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32"/>
  </p:normalViewPr>
  <p:slideViewPr>
    <p:cSldViewPr snapToGrid="0">
      <p:cViewPr varScale="1">
        <p:scale>
          <a:sx n="109" d="100"/>
          <a:sy n="109" d="100"/>
        </p:scale>
        <p:origin x="636" y="1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FD7C5B3-A081-6519-81E4-5804F917A36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2C3B1B68-5048-0974-0E7B-C627DAD1C48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A1C9D07-2314-DFB0-25DA-22FEAA018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32DE9D0-6D4B-E38C-5069-DDAB8D116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82E79B3-D71F-ACCA-7CD5-7C93F7B19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373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FA2D89A-519F-0F7B-C45D-52F569180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0374150-71EF-3F45-4236-5C382DA6CB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F2443C3-93E8-514A-73DA-28A5386CBC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2A5A621-6BBA-7635-686A-592AE1CD6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B22D5A-B37D-5AB6-396B-72BA3FEE1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01525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23425BC8-6259-5755-912F-B0B371A654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D7F6EC0-E634-3D02-C959-5AA0655E4C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389A082-211A-0510-D3CB-1A39C0668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9FEF593-9F66-7B3D-EB9D-0C79CF73E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FD17C9D-E13A-C156-FF6C-776516689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1658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510BA74-DF15-8FA1-D2FB-3C51CD585E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CA05537-F7DF-1363-56E2-1DE6B0F5A5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CB6D67F-1500-A74E-6419-EF56E3282F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DA10C49-AC52-C168-A960-B7E81E90E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44EC4D2-D529-629D-B870-39F9A2C979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2365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8271B36-7574-1381-04A0-9E80E09ECA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7BFC9C9-30AC-F5DE-6277-DC4C186BC3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E99CC3A-D791-D239-18ED-EFC8E45C31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7C1C70A-2521-5943-1710-FFE2DA9F30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61694C3-BBDF-B022-534A-2EEEE882B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1196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C0DCC68-7F2C-E1EC-1D20-9EAD3BB87B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782DAD08-E722-FBB8-C135-655F1ECD13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3AAEA8B-3135-FB71-4832-806C0A90D3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C612363D-0FDB-8D70-E6B0-81CEF017B4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CB6E4CE-1E08-402B-E0A3-54AF287E73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9980489-9328-B957-ACAF-247637E902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9465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1CF76FD-DDD3-100A-230F-72D66E6BB2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16E2AD7-ACAD-4AD1-91B1-F086419215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67503C2D-0A7C-F33C-E980-2FBEC27D675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C1F1DA3B-4B7A-2855-5EE3-08742675EB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4174C88-540D-0CCC-7439-67AE30683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ED09E074-BF88-2800-52C5-7FF2EF0D7B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283ACCB8-9537-CAF3-29A9-ADFE09808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5108EAED-04EB-4880-E4D5-7FC78D4861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551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CACC4C9-A94B-C91C-B7D6-E058518276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BAF7B230-D12A-7496-360C-2E47A2868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C8268EC0-3CE5-4F1A-A044-172631881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4A999643-5B6F-4A91-5C39-8EEFF7340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09947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FDEBEC5-CBC7-136C-FFA9-9DC9C3011E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FEEF48D-9135-DE2C-CCF7-79174FCA60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BC6D964B-671D-6396-60B1-62DF64201F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2875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348A253-8E38-E1AB-6F4A-1371589A8C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315DBE6-02BA-A752-2E94-F3A2DC85C7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89E51BF-8E85-5AD9-5004-C95F9827A1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8983B9A-8D0C-DE01-0179-2D310D1263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1287F06-E59F-DBC0-EFE9-1AA7AEB557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22F3560-8D42-DA5F-17AB-ACAF1D071C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01867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2B4A84-E7B3-270E-6FA2-9A88E517AE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6569937-C485-22F8-678D-17D8E671B15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96ECEDE3-745D-4119-7007-EA2EFAF036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A148CE7E-E57A-057A-5AA8-99BDBA7E9A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908640DC-3A2F-015C-9DF0-3BFBEC5C4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5B35462-7180-2AF0-C712-7CD820715C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78958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A5EDC70-6A59-C1BE-7F53-119398C1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F14A792-0741-AA96-6C54-0C0D07AE84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7BE3527-4BEC-002C-AB42-D3724302F3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6455295-DA9C-3548-BE2B-C585EFCE1CB4}" type="datetimeFigureOut">
              <a:rPr lang="de-DE" smtClean="0"/>
              <a:t>13.08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8D78EB2-D3EC-2FE0-CB7F-FCB6C1F9488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E04F9DC-C1D5-F393-7F6A-7316EAB6D6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A9FCB4-ABE2-F941-A1B9-8C0DFEB6F56E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66766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jp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792D266-555C-BBBD-C3BE-931754EF6E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0684" y="268873"/>
            <a:ext cx="10515600" cy="741780"/>
          </a:xfrm>
        </p:spPr>
        <p:txBody>
          <a:bodyPr>
            <a:normAutofit/>
          </a:bodyPr>
          <a:lstStyle/>
          <a:p>
            <a:r>
              <a:rPr lang="de-DE" sz="2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sz="2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Figure 1:</a:t>
            </a:r>
          </a:p>
        </p:txBody>
      </p:sp>
      <p:grpSp>
        <p:nvGrpSpPr>
          <p:cNvPr id="42" name="Gruppieren 41">
            <a:extLst>
              <a:ext uri="{FF2B5EF4-FFF2-40B4-BE49-F238E27FC236}">
                <a16:creationId xmlns:a16="http://schemas.microsoft.com/office/drawing/2014/main" id="{FF204DD8-7DBB-462C-9AB2-8A03379CF6C3}"/>
              </a:ext>
            </a:extLst>
          </p:cNvPr>
          <p:cNvGrpSpPr/>
          <p:nvPr/>
        </p:nvGrpSpPr>
        <p:grpSpPr>
          <a:xfrm>
            <a:off x="437488" y="1622688"/>
            <a:ext cx="4795183" cy="4657738"/>
            <a:chOff x="1036793" y="1486074"/>
            <a:chExt cx="4795183" cy="4657738"/>
          </a:xfrm>
        </p:grpSpPr>
        <p:grpSp>
          <p:nvGrpSpPr>
            <p:cNvPr id="27" name="Gruppieren 26">
              <a:extLst>
                <a:ext uri="{FF2B5EF4-FFF2-40B4-BE49-F238E27FC236}">
                  <a16:creationId xmlns:a16="http://schemas.microsoft.com/office/drawing/2014/main" id="{56154237-DE6E-1A0F-E7A0-94867D592856}"/>
                </a:ext>
              </a:extLst>
            </p:cNvPr>
            <p:cNvGrpSpPr/>
            <p:nvPr/>
          </p:nvGrpSpPr>
          <p:grpSpPr>
            <a:xfrm>
              <a:off x="1036793" y="4024536"/>
              <a:ext cx="3015440" cy="2119276"/>
              <a:chOff x="2533198" y="3429000"/>
              <a:chExt cx="1443716" cy="1094871"/>
            </a:xfrm>
          </p:grpSpPr>
          <p:grpSp>
            <p:nvGrpSpPr>
              <p:cNvPr id="26" name="Gruppieren 25">
                <a:extLst>
                  <a:ext uri="{FF2B5EF4-FFF2-40B4-BE49-F238E27FC236}">
                    <a16:creationId xmlns:a16="http://schemas.microsoft.com/office/drawing/2014/main" id="{638DB00C-FCF3-92E6-EE01-3F34EA877550}"/>
                  </a:ext>
                </a:extLst>
              </p:cNvPr>
              <p:cNvGrpSpPr/>
              <p:nvPr/>
            </p:nvGrpSpPr>
            <p:grpSpPr>
              <a:xfrm>
                <a:off x="2533198" y="3429000"/>
                <a:ext cx="1443716" cy="1094871"/>
                <a:chOff x="2533198" y="3515472"/>
                <a:chExt cx="1389349" cy="1008399"/>
              </a:xfrm>
            </p:grpSpPr>
            <p:pic>
              <p:nvPicPr>
                <p:cNvPr id="9" name="Grafik 8" descr="Ein Bild, das dunkel, Nacht, Meeresgrund enthält.&#10;&#10;Automatisch generierte Beschreibung">
                  <a:extLst>
                    <a:ext uri="{FF2B5EF4-FFF2-40B4-BE49-F238E27FC236}">
                      <a16:creationId xmlns:a16="http://schemas.microsoft.com/office/drawing/2014/main" id="{38CCE074-0EC4-3715-6F62-B184641C9630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2" cstate="email">
                  <a:extLst>
                    <a:ext uri="{BEBA8EAE-BF5A-486C-A8C5-ECC9F3942E4B}">
                      <a14:imgProps xmlns:a14="http://schemas.microsoft.com/office/drawing/2010/main">
                        <a14:imgLayer r:embed="rId3">
                          <a14:imgEffect>
                            <a14:sharpenSoften amount="50000"/>
                          </a14:imgEffect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 rot="5400000">
                  <a:off x="2723673" y="3324997"/>
                  <a:ext cx="1008399" cy="1389349"/>
                </a:xfrm>
                <a:prstGeom prst="rect">
                  <a:avLst/>
                </a:prstGeom>
              </p:spPr>
            </p:pic>
            <p:sp>
              <p:nvSpPr>
                <p:cNvPr id="12" name="Freihandform 11">
                  <a:extLst>
                    <a:ext uri="{FF2B5EF4-FFF2-40B4-BE49-F238E27FC236}">
                      <a16:creationId xmlns:a16="http://schemas.microsoft.com/office/drawing/2014/main" id="{9ACAA0C5-0703-ADEE-7FD7-04CC84F9DC56}"/>
                    </a:ext>
                  </a:extLst>
                </p:cNvPr>
                <p:cNvSpPr/>
                <p:nvPr/>
              </p:nvSpPr>
              <p:spPr>
                <a:xfrm>
                  <a:off x="2533198" y="3571875"/>
                  <a:ext cx="1378659" cy="476250"/>
                </a:xfrm>
                <a:custGeom>
                  <a:avLst/>
                  <a:gdLst>
                    <a:gd name="connsiteX0" fmla="*/ 28575 w 1397257"/>
                    <a:gd name="connsiteY0" fmla="*/ 466725 h 476272"/>
                    <a:gd name="connsiteX1" fmla="*/ 69850 w 1397257"/>
                    <a:gd name="connsiteY1" fmla="*/ 457200 h 476272"/>
                    <a:gd name="connsiteX2" fmla="*/ 79375 w 1397257"/>
                    <a:gd name="connsiteY2" fmla="*/ 454025 h 476272"/>
                    <a:gd name="connsiteX3" fmla="*/ 88900 w 1397257"/>
                    <a:gd name="connsiteY3" fmla="*/ 447675 h 476272"/>
                    <a:gd name="connsiteX4" fmla="*/ 114300 w 1397257"/>
                    <a:gd name="connsiteY4" fmla="*/ 441325 h 476272"/>
                    <a:gd name="connsiteX5" fmla="*/ 155575 w 1397257"/>
                    <a:gd name="connsiteY5" fmla="*/ 434975 h 476272"/>
                    <a:gd name="connsiteX6" fmla="*/ 174625 w 1397257"/>
                    <a:gd name="connsiteY6" fmla="*/ 428625 h 476272"/>
                    <a:gd name="connsiteX7" fmla="*/ 184150 w 1397257"/>
                    <a:gd name="connsiteY7" fmla="*/ 422275 h 476272"/>
                    <a:gd name="connsiteX8" fmla="*/ 228600 w 1397257"/>
                    <a:gd name="connsiteY8" fmla="*/ 409575 h 476272"/>
                    <a:gd name="connsiteX9" fmla="*/ 260350 w 1397257"/>
                    <a:gd name="connsiteY9" fmla="*/ 400050 h 476272"/>
                    <a:gd name="connsiteX10" fmla="*/ 269875 w 1397257"/>
                    <a:gd name="connsiteY10" fmla="*/ 396875 h 476272"/>
                    <a:gd name="connsiteX11" fmla="*/ 298450 w 1397257"/>
                    <a:gd name="connsiteY11" fmla="*/ 390525 h 476272"/>
                    <a:gd name="connsiteX12" fmla="*/ 317500 w 1397257"/>
                    <a:gd name="connsiteY12" fmla="*/ 384175 h 476272"/>
                    <a:gd name="connsiteX13" fmla="*/ 327025 w 1397257"/>
                    <a:gd name="connsiteY13" fmla="*/ 381000 h 476272"/>
                    <a:gd name="connsiteX14" fmla="*/ 336550 w 1397257"/>
                    <a:gd name="connsiteY14" fmla="*/ 377825 h 476272"/>
                    <a:gd name="connsiteX15" fmla="*/ 355600 w 1397257"/>
                    <a:gd name="connsiteY15" fmla="*/ 365125 h 476272"/>
                    <a:gd name="connsiteX16" fmla="*/ 377825 w 1397257"/>
                    <a:gd name="connsiteY16" fmla="*/ 358775 h 476272"/>
                    <a:gd name="connsiteX17" fmla="*/ 396875 w 1397257"/>
                    <a:gd name="connsiteY17" fmla="*/ 352425 h 476272"/>
                    <a:gd name="connsiteX18" fmla="*/ 419100 w 1397257"/>
                    <a:gd name="connsiteY18" fmla="*/ 349250 h 476272"/>
                    <a:gd name="connsiteX19" fmla="*/ 434975 w 1397257"/>
                    <a:gd name="connsiteY19" fmla="*/ 346075 h 476272"/>
                    <a:gd name="connsiteX20" fmla="*/ 609600 w 1397257"/>
                    <a:gd name="connsiteY20" fmla="*/ 342900 h 476272"/>
                    <a:gd name="connsiteX21" fmla="*/ 641350 w 1397257"/>
                    <a:gd name="connsiteY21" fmla="*/ 336550 h 476272"/>
                    <a:gd name="connsiteX22" fmla="*/ 685800 w 1397257"/>
                    <a:gd name="connsiteY22" fmla="*/ 327025 h 476272"/>
                    <a:gd name="connsiteX23" fmla="*/ 704850 w 1397257"/>
                    <a:gd name="connsiteY23" fmla="*/ 320675 h 476272"/>
                    <a:gd name="connsiteX24" fmla="*/ 714375 w 1397257"/>
                    <a:gd name="connsiteY24" fmla="*/ 317500 h 476272"/>
                    <a:gd name="connsiteX25" fmla="*/ 723900 w 1397257"/>
                    <a:gd name="connsiteY25" fmla="*/ 314325 h 476272"/>
                    <a:gd name="connsiteX26" fmla="*/ 733425 w 1397257"/>
                    <a:gd name="connsiteY26" fmla="*/ 307975 h 476272"/>
                    <a:gd name="connsiteX27" fmla="*/ 752475 w 1397257"/>
                    <a:gd name="connsiteY27" fmla="*/ 301625 h 476272"/>
                    <a:gd name="connsiteX28" fmla="*/ 790575 w 1397257"/>
                    <a:gd name="connsiteY28" fmla="*/ 304800 h 476272"/>
                    <a:gd name="connsiteX29" fmla="*/ 800100 w 1397257"/>
                    <a:gd name="connsiteY29" fmla="*/ 307975 h 476272"/>
                    <a:gd name="connsiteX30" fmla="*/ 815975 w 1397257"/>
                    <a:gd name="connsiteY30" fmla="*/ 323850 h 476272"/>
                    <a:gd name="connsiteX31" fmla="*/ 835025 w 1397257"/>
                    <a:gd name="connsiteY31" fmla="*/ 330200 h 476272"/>
                    <a:gd name="connsiteX32" fmla="*/ 844550 w 1397257"/>
                    <a:gd name="connsiteY32" fmla="*/ 333375 h 476272"/>
                    <a:gd name="connsiteX33" fmla="*/ 866775 w 1397257"/>
                    <a:gd name="connsiteY33" fmla="*/ 339725 h 476272"/>
                    <a:gd name="connsiteX34" fmla="*/ 885825 w 1397257"/>
                    <a:gd name="connsiteY34" fmla="*/ 349250 h 476272"/>
                    <a:gd name="connsiteX35" fmla="*/ 898525 w 1397257"/>
                    <a:gd name="connsiteY35" fmla="*/ 352425 h 476272"/>
                    <a:gd name="connsiteX36" fmla="*/ 908050 w 1397257"/>
                    <a:gd name="connsiteY36" fmla="*/ 355600 h 476272"/>
                    <a:gd name="connsiteX37" fmla="*/ 1003300 w 1397257"/>
                    <a:gd name="connsiteY37" fmla="*/ 361950 h 476272"/>
                    <a:gd name="connsiteX38" fmla="*/ 1063625 w 1397257"/>
                    <a:gd name="connsiteY38" fmla="*/ 358775 h 476272"/>
                    <a:gd name="connsiteX39" fmla="*/ 1073150 w 1397257"/>
                    <a:gd name="connsiteY39" fmla="*/ 355600 h 476272"/>
                    <a:gd name="connsiteX40" fmla="*/ 1092200 w 1397257"/>
                    <a:gd name="connsiteY40" fmla="*/ 352425 h 476272"/>
                    <a:gd name="connsiteX41" fmla="*/ 1101725 w 1397257"/>
                    <a:gd name="connsiteY41" fmla="*/ 349250 h 476272"/>
                    <a:gd name="connsiteX42" fmla="*/ 1114425 w 1397257"/>
                    <a:gd name="connsiteY42" fmla="*/ 346075 h 476272"/>
                    <a:gd name="connsiteX43" fmla="*/ 1133475 w 1397257"/>
                    <a:gd name="connsiteY43" fmla="*/ 339725 h 476272"/>
                    <a:gd name="connsiteX44" fmla="*/ 1136650 w 1397257"/>
                    <a:gd name="connsiteY44" fmla="*/ 330200 h 476272"/>
                    <a:gd name="connsiteX45" fmla="*/ 1149350 w 1397257"/>
                    <a:gd name="connsiteY45" fmla="*/ 314325 h 476272"/>
                    <a:gd name="connsiteX46" fmla="*/ 1174750 w 1397257"/>
                    <a:gd name="connsiteY46" fmla="*/ 288925 h 476272"/>
                    <a:gd name="connsiteX47" fmla="*/ 1187450 w 1397257"/>
                    <a:gd name="connsiteY47" fmla="*/ 269875 h 476272"/>
                    <a:gd name="connsiteX48" fmla="*/ 1193800 w 1397257"/>
                    <a:gd name="connsiteY48" fmla="*/ 260350 h 476272"/>
                    <a:gd name="connsiteX49" fmla="*/ 1203325 w 1397257"/>
                    <a:gd name="connsiteY49" fmla="*/ 250825 h 476272"/>
                    <a:gd name="connsiteX50" fmla="*/ 1209675 w 1397257"/>
                    <a:gd name="connsiteY50" fmla="*/ 231775 h 476272"/>
                    <a:gd name="connsiteX51" fmla="*/ 1231900 w 1397257"/>
                    <a:gd name="connsiteY51" fmla="*/ 203200 h 476272"/>
                    <a:gd name="connsiteX52" fmla="*/ 1238250 w 1397257"/>
                    <a:gd name="connsiteY52" fmla="*/ 193675 h 476272"/>
                    <a:gd name="connsiteX53" fmla="*/ 1257300 w 1397257"/>
                    <a:gd name="connsiteY53" fmla="*/ 180975 h 476272"/>
                    <a:gd name="connsiteX54" fmla="*/ 1285875 w 1397257"/>
                    <a:gd name="connsiteY54" fmla="*/ 158750 h 476272"/>
                    <a:gd name="connsiteX55" fmla="*/ 1295400 w 1397257"/>
                    <a:gd name="connsiteY55" fmla="*/ 152400 h 476272"/>
                    <a:gd name="connsiteX56" fmla="*/ 1308100 w 1397257"/>
                    <a:gd name="connsiteY56" fmla="*/ 146050 h 476272"/>
                    <a:gd name="connsiteX57" fmla="*/ 1317625 w 1397257"/>
                    <a:gd name="connsiteY57" fmla="*/ 142875 h 476272"/>
                    <a:gd name="connsiteX58" fmla="*/ 1336675 w 1397257"/>
                    <a:gd name="connsiteY58" fmla="*/ 130175 h 476272"/>
                    <a:gd name="connsiteX59" fmla="*/ 1346200 w 1397257"/>
                    <a:gd name="connsiteY59" fmla="*/ 127000 h 476272"/>
                    <a:gd name="connsiteX60" fmla="*/ 1365250 w 1397257"/>
                    <a:gd name="connsiteY60" fmla="*/ 114300 h 476272"/>
                    <a:gd name="connsiteX61" fmla="*/ 1374775 w 1397257"/>
                    <a:gd name="connsiteY61" fmla="*/ 104775 h 476272"/>
                    <a:gd name="connsiteX62" fmla="*/ 1384300 w 1397257"/>
                    <a:gd name="connsiteY62" fmla="*/ 101600 h 476272"/>
                    <a:gd name="connsiteX63" fmla="*/ 1393825 w 1397257"/>
                    <a:gd name="connsiteY63" fmla="*/ 95250 h 476272"/>
                    <a:gd name="connsiteX64" fmla="*/ 1393825 w 1397257"/>
                    <a:gd name="connsiteY64" fmla="*/ 76200 h 476272"/>
                    <a:gd name="connsiteX65" fmla="*/ 1381125 w 1397257"/>
                    <a:gd name="connsiteY65" fmla="*/ 0 h 476272"/>
                    <a:gd name="connsiteX66" fmla="*/ 1336675 w 1397257"/>
                    <a:gd name="connsiteY66" fmla="*/ 6350 h 476272"/>
                    <a:gd name="connsiteX67" fmla="*/ 1317625 w 1397257"/>
                    <a:gd name="connsiteY67" fmla="*/ 19050 h 476272"/>
                    <a:gd name="connsiteX68" fmla="*/ 1308100 w 1397257"/>
                    <a:gd name="connsiteY68" fmla="*/ 25400 h 476272"/>
                    <a:gd name="connsiteX69" fmla="*/ 1289050 w 1397257"/>
                    <a:gd name="connsiteY69" fmla="*/ 31750 h 476272"/>
                    <a:gd name="connsiteX70" fmla="*/ 1279525 w 1397257"/>
                    <a:gd name="connsiteY70" fmla="*/ 34925 h 476272"/>
                    <a:gd name="connsiteX71" fmla="*/ 1270000 w 1397257"/>
                    <a:gd name="connsiteY71" fmla="*/ 41275 h 476272"/>
                    <a:gd name="connsiteX72" fmla="*/ 1250950 w 1397257"/>
                    <a:gd name="connsiteY72" fmla="*/ 47625 h 476272"/>
                    <a:gd name="connsiteX73" fmla="*/ 1231900 w 1397257"/>
                    <a:gd name="connsiteY73" fmla="*/ 53975 h 476272"/>
                    <a:gd name="connsiteX74" fmla="*/ 1222375 w 1397257"/>
                    <a:gd name="connsiteY74" fmla="*/ 57150 h 476272"/>
                    <a:gd name="connsiteX75" fmla="*/ 1212850 w 1397257"/>
                    <a:gd name="connsiteY75" fmla="*/ 63500 h 476272"/>
                    <a:gd name="connsiteX76" fmla="*/ 1193800 w 1397257"/>
                    <a:gd name="connsiteY76" fmla="*/ 69850 h 476272"/>
                    <a:gd name="connsiteX77" fmla="*/ 1184275 w 1397257"/>
                    <a:gd name="connsiteY77" fmla="*/ 73025 h 476272"/>
                    <a:gd name="connsiteX78" fmla="*/ 1171575 w 1397257"/>
                    <a:gd name="connsiteY78" fmla="*/ 76200 h 476272"/>
                    <a:gd name="connsiteX79" fmla="*/ 1152525 w 1397257"/>
                    <a:gd name="connsiteY79" fmla="*/ 82550 h 476272"/>
                    <a:gd name="connsiteX80" fmla="*/ 1130300 w 1397257"/>
                    <a:gd name="connsiteY80" fmla="*/ 95250 h 476272"/>
                    <a:gd name="connsiteX81" fmla="*/ 1120775 w 1397257"/>
                    <a:gd name="connsiteY81" fmla="*/ 101600 h 476272"/>
                    <a:gd name="connsiteX82" fmla="*/ 1111250 w 1397257"/>
                    <a:gd name="connsiteY82" fmla="*/ 104775 h 476272"/>
                    <a:gd name="connsiteX83" fmla="*/ 1101725 w 1397257"/>
                    <a:gd name="connsiteY83" fmla="*/ 111125 h 476272"/>
                    <a:gd name="connsiteX84" fmla="*/ 1092200 w 1397257"/>
                    <a:gd name="connsiteY84" fmla="*/ 114300 h 476272"/>
                    <a:gd name="connsiteX85" fmla="*/ 1073150 w 1397257"/>
                    <a:gd name="connsiteY85" fmla="*/ 127000 h 476272"/>
                    <a:gd name="connsiteX86" fmla="*/ 1060450 w 1397257"/>
                    <a:gd name="connsiteY86" fmla="*/ 146050 h 476272"/>
                    <a:gd name="connsiteX87" fmla="*/ 1050925 w 1397257"/>
                    <a:gd name="connsiteY87" fmla="*/ 165100 h 476272"/>
                    <a:gd name="connsiteX88" fmla="*/ 1047750 w 1397257"/>
                    <a:gd name="connsiteY88" fmla="*/ 177800 h 476272"/>
                    <a:gd name="connsiteX89" fmla="*/ 1041400 w 1397257"/>
                    <a:gd name="connsiteY89" fmla="*/ 187325 h 476272"/>
                    <a:gd name="connsiteX90" fmla="*/ 1035050 w 1397257"/>
                    <a:gd name="connsiteY90" fmla="*/ 219075 h 476272"/>
                    <a:gd name="connsiteX91" fmla="*/ 1016000 w 1397257"/>
                    <a:gd name="connsiteY91" fmla="*/ 231775 h 476272"/>
                    <a:gd name="connsiteX92" fmla="*/ 1006475 w 1397257"/>
                    <a:gd name="connsiteY92" fmla="*/ 238125 h 476272"/>
                    <a:gd name="connsiteX93" fmla="*/ 987425 w 1397257"/>
                    <a:gd name="connsiteY93" fmla="*/ 244475 h 476272"/>
                    <a:gd name="connsiteX94" fmla="*/ 917575 w 1397257"/>
                    <a:gd name="connsiteY94" fmla="*/ 241300 h 476272"/>
                    <a:gd name="connsiteX95" fmla="*/ 898525 w 1397257"/>
                    <a:gd name="connsiteY95" fmla="*/ 231775 h 476272"/>
                    <a:gd name="connsiteX96" fmla="*/ 879475 w 1397257"/>
                    <a:gd name="connsiteY96" fmla="*/ 225425 h 476272"/>
                    <a:gd name="connsiteX97" fmla="*/ 869950 w 1397257"/>
                    <a:gd name="connsiteY97" fmla="*/ 222250 h 476272"/>
                    <a:gd name="connsiteX98" fmla="*/ 850900 w 1397257"/>
                    <a:gd name="connsiteY98" fmla="*/ 209550 h 476272"/>
                    <a:gd name="connsiteX99" fmla="*/ 831850 w 1397257"/>
                    <a:gd name="connsiteY99" fmla="*/ 203200 h 476272"/>
                    <a:gd name="connsiteX100" fmla="*/ 822325 w 1397257"/>
                    <a:gd name="connsiteY100" fmla="*/ 200025 h 476272"/>
                    <a:gd name="connsiteX101" fmla="*/ 796925 w 1397257"/>
                    <a:gd name="connsiteY101" fmla="*/ 190500 h 476272"/>
                    <a:gd name="connsiteX102" fmla="*/ 777875 w 1397257"/>
                    <a:gd name="connsiteY102" fmla="*/ 177800 h 476272"/>
                    <a:gd name="connsiteX103" fmla="*/ 768350 w 1397257"/>
                    <a:gd name="connsiteY103" fmla="*/ 171450 h 476272"/>
                    <a:gd name="connsiteX104" fmla="*/ 742950 w 1397257"/>
                    <a:gd name="connsiteY104" fmla="*/ 165100 h 476272"/>
                    <a:gd name="connsiteX105" fmla="*/ 708025 w 1397257"/>
                    <a:gd name="connsiteY105" fmla="*/ 158750 h 476272"/>
                    <a:gd name="connsiteX106" fmla="*/ 660400 w 1397257"/>
                    <a:gd name="connsiteY106" fmla="*/ 161925 h 476272"/>
                    <a:gd name="connsiteX107" fmla="*/ 647700 w 1397257"/>
                    <a:gd name="connsiteY107" fmla="*/ 168275 h 476272"/>
                    <a:gd name="connsiteX108" fmla="*/ 638175 w 1397257"/>
                    <a:gd name="connsiteY108" fmla="*/ 171450 h 476272"/>
                    <a:gd name="connsiteX109" fmla="*/ 628650 w 1397257"/>
                    <a:gd name="connsiteY109" fmla="*/ 180975 h 476272"/>
                    <a:gd name="connsiteX110" fmla="*/ 619125 w 1397257"/>
                    <a:gd name="connsiteY110" fmla="*/ 187325 h 476272"/>
                    <a:gd name="connsiteX111" fmla="*/ 612775 w 1397257"/>
                    <a:gd name="connsiteY111" fmla="*/ 196850 h 476272"/>
                    <a:gd name="connsiteX112" fmla="*/ 603250 w 1397257"/>
                    <a:gd name="connsiteY112" fmla="*/ 209550 h 476272"/>
                    <a:gd name="connsiteX113" fmla="*/ 593725 w 1397257"/>
                    <a:gd name="connsiteY113" fmla="*/ 215900 h 476272"/>
                    <a:gd name="connsiteX114" fmla="*/ 577850 w 1397257"/>
                    <a:gd name="connsiteY114" fmla="*/ 231775 h 476272"/>
                    <a:gd name="connsiteX115" fmla="*/ 549275 w 1397257"/>
                    <a:gd name="connsiteY115" fmla="*/ 254000 h 476272"/>
                    <a:gd name="connsiteX116" fmla="*/ 530225 w 1397257"/>
                    <a:gd name="connsiteY116" fmla="*/ 260350 h 476272"/>
                    <a:gd name="connsiteX117" fmla="*/ 473075 w 1397257"/>
                    <a:gd name="connsiteY117" fmla="*/ 266700 h 476272"/>
                    <a:gd name="connsiteX118" fmla="*/ 463550 w 1397257"/>
                    <a:gd name="connsiteY118" fmla="*/ 269875 h 476272"/>
                    <a:gd name="connsiteX119" fmla="*/ 412750 w 1397257"/>
                    <a:gd name="connsiteY119" fmla="*/ 263525 h 476272"/>
                    <a:gd name="connsiteX120" fmla="*/ 250825 w 1397257"/>
                    <a:gd name="connsiteY120" fmla="*/ 266700 h 476272"/>
                    <a:gd name="connsiteX121" fmla="*/ 219075 w 1397257"/>
                    <a:gd name="connsiteY121" fmla="*/ 273050 h 476272"/>
                    <a:gd name="connsiteX122" fmla="*/ 196850 w 1397257"/>
                    <a:gd name="connsiteY122" fmla="*/ 288925 h 476272"/>
                    <a:gd name="connsiteX123" fmla="*/ 184150 w 1397257"/>
                    <a:gd name="connsiteY123" fmla="*/ 295275 h 476272"/>
                    <a:gd name="connsiteX124" fmla="*/ 174625 w 1397257"/>
                    <a:gd name="connsiteY124" fmla="*/ 301625 h 476272"/>
                    <a:gd name="connsiteX125" fmla="*/ 152400 w 1397257"/>
                    <a:gd name="connsiteY125" fmla="*/ 311150 h 476272"/>
                    <a:gd name="connsiteX126" fmla="*/ 123825 w 1397257"/>
                    <a:gd name="connsiteY126" fmla="*/ 320675 h 476272"/>
                    <a:gd name="connsiteX127" fmla="*/ 114300 w 1397257"/>
                    <a:gd name="connsiteY127" fmla="*/ 327025 h 476272"/>
                    <a:gd name="connsiteX128" fmla="*/ 79375 w 1397257"/>
                    <a:gd name="connsiteY128" fmla="*/ 336550 h 476272"/>
                    <a:gd name="connsiteX129" fmla="*/ 66675 w 1397257"/>
                    <a:gd name="connsiteY129" fmla="*/ 342900 h 476272"/>
                    <a:gd name="connsiteX130" fmla="*/ 47625 w 1397257"/>
                    <a:gd name="connsiteY130" fmla="*/ 349250 h 476272"/>
                    <a:gd name="connsiteX131" fmla="*/ 38100 w 1397257"/>
                    <a:gd name="connsiteY131" fmla="*/ 355600 h 476272"/>
                    <a:gd name="connsiteX132" fmla="*/ 9525 w 1397257"/>
                    <a:gd name="connsiteY132" fmla="*/ 365125 h 476272"/>
                    <a:gd name="connsiteX133" fmla="*/ 0 w 1397257"/>
                    <a:gd name="connsiteY133" fmla="*/ 368300 h 476272"/>
                    <a:gd name="connsiteX134" fmla="*/ 9525 w 1397257"/>
                    <a:gd name="connsiteY134" fmla="*/ 403225 h 476272"/>
                    <a:gd name="connsiteX135" fmla="*/ 12700 w 1397257"/>
                    <a:gd name="connsiteY135" fmla="*/ 450850 h 476272"/>
                    <a:gd name="connsiteX136" fmla="*/ 28575 w 1397257"/>
                    <a:gd name="connsiteY136" fmla="*/ 476250 h 476272"/>
                    <a:gd name="connsiteX137" fmla="*/ 28575 w 1397257"/>
                    <a:gd name="connsiteY137" fmla="*/ 466725 h 47627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</a:cxnLst>
                  <a:rect l="l" t="t" r="r" b="b"/>
                  <a:pathLst>
                    <a:path w="1397257" h="476272">
                      <a:moveTo>
                        <a:pt x="28575" y="466725"/>
                      </a:moveTo>
                      <a:cubicBezTo>
                        <a:pt x="35454" y="463550"/>
                        <a:pt x="43700" y="465917"/>
                        <a:pt x="69850" y="457200"/>
                      </a:cubicBezTo>
                      <a:cubicBezTo>
                        <a:pt x="73025" y="456142"/>
                        <a:pt x="76590" y="455881"/>
                        <a:pt x="79375" y="454025"/>
                      </a:cubicBezTo>
                      <a:cubicBezTo>
                        <a:pt x="82550" y="451908"/>
                        <a:pt x="85314" y="448979"/>
                        <a:pt x="88900" y="447675"/>
                      </a:cubicBezTo>
                      <a:cubicBezTo>
                        <a:pt x="97102" y="444693"/>
                        <a:pt x="105692" y="442760"/>
                        <a:pt x="114300" y="441325"/>
                      </a:cubicBezTo>
                      <a:cubicBezTo>
                        <a:pt x="140732" y="436920"/>
                        <a:pt x="126977" y="439060"/>
                        <a:pt x="155575" y="434975"/>
                      </a:cubicBezTo>
                      <a:cubicBezTo>
                        <a:pt x="161925" y="432858"/>
                        <a:pt x="169056" y="432338"/>
                        <a:pt x="174625" y="428625"/>
                      </a:cubicBezTo>
                      <a:cubicBezTo>
                        <a:pt x="177800" y="426508"/>
                        <a:pt x="180663" y="423825"/>
                        <a:pt x="184150" y="422275"/>
                      </a:cubicBezTo>
                      <a:cubicBezTo>
                        <a:pt x="202496" y="414121"/>
                        <a:pt x="208419" y="416302"/>
                        <a:pt x="228600" y="409575"/>
                      </a:cubicBezTo>
                      <a:cubicBezTo>
                        <a:pt x="273871" y="394485"/>
                        <a:pt x="226761" y="409647"/>
                        <a:pt x="260350" y="400050"/>
                      </a:cubicBezTo>
                      <a:cubicBezTo>
                        <a:pt x="263568" y="399131"/>
                        <a:pt x="266628" y="397687"/>
                        <a:pt x="269875" y="396875"/>
                      </a:cubicBezTo>
                      <a:cubicBezTo>
                        <a:pt x="288002" y="392343"/>
                        <a:pt x="282153" y="395414"/>
                        <a:pt x="298450" y="390525"/>
                      </a:cubicBezTo>
                      <a:cubicBezTo>
                        <a:pt x="304861" y="388602"/>
                        <a:pt x="311150" y="386292"/>
                        <a:pt x="317500" y="384175"/>
                      </a:cubicBezTo>
                      <a:lnTo>
                        <a:pt x="327025" y="381000"/>
                      </a:lnTo>
                      <a:cubicBezTo>
                        <a:pt x="330200" y="379942"/>
                        <a:pt x="333765" y="379681"/>
                        <a:pt x="336550" y="377825"/>
                      </a:cubicBezTo>
                      <a:cubicBezTo>
                        <a:pt x="342900" y="373592"/>
                        <a:pt x="348360" y="367538"/>
                        <a:pt x="355600" y="365125"/>
                      </a:cubicBezTo>
                      <a:cubicBezTo>
                        <a:pt x="387611" y="354455"/>
                        <a:pt x="337958" y="370735"/>
                        <a:pt x="377825" y="358775"/>
                      </a:cubicBezTo>
                      <a:cubicBezTo>
                        <a:pt x="384236" y="356852"/>
                        <a:pt x="390249" y="353372"/>
                        <a:pt x="396875" y="352425"/>
                      </a:cubicBezTo>
                      <a:cubicBezTo>
                        <a:pt x="404283" y="351367"/>
                        <a:pt x="411718" y="350480"/>
                        <a:pt x="419100" y="349250"/>
                      </a:cubicBezTo>
                      <a:cubicBezTo>
                        <a:pt x="424423" y="348363"/>
                        <a:pt x="429582" y="346255"/>
                        <a:pt x="434975" y="346075"/>
                      </a:cubicBezTo>
                      <a:cubicBezTo>
                        <a:pt x="493161" y="344135"/>
                        <a:pt x="551392" y="343958"/>
                        <a:pt x="609600" y="342900"/>
                      </a:cubicBezTo>
                      <a:cubicBezTo>
                        <a:pt x="653917" y="335514"/>
                        <a:pt x="608196" y="343655"/>
                        <a:pt x="641350" y="336550"/>
                      </a:cubicBezTo>
                      <a:cubicBezTo>
                        <a:pt x="649953" y="334707"/>
                        <a:pt x="673718" y="330650"/>
                        <a:pt x="685800" y="327025"/>
                      </a:cubicBezTo>
                      <a:cubicBezTo>
                        <a:pt x="692211" y="325102"/>
                        <a:pt x="698500" y="322792"/>
                        <a:pt x="704850" y="320675"/>
                      </a:cubicBezTo>
                      <a:lnTo>
                        <a:pt x="714375" y="317500"/>
                      </a:lnTo>
                      <a:cubicBezTo>
                        <a:pt x="717550" y="316442"/>
                        <a:pt x="721115" y="316181"/>
                        <a:pt x="723900" y="314325"/>
                      </a:cubicBezTo>
                      <a:cubicBezTo>
                        <a:pt x="727075" y="312208"/>
                        <a:pt x="729938" y="309525"/>
                        <a:pt x="733425" y="307975"/>
                      </a:cubicBezTo>
                      <a:cubicBezTo>
                        <a:pt x="739542" y="305257"/>
                        <a:pt x="752475" y="301625"/>
                        <a:pt x="752475" y="301625"/>
                      </a:cubicBezTo>
                      <a:cubicBezTo>
                        <a:pt x="765175" y="302683"/>
                        <a:pt x="777943" y="303116"/>
                        <a:pt x="790575" y="304800"/>
                      </a:cubicBezTo>
                      <a:cubicBezTo>
                        <a:pt x="793892" y="305242"/>
                        <a:pt x="797487" y="305884"/>
                        <a:pt x="800100" y="307975"/>
                      </a:cubicBezTo>
                      <a:cubicBezTo>
                        <a:pt x="817298" y="321733"/>
                        <a:pt x="794544" y="314325"/>
                        <a:pt x="815975" y="323850"/>
                      </a:cubicBezTo>
                      <a:cubicBezTo>
                        <a:pt x="822092" y="326568"/>
                        <a:pt x="828675" y="328083"/>
                        <a:pt x="835025" y="330200"/>
                      </a:cubicBezTo>
                      <a:cubicBezTo>
                        <a:pt x="838200" y="331258"/>
                        <a:pt x="841303" y="332563"/>
                        <a:pt x="844550" y="333375"/>
                      </a:cubicBezTo>
                      <a:cubicBezTo>
                        <a:pt x="848619" y="334392"/>
                        <a:pt x="862220" y="337448"/>
                        <a:pt x="866775" y="339725"/>
                      </a:cubicBezTo>
                      <a:cubicBezTo>
                        <a:pt x="885328" y="349002"/>
                        <a:pt x="867204" y="343930"/>
                        <a:pt x="885825" y="349250"/>
                      </a:cubicBezTo>
                      <a:cubicBezTo>
                        <a:pt x="890021" y="350449"/>
                        <a:pt x="894329" y="351226"/>
                        <a:pt x="898525" y="352425"/>
                      </a:cubicBezTo>
                      <a:cubicBezTo>
                        <a:pt x="901743" y="353344"/>
                        <a:pt x="904749" y="355050"/>
                        <a:pt x="908050" y="355600"/>
                      </a:cubicBezTo>
                      <a:cubicBezTo>
                        <a:pt x="935084" y="360106"/>
                        <a:pt x="981972" y="360934"/>
                        <a:pt x="1003300" y="361950"/>
                      </a:cubicBezTo>
                      <a:cubicBezTo>
                        <a:pt x="1023408" y="360892"/>
                        <a:pt x="1043572" y="360598"/>
                        <a:pt x="1063625" y="358775"/>
                      </a:cubicBezTo>
                      <a:cubicBezTo>
                        <a:pt x="1066958" y="358472"/>
                        <a:pt x="1069883" y="356326"/>
                        <a:pt x="1073150" y="355600"/>
                      </a:cubicBezTo>
                      <a:cubicBezTo>
                        <a:pt x="1079434" y="354203"/>
                        <a:pt x="1085916" y="353822"/>
                        <a:pt x="1092200" y="352425"/>
                      </a:cubicBezTo>
                      <a:cubicBezTo>
                        <a:pt x="1095467" y="351699"/>
                        <a:pt x="1098507" y="350169"/>
                        <a:pt x="1101725" y="349250"/>
                      </a:cubicBezTo>
                      <a:cubicBezTo>
                        <a:pt x="1105921" y="348051"/>
                        <a:pt x="1110245" y="347329"/>
                        <a:pt x="1114425" y="346075"/>
                      </a:cubicBezTo>
                      <a:cubicBezTo>
                        <a:pt x="1120836" y="344152"/>
                        <a:pt x="1133475" y="339725"/>
                        <a:pt x="1133475" y="339725"/>
                      </a:cubicBezTo>
                      <a:cubicBezTo>
                        <a:pt x="1134533" y="336550"/>
                        <a:pt x="1134876" y="333038"/>
                        <a:pt x="1136650" y="330200"/>
                      </a:cubicBezTo>
                      <a:cubicBezTo>
                        <a:pt x="1140242" y="324453"/>
                        <a:pt x="1144754" y="319304"/>
                        <a:pt x="1149350" y="314325"/>
                      </a:cubicBezTo>
                      <a:cubicBezTo>
                        <a:pt x="1157472" y="305527"/>
                        <a:pt x="1168108" y="298888"/>
                        <a:pt x="1174750" y="288925"/>
                      </a:cubicBezTo>
                      <a:lnTo>
                        <a:pt x="1187450" y="269875"/>
                      </a:lnTo>
                      <a:cubicBezTo>
                        <a:pt x="1189567" y="266700"/>
                        <a:pt x="1191102" y="263048"/>
                        <a:pt x="1193800" y="260350"/>
                      </a:cubicBezTo>
                      <a:lnTo>
                        <a:pt x="1203325" y="250825"/>
                      </a:lnTo>
                      <a:cubicBezTo>
                        <a:pt x="1205442" y="244475"/>
                        <a:pt x="1205962" y="237344"/>
                        <a:pt x="1209675" y="231775"/>
                      </a:cubicBezTo>
                      <a:cubicBezTo>
                        <a:pt x="1241773" y="183627"/>
                        <a:pt x="1207031" y="233043"/>
                        <a:pt x="1231900" y="203200"/>
                      </a:cubicBezTo>
                      <a:cubicBezTo>
                        <a:pt x="1234343" y="200269"/>
                        <a:pt x="1235378" y="196188"/>
                        <a:pt x="1238250" y="193675"/>
                      </a:cubicBezTo>
                      <a:cubicBezTo>
                        <a:pt x="1243993" y="188649"/>
                        <a:pt x="1251904" y="186371"/>
                        <a:pt x="1257300" y="180975"/>
                      </a:cubicBezTo>
                      <a:cubicBezTo>
                        <a:pt x="1272221" y="166054"/>
                        <a:pt x="1263089" y="173941"/>
                        <a:pt x="1285875" y="158750"/>
                      </a:cubicBezTo>
                      <a:cubicBezTo>
                        <a:pt x="1289050" y="156633"/>
                        <a:pt x="1291987" y="154107"/>
                        <a:pt x="1295400" y="152400"/>
                      </a:cubicBezTo>
                      <a:cubicBezTo>
                        <a:pt x="1299633" y="150283"/>
                        <a:pt x="1303750" y="147914"/>
                        <a:pt x="1308100" y="146050"/>
                      </a:cubicBezTo>
                      <a:cubicBezTo>
                        <a:pt x="1311176" y="144732"/>
                        <a:pt x="1314699" y="144500"/>
                        <a:pt x="1317625" y="142875"/>
                      </a:cubicBezTo>
                      <a:cubicBezTo>
                        <a:pt x="1324296" y="139169"/>
                        <a:pt x="1329435" y="132588"/>
                        <a:pt x="1336675" y="130175"/>
                      </a:cubicBezTo>
                      <a:cubicBezTo>
                        <a:pt x="1339850" y="129117"/>
                        <a:pt x="1343274" y="128625"/>
                        <a:pt x="1346200" y="127000"/>
                      </a:cubicBezTo>
                      <a:cubicBezTo>
                        <a:pt x="1352871" y="123294"/>
                        <a:pt x="1359854" y="119696"/>
                        <a:pt x="1365250" y="114300"/>
                      </a:cubicBezTo>
                      <a:cubicBezTo>
                        <a:pt x="1368425" y="111125"/>
                        <a:pt x="1371039" y="107266"/>
                        <a:pt x="1374775" y="104775"/>
                      </a:cubicBezTo>
                      <a:cubicBezTo>
                        <a:pt x="1377560" y="102919"/>
                        <a:pt x="1381307" y="103097"/>
                        <a:pt x="1384300" y="101600"/>
                      </a:cubicBezTo>
                      <a:cubicBezTo>
                        <a:pt x="1387713" y="99893"/>
                        <a:pt x="1390650" y="97367"/>
                        <a:pt x="1393825" y="95250"/>
                      </a:cubicBezTo>
                      <a:cubicBezTo>
                        <a:pt x="1400653" y="74766"/>
                        <a:pt x="1395464" y="96684"/>
                        <a:pt x="1393825" y="76200"/>
                      </a:cubicBezTo>
                      <a:cubicBezTo>
                        <a:pt x="1387789" y="746"/>
                        <a:pt x="1410483" y="19572"/>
                        <a:pt x="1381125" y="0"/>
                      </a:cubicBezTo>
                      <a:cubicBezTo>
                        <a:pt x="1377304" y="347"/>
                        <a:pt x="1347431" y="375"/>
                        <a:pt x="1336675" y="6350"/>
                      </a:cubicBezTo>
                      <a:cubicBezTo>
                        <a:pt x="1330004" y="10056"/>
                        <a:pt x="1323975" y="14817"/>
                        <a:pt x="1317625" y="19050"/>
                      </a:cubicBezTo>
                      <a:cubicBezTo>
                        <a:pt x="1314450" y="21167"/>
                        <a:pt x="1311720" y="24193"/>
                        <a:pt x="1308100" y="25400"/>
                      </a:cubicBezTo>
                      <a:lnTo>
                        <a:pt x="1289050" y="31750"/>
                      </a:lnTo>
                      <a:cubicBezTo>
                        <a:pt x="1285875" y="32808"/>
                        <a:pt x="1282310" y="33069"/>
                        <a:pt x="1279525" y="34925"/>
                      </a:cubicBezTo>
                      <a:cubicBezTo>
                        <a:pt x="1276350" y="37042"/>
                        <a:pt x="1273487" y="39725"/>
                        <a:pt x="1270000" y="41275"/>
                      </a:cubicBezTo>
                      <a:cubicBezTo>
                        <a:pt x="1263883" y="43993"/>
                        <a:pt x="1257300" y="45508"/>
                        <a:pt x="1250950" y="47625"/>
                      </a:cubicBezTo>
                      <a:lnTo>
                        <a:pt x="1231900" y="53975"/>
                      </a:lnTo>
                      <a:cubicBezTo>
                        <a:pt x="1228725" y="55033"/>
                        <a:pt x="1225160" y="55294"/>
                        <a:pt x="1222375" y="57150"/>
                      </a:cubicBezTo>
                      <a:cubicBezTo>
                        <a:pt x="1219200" y="59267"/>
                        <a:pt x="1216337" y="61950"/>
                        <a:pt x="1212850" y="63500"/>
                      </a:cubicBezTo>
                      <a:cubicBezTo>
                        <a:pt x="1206733" y="66218"/>
                        <a:pt x="1200150" y="67733"/>
                        <a:pt x="1193800" y="69850"/>
                      </a:cubicBezTo>
                      <a:cubicBezTo>
                        <a:pt x="1190625" y="70908"/>
                        <a:pt x="1187522" y="72213"/>
                        <a:pt x="1184275" y="73025"/>
                      </a:cubicBezTo>
                      <a:cubicBezTo>
                        <a:pt x="1180042" y="74083"/>
                        <a:pt x="1175755" y="74946"/>
                        <a:pt x="1171575" y="76200"/>
                      </a:cubicBezTo>
                      <a:cubicBezTo>
                        <a:pt x="1165164" y="78123"/>
                        <a:pt x="1158094" y="78837"/>
                        <a:pt x="1152525" y="82550"/>
                      </a:cubicBezTo>
                      <a:cubicBezTo>
                        <a:pt x="1129319" y="98021"/>
                        <a:pt x="1158498" y="79137"/>
                        <a:pt x="1130300" y="95250"/>
                      </a:cubicBezTo>
                      <a:cubicBezTo>
                        <a:pt x="1126987" y="97143"/>
                        <a:pt x="1124188" y="99893"/>
                        <a:pt x="1120775" y="101600"/>
                      </a:cubicBezTo>
                      <a:cubicBezTo>
                        <a:pt x="1117782" y="103097"/>
                        <a:pt x="1114243" y="103278"/>
                        <a:pt x="1111250" y="104775"/>
                      </a:cubicBezTo>
                      <a:cubicBezTo>
                        <a:pt x="1107837" y="106482"/>
                        <a:pt x="1105138" y="109418"/>
                        <a:pt x="1101725" y="111125"/>
                      </a:cubicBezTo>
                      <a:cubicBezTo>
                        <a:pt x="1098732" y="112622"/>
                        <a:pt x="1095126" y="112675"/>
                        <a:pt x="1092200" y="114300"/>
                      </a:cubicBezTo>
                      <a:cubicBezTo>
                        <a:pt x="1085529" y="118006"/>
                        <a:pt x="1073150" y="127000"/>
                        <a:pt x="1073150" y="127000"/>
                      </a:cubicBezTo>
                      <a:cubicBezTo>
                        <a:pt x="1068917" y="133350"/>
                        <a:pt x="1062863" y="138810"/>
                        <a:pt x="1060450" y="146050"/>
                      </a:cubicBezTo>
                      <a:cubicBezTo>
                        <a:pt x="1056068" y="159195"/>
                        <a:pt x="1059131" y="152790"/>
                        <a:pt x="1050925" y="165100"/>
                      </a:cubicBezTo>
                      <a:cubicBezTo>
                        <a:pt x="1049867" y="169333"/>
                        <a:pt x="1049469" y="173789"/>
                        <a:pt x="1047750" y="177800"/>
                      </a:cubicBezTo>
                      <a:cubicBezTo>
                        <a:pt x="1046247" y="181307"/>
                        <a:pt x="1042522" y="183678"/>
                        <a:pt x="1041400" y="187325"/>
                      </a:cubicBezTo>
                      <a:cubicBezTo>
                        <a:pt x="1038226" y="197641"/>
                        <a:pt x="1044030" y="213088"/>
                        <a:pt x="1035050" y="219075"/>
                      </a:cubicBezTo>
                      <a:lnTo>
                        <a:pt x="1016000" y="231775"/>
                      </a:lnTo>
                      <a:cubicBezTo>
                        <a:pt x="1012825" y="233892"/>
                        <a:pt x="1010095" y="236918"/>
                        <a:pt x="1006475" y="238125"/>
                      </a:cubicBezTo>
                      <a:lnTo>
                        <a:pt x="987425" y="244475"/>
                      </a:lnTo>
                      <a:cubicBezTo>
                        <a:pt x="964142" y="243417"/>
                        <a:pt x="940808" y="243159"/>
                        <a:pt x="917575" y="241300"/>
                      </a:cubicBezTo>
                      <a:cubicBezTo>
                        <a:pt x="906984" y="240453"/>
                        <a:pt x="907922" y="235952"/>
                        <a:pt x="898525" y="231775"/>
                      </a:cubicBezTo>
                      <a:cubicBezTo>
                        <a:pt x="892408" y="229057"/>
                        <a:pt x="885825" y="227542"/>
                        <a:pt x="879475" y="225425"/>
                      </a:cubicBezTo>
                      <a:cubicBezTo>
                        <a:pt x="876300" y="224367"/>
                        <a:pt x="872735" y="224106"/>
                        <a:pt x="869950" y="222250"/>
                      </a:cubicBezTo>
                      <a:cubicBezTo>
                        <a:pt x="863600" y="218017"/>
                        <a:pt x="858140" y="211963"/>
                        <a:pt x="850900" y="209550"/>
                      </a:cubicBezTo>
                      <a:lnTo>
                        <a:pt x="831850" y="203200"/>
                      </a:lnTo>
                      <a:cubicBezTo>
                        <a:pt x="828675" y="202142"/>
                        <a:pt x="825110" y="201881"/>
                        <a:pt x="822325" y="200025"/>
                      </a:cubicBezTo>
                      <a:cubicBezTo>
                        <a:pt x="808310" y="190682"/>
                        <a:pt x="816542" y="194423"/>
                        <a:pt x="796925" y="190500"/>
                      </a:cubicBezTo>
                      <a:lnTo>
                        <a:pt x="777875" y="177800"/>
                      </a:lnTo>
                      <a:cubicBezTo>
                        <a:pt x="774700" y="175683"/>
                        <a:pt x="772052" y="172375"/>
                        <a:pt x="768350" y="171450"/>
                      </a:cubicBezTo>
                      <a:cubicBezTo>
                        <a:pt x="759883" y="169333"/>
                        <a:pt x="751558" y="166535"/>
                        <a:pt x="742950" y="165100"/>
                      </a:cubicBezTo>
                      <a:cubicBezTo>
                        <a:pt x="718577" y="161038"/>
                        <a:pt x="730213" y="163188"/>
                        <a:pt x="708025" y="158750"/>
                      </a:cubicBezTo>
                      <a:cubicBezTo>
                        <a:pt x="692150" y="159808"/>
                        <a:pt x="676116" y="159444"/>
                        <a:pt x="660400" y="161925"/>
                      </a:cubicBezTo>
                      <a:cubicBezTo>
                        <a:pt x="655725" y="162663"/>
                        <a:pt x="652050" y="166411"/>
                        <a:pt x="647700" y="168275"/>
                      </a:cubicBezTo>
                      <a:cubicBezTo>
                        <a:pt x="644624" y="169593"/>
                        <a:pt x="641350" y="170392"/>
                        <a:pt x="638175" y="171450"/>
                      </a:cubicBezTo>
                      <a:cubicBezTo>
                        <a:pt x="635000" y="174625"/>
                        <a:pt x="632099" y="178100"/>
                        <a:pt x="628650" y="180975"/>
                      </a:cubicBezTo>
                      <a:cubicBezTo>
                        <a:pt x="625719" y="183418"/>
                        <a:pt x="621823" y="184627"/>
                        <a:pt x="619125" y="187325"/>
                      </a:cubicBezTo>
                      <a:cubicBezTo>
                        <a:pt x="616427" y="190023"/>
                        <a:pt x="614993" y="193745"/>
                        <a:pt x="612775" y="196850"/>
                      </a:cubicBezTo>
                      <a:cubicBezTo>
                        <a:pt x="609699" y="201156"/>
                        <a:pt x="606992" y="205808"/>
                        <a:pt x="603250" y="209550"/>
                      </a:cubicBezTo>
                      <a:cubicBezTo>
                        <a:pt x="600552" y="212248"/>
                        <a:pt x="596900" y="213783"/>
                        <a:pt x="593725" y="215900"/>
                      </a:cubicBezTo>
                      <a:cubicBezTo>
                        <a:pt x="582083" y="233362"/>
                        <a:pt x="593725" y="218546"/>
                        <a:pt x="577850" y="231775"/>
                      </a:cubicBezTo>
                      <a:cubicBezTo>
                        <a:pt x="566892" y="240907"/>
                        <a:pt x="565324" y="248650"/>
                        <a:pt x="549275" y="254000"/>
                      </a:cubicBezTo>
                      <a:cubicBezTo>
                        <a:pt x="542925" y="256117"/>
                        <a:pt x="536867" y="259520"/>
                        <a:pt x="530225" y="260350"/>
                      </a:cubicBezTo>
                      <a:cubicBezTo>
                        <a:pt x="494271" y="264844"/>
                        <a:pt x="513315" y="262676"/>
                        <a:pt x="473075" y="266700"/>
                      </a:cubicBezTo>
                      <a:cubicBezTo>
                        <a:pt x="469900" y="267758"/>
                        <a:pt x="466892" y="270051"/>
                        <a:pt x="463550" y="269875"/>
                      </a:cubicBezTo>
                      <a:cubicBezTo>
                        <a:pt x="446508" y="268978"/>
                        <a:pt x="412750" y="263525"/>
                        <a:pt x="412750" y="263525"/>
                      </a:cubicBezTo>
                      <a:lnTo>
                        <a:pt x="250825" y="266700"/>
                      </a:lnTo>
                      <a:cubicBezTo>
                        <a:pt x="244541" y="266917"/>
                        <a:pt x="227089" y="269043"/>
                        <a:pt x="219075" y="273050"/>
                      </a:cubicBezTo>
                      <a:cubicBezTo>
                        <a:pt x="212358" y="276408"/>
                        <a:pt x="202603" y="285330"/>
                        <a:pt x="196850" y="288925"/>
                      </a:cubicBezTo>
                      <a:cubicBezTo>
                        <a:pt x="192836" y="291433"/>
                        <a:pt x="188259" y="292927"/>
                        <a:pt x="184150" y="295275"/>
                      </a:cubicBezTo>
                      <a:cubicBezTo>
                        <a:pt x="180837" y="297168"/>
                        <a:pt x="177938" y="299732"/>
                        <a:pt x="174625" y="301625"/>
                      </a:cubicBezTo>
                      <a:cubicBezTo>
                        <a:pt x="160434" y="309734"/>
                        <a:pt x="165353" y="306293"/>
                        <a:pt x="152400" y="311150"/>
                      </a:cubicBezTo>
                      <a:cubicBezTo>
                        <a:pt x="128488" y="320117"/>
                        <a:pt x="145105" y="315355"/>
                        <a:pt x="123825" y="320675"/>
                      </a:cubicBezTo>
                      <a:cubicBezTo>
                        <a:pt x="120650" y="322792"/>
                        <a:pt x="117886" y="325721"/>
                        <a:pt x="114300" y="327025"/>
                      </a:cubicBezTo>
                      <a:cubicBezTo>
                        <a:pt x="103616" y="330910"/>
                        <a:pt x="90291" y="331872"/>
                        <a:pt x="79375" y="336550"/>
                      </a:cubicBezTo>
                      <a:cubicBezTo>
                        <a:pt x="75025" y="338414"/>
                        <a:pt x="71069" y="341142"/>
                        <a:pt x="66675" y="342900"/>
                      </a:cubicBezTo>
                      <a:cubicBezTo>
                        <a:pt x="60460" y="345386"/>
                        <a:pt x="53194" y="345537"/>
                        <a:pt x="47625" y="349250"/>
                      </a:cubicBezTo>
                      <a:cubicBezTo>
                        <a:pt x="44450" y="351367"/>
                        <a:pt x="41587" y="354050"/>
                        <a:pt x="38100" y="355600"/>
                      </a:cubicBezTo>
                      <a:lnTo>
                        <a:pt x="9525" y="365125"/>
                      </a:lnTo>
                      <a:lnTo>
                        <a:pt x="0" y="368300"/>
                      </a:lnTo>
                      <a:cubicBezTo>
                        <a:pt x="8057" y="392470"/>
                        <a:pt x="5037" y="380786"/>
                        <a:pt x="9525" y="403225"/>
                      </a:cubicBezTo>
                      <a:cubicBezTo>
                        <a:pt x="10583" y="419100"/>
                        <a:pt x="10450" y="435100"/>
                        <a:pt x="12700" y="450850"/>
                      </a:cubicBezTo>
                      <a:cubicBezTo>
                        <a:pt x="13995" y="459912"/>
                        <a:pt x="17051" y="473945"/>
                        <a:pt x="28575" y="476250"/>
                      </a:cubicBezTo>
                      <a:cubicBezTo>
                        <a:pt x="30896" y="476714"/>
                        <a:pt x="21696" y="469900"/>
                        <a:pt x="28575" y="466725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B0F0"/>
                  </a:solidFill>
                  <a:prstDash val="dash"/>
                  <a:extLst>
                    <a:ext uri="{C807C97D-BFC1-408E-A445-0C87EB9F89A2}">
                      <ask:lineSketchStyleProps xmlns:ask="http://schemas.microsoft.com/office/drawing/2018/sketchyshapes" xmlns="" sd="1219033472">
                        <a:custGeom>
                          <a:avLst/>
                          <a:gdLst>
                            <a:gd name="connsiteX0" fmla="*/ 28194 w 1378659"/>
                            <a:gd name="connsiteY0" fmla="*/ 466703 h 476250"/>
                            <a:gd name="connsiteX1" fmla="*/ 68920 w 1378659"/>
                            <a:gd name="connsiteY1" fmla="*/ 457178 h 476250"/>
                            <a:gd name="connsiteX2" fmla="*/ 78318 w 1378659"/>
                            <a:gd name="connsiteY2" fmla="*/ 454004 h 476250"/>
                            <a:gd name="connsiteX3" fmla="*/ 87716 w 1378659"/>
                            <a:gd name="connsiteY3" fmla="*/ 447654 h 476250"/>
                            <a:gd name="connsiteX4" fmla="*/ 112778 w 1378659"/>
                            <a:gd name="connsiteY4" fmla="*/ 441304 h 476250"/>
                            <a:gd name="connsiteX5" fmla="*/ 153504 w 1378659"/>
                            <a:gd name="connsiteY5" fmla="*/ 434954 h 476250"/>
                            <a:gd name="connsiteX6" fmla="*/ 172300 w 1378659"/>
                            <a:gd name="connsiteY6" fmla="*/ 428605 h 476250"/>
                            <a:gd name="connsiteX7" fmla="*/ 181698 w 1378659"/>
                            <a:gd name="connsiteY7" fmla="*/ 422255 h 476250"/>
                            <a:gd name="connsiteX8" fmla="*/ 225557 w 1378659"/>
                            <a:gd name="connsiteY8" fmla="*/ 409556 h 476250"/>
                            <a:gd name="connsiteX9" fmla="*/ 256884 w 1378659"/>
                            <a:gd name="connsiteY9" fmla="*/ 400031 h 476250"/>
                            <a:gd name="connsiteX10" fmla="*/ 266282 w 1378659"/>
                            <a:gd name="connsiteY10" fmla="*/ 396856 h 476250"/>
                            <a:gd name="connsiteX11" fmla="*/ 294477 w 1378659"/>
                            <a:gd name="connsiteY11" fmla="*/ 390506 h 476250"/>
                            <a:gd name="connsiteX12" fmla="*/ 313273 w 1378659"/>
                            <a:gd name="connsiteY12" fmla="*/ 384157 h 476250"/>
                            <a:gd name="connsiteX13" fmla="*/ 322672 w 1378659"/>
                            <a:gd name="connsiteY13" fmla="*/ 380982 h 476250"/>
                            <a:gd name="connsiteX14" fmla="*/ 332070 w 1378659"/>
                            <a:gd name="connsiteY14" fmla="*/ 377807 h 476250"/>
                            <a:gd name="connsiteX15" fmla="*/ 350866 w 1378659"/>
                            <a:gd name="connsiteY15" fmla="*/ 365108 h 476250"/>
                            <a:gd name="connsiteX16" fmla="*/ 372796 w 1378659"/>
                            <a:gd name="connsiteY16" fmla="*/ 358758 h 476250"/>
                            <a:gd name="connsiteX17" fmla="*/ 391592 w 1378659"/>
                            <a:gd name="connsiteY17" fmla="*/ 352408 h 476250"/>
                            <a:gd name="connsiteX18" fmla="*/ 413521 w 1378659"/>
                            <a:gd name="connsiteY18" fmla="*/ 349233 h 476250"/>
                            <a:gd name="connsiteX19" fmla="*/ 429185 w 1378659"/>
                            <a:gd name="connsiteY19" fmla="*/ 346059 h 476250"/>
                            <a:gd name="connsiteX20" fmla="*/ 601486 w 1378659"/>
                            <a:gd name="connsiteY20" fmla="*/ 342884 h 476250"/>
                            <a:gd name="connsiteX21" fmla="*/ 632813 w 1378659"/>
                            <a:gd name="connsiteY21" fmla="*/ 336534 h 476250"/>
                            <a:gd name="connsiteX22" fmla="*/ 676671 w 1378659"/>
                            <a:gd name="connsiteY22" fmla="*/ 327009 h 476250"/>
                            <a:gd name="connsiteX23" fmla="*/ 695468 w 1378659"/>
                            <a:gd name="connsiteY23" fmla="*/ 320660 h 476250"/>
                            <a:gd name="connsiteX24" fmla="*/ 704866 w 1378659"/>
                            <a:gd name="connsiteY24" fmla="*/ 317485 h 476250"/>
                            <a:gd name="connsiteX25" fmla="*/ 714264 w 1378659"/>
                            <a:gd name="connsiteY25" fmla="*/ 314310 h 476250"/>
                            <a:gd name="connsiteX26" fmla="*/ 723662 w 1378659"/>
                            <a:gd name="connsiteY26" fmla="*/ 307960 h 476250"/>
                            <a:gd name="connsiteX27" fmla="*/ 742459 w 1378659"/>
                            <a:gd name="connsiteY27" fmla="*/ 301611 h 476250"/>
                            <a:gd name="connsiteX28" fmla="*/ 780052 w 1378659"/>
                            <a:gd name="connsiteY28" fmla="*/ 304785 h 476250"/>
                            <a:gd name="connsiteX29" fmla="*/ 789450 w 1378659"/>
                            <a:gd name="connsiteY29" fmla="*/ 307960 h 476250"/>
                            <a:gd name="connsiteX30" fmla="*/ 805114 w 1378659"/>
                            <a:gd name="connsiteY30" fmla="*/ 323835 h 476250"/>
                            <a:gd name="connsiteX31" fmla="*/ 823910 w 1378659"/>
                            <a:gd name="connsiteY31" fmla="*/ 330184 h 476250"/>
                            <a:gd name="connsiteX32" fmla="*/ 833308 w 1378659"/>
                            <a:gd name="connsiteY32" fmla="*/ 333359 h 476250"/>
                            <a:gd name="connsiteX33" fmla="*/ 855237 w 1378659"/>
                            <a:gd name="connsiteY33" fmla="*/ 339709 h 476250"/>
                            <a:gd name="connsiteX34" fmla="*/ 874034 w 1378659"/>
                            <a:gd name="connsiteY34" fmla="*/ 349233 h 476250"/>
                            <a:gd name="connsiteX35" fmla="*/ 886565 w 1378659"/>
                            <a:gd name="connsiteY35" fmla="*/ 352408 h 476250"/>
                            <a:gd name="connsiteX36" fmla="*/ 895963 w 1378659"/>
                            <a:gd name="connsiteY36" fmla="*/ 355583 h 476250"/>
                            <a:gd name="connsiteX37" fmla="*/ 989945 w 1378659"/>
                            <a:gd name="connsiteY37" fmla="*/ 361933 h 476250"/>
                            <a:gd name="connsiteX38" fmla="*/ 1049467 w 1378659"/>
                            <a:gd name="connsiteY38" fmla="*/ 358758 h 476250"/>
                            <a:gd name="connsiteX39" fmla="*/ 1058865 w 1378659"/>
                            <a:gd name="connsiteY39" fmla="*/ 355583 h 476250"/>
                            <a:gd name="connsiteX40" fmla="*/ 1077662 w 1378659"/>
                            <a:gd name="connsiteY40" fmla="*/ 352408 h 476250"/>
                            <a:gd name="connsiteX41" fmla="*/ 1087060 w 1378659"/>
                            <a:gd name="connsiteY41" fmla="*/ 349233 h 476250"/>
                            <a:gd name="connsiteX42" fmla="*/ 1099591 w 1378659"/>
                            <a:gd name="connsiteY42" fmla="*/ 346059 h 476250"/>
                            <a:gd name="connsiteX43" fmla="*/ 1118388 w 1378659"/>
                            <a:gd name="connsiteY43" fmla="*/ 339709 h 476250"/>
                            <a:gd name="connsiteX44" fmla="*/ 1121520 w 1378659"/>
                            <a:gd name="connsiteY44" fmla="*/ 330184 h 476250"/>
                            <a:gd name="connsiteX45" fmla="*/ 1134051 w 1378659"/>
                            <a:gd name="connsiteY45" fmla="*/ 314310 h 476250"/>
                            <a:gd name="connsiteX46" fmla="*/ 1159113 w 1378659"/>
                            <a:gd name="connsiteY46" fmla="*/ 288911 h 476250"/>
                            <a:gd name="connsiteX47" fmla="*/ 1171644 w 1378659"/>
                            <a:gd name="connsiteY47" fmla="*/ 269862 h 476250"/>
                            <a:gd name="connsiteX48" fmla="*/ 1177910 w 1378659"/>
                            <a:gd name="connsiteY48" fmla="*/ 260337 h 476250"/>
                            <a:gd name="connsiteX49" fmla="*/ 1187308 w 1378659"/>
                            <a:gd name="connsiteY49" fmla="*/ 250813 h 476250"/>
                            <a:gd name="connsiteX50" fmla="*/ 1193573 w 1378659"/>
                            <a:gd name="connsiteY50" fmla="*/ 231764 h 476250"/>
                            <a:gd name="connsiteX51" fmla="*/ 1215502 w 1378659"/>
                            <a:gd name="connsiteY51" fmla="*/ 203190 h 476250"/>
                            <a:gd name="connsiteX52" fmla="*/ 1221768 w 1378659"/>
                            <a:gd name="connsiteY52" fmla="*/ 193666 h 476250"/>
                            <a:gd name="connsiteX53" fmla="*/ 1240564 w 1378659"/>
                            <a:gd name="connsiteY53" fmla="*/ 180966 h 476250"/>
                            <a:gd name="connsiteX54" fmla="*/ 1268759 w 1378659"/>
                            <a:gd name="connsiteY54" fmla="*/ 158742 h 476250"/>
                            <a:gd name="connsiteX55" fmla="*/ 1278157 w 1378659"/>
                            <a:gd name="connsiteY55" fmla="*/ 152392 h 476250"/>
                            <a:gd name="connsiteX56" fmla="*/ 1290688 w 1378659"/>
                            <a:gd name="connsiteY56" fmla="*/ 146043 h 476250"/>
                            <a:gd name="connsiteX57" fmla="*/ 1300086 w 1378659"/>
                            <a:gd name="connsiteY57" fmla="*/ 142868 h 476250"/>
                            <a:gd name="connsiteX58" fmla="*/ 1318883 w 1378659"/>
                            <a:gd name="connsiteY58" fmla="*/ 130168 h 476250"/>
                            <a:gd name="connsiteX59" fmla="*/ 1328281 w 1378659"/>
                            <a:gd name="connsiteY59" fmla="*/ 126994 h 476250"/>
                            <a:gd name="connsiteX60" fmla="*/ 1347078 w 1378659"/>
                            <a:gd name="connsiteY60" fmla="*/ 114294 h 476250"/>
                            <a:gd name="connsiteX61" fmla="*/ 1356476 w 1378659"/>
                            <a:gd name="connsiteY61" fmla="*/ 104770 h 476250"/>
                            <a:gd name="connsiteX62" fmla="*/ 1365874 w 1378659"/>
                            <a:gd name="connsiteY62" fmla="*/ 101595 h 476250"/>
                            <a:gd name="connsiteX63" fmla="*/ 1375272 w 1378659"/>
                            <a:gd name="connsiteY63" fmla="*/ 95245 h 476250"/>
                            <a:gd name="connsiteX64" fmla="*/ 1375272 w 1378659"/>
                            <a:gd name="connsiteY64" fmla="*/ 76196 h 476250"/>
                            <a:gd name="connsiteX65" fmla="*/ 1362741 w 1378659"/>
                            <a:gd name="connsiteY65" fmla="*/ 0 h 476250"/>
                            <a:gd name="connsiteX66" fmla="*/ 1318883 w 1378659"/>
                            <a:gd name="connsiteY66" fmla="*/ 6349 h 476250"/>
                            <a:gd name="connsiteX67" fmla="*/ 1300086 w 1378659"/>
                            <a:gd name="connsiteY67" fmla="*/ 19049 h 476250"/>
                            <a:gd name="connsiteX68" fmla="*/ 1290688 w 1378659"/>
                            <a:gd name="connsiteY68" fmla="*/ 25398 h 476250"/>
                            <a:gd name="connsiteX69" fmla="*/ 1271892 w 1378659"/>
                            <a:gd name="connsiteY69" fmla="*/ 31748 h 476250"/>
                            <a:gd name="connsiteX70" fmla="*/ 1262494 w 1378659"/>
                            <a:gd name="connsiteY70" fmla="*/ 34923 h 476250"/>
                            <a:gd name="connsiteX71" fmla="*/ 1253095 w 1378659"/>
                            <a:gd name="connsiteY71" fmla="*/ 41273 h 476250"/>
                            <a:gd name="connsiteX72" fmla="*/ 1234299 w 1378659"/>
                            <a:gd name="connsiteY72" fmla="*/ 47622 h 476250"/>
                            <a:gd name="connsiteX73" fmla="*/ 1215502 w 1378659"/>
                            <a:gd name="connsiteY73" fmla="*/ 53972 h 476250"/>
                            <a:gd name="connsiteX74" fmla="*/ 1206104 w 1378659"/>
                            <a:gd name="connsiteY74" fmla="*/ 57147 h 476250"/>
                            <a:gd name="connsiteX75" fmla="*/ 1196706 w 1378659"/>
                            <a:gd name="connsiteY75" fmla="*/ 63497 h 476250"/>
                            <a:gd name="connsiteX76" fmla="*/ 1177910 w 1378659"/>
                            <a:gd name="connsiteY76" fmla="*/ 69846 h 476250"/>
                            <a:gd name="connsiteX77" fmla="*/ 1168511 w 1378659"/>
                            <a:gd name="connsiteY77" fmla="*/ 73021 h 476250"/>
                            <a:gd name="connsiteX78" fmla="*/ 1155980 w 1378659"/>
                            <a:gd name="connsiteY78" fmla="*/ 76196 h 476250"/>
                            <a:gd name="connsiteX79" fmla="*/ 1137184 w 1378659"/>
                            <a:gd name="connsiteY79" fmla="*/ 82546 h 476250"/>
                            <a:gd name="connsiteX80" fmla="*/ 1115255 w 1378659"/>
                            <a:gd name="connsiteY80" fmla="*/ 95245 h 476250"/>
                            <a:gd name="connsiteX81" fmla="*/ 1105857 w 1378659"/>
                            <a:gd name="connsiteY81" fmla="*/ 101595 h 476250"/>
                            <a:gd name="connsiteX82" fmla="*/ 1096458 w 1378659"/>
                            <a:gd name="connsiteY82" fmla="*/ 104770 h 476250"/>
                            <a:gd name="connsiteX83" fmla="*/ 1087060 w 1378659"/>
                            <a:gd name="connsiteY83" fmla="*/ 111119 h 476250"/>
                            <a:gd name="connsiteX84" fmla="*/ 1077662 w 1378659"/>
                            <a:gd name="connsiteY84" fmla="*/ 114294 h 476250"/>
                            <a:gd name="connsiteX85" fmla="*/ 1058865 w 1378659"/>
                            <a:gd name="connsiteY85" fmla="*/ 126994 h 476250"/>
                            <a:gd name="connsiteX86" fmla="*/ 1046335 w 1378659"/>
                            <a:gd name="connsiteY86" fmla="*/ 146043 h 476250"/>
                            <a:gd name="connsiteX87" fmla="*/ 1036936 w 1378659"/>
                            <a:gd name="connsiteY87" fmla="*/ 165092 h 476250"/>
                            <a:gd name="connsiteX88" fmla="*/ 1033804 w 1378659"/>
                            <a:gd name="connsiteY88" fmla="*/ 177791 h 476250"/>
                            <a:gd name="connsiteX89" fmla="*/ 1027538 w 1378659"/>
                            <a:gd name="connsiteY89" fmla="*/ 187316 h 476250"/>
                            <a:gd name="connsiteX90" fmla="*/ 1021273 w 1378659"/>
                            <a:gd name="connsiteY90" fmla="*/ 219064 h 476250"/>
                            <a:gd name="connsiteX91" fmla="*/ 1002476 w 1378659"/>
                            <a:gd name="connsiteY91" fmla="*/ 231764 h 476250"/>
                            <a:gd name="connsiteX92" fmla="*/ 993078 w 1378659"/>
                            <a:gd name="connsiteY92" fmla="*/ 238114 h 476250"/>
                            <a:gd name="connsiteX93" fmla="*/ 974282 w 1378659"/>
                            <a:gd name="connsiteY93" fmla="*/ 244463 h 476250"/>
                            <a:gd name="connsiteX94" fmla="*/ 905361 w 1378659"/>
                            <a:gd name="connsiteY94" fmla="*/ 241288 h 476250"/>
                            <a:gd name="connsiteX95" fmla="*/ 886565 w 1378659"/>
                            <a:gd name="connsiteY95" fmla="*/ 231764 h 476250"/>
                            <a:gd name="connsiteX96" fmla="*/ 867768 w 1378659"/>
                            <a:gd name="connsiteY96" fmla="*/ 225414 h 476250"/>
                            <a:gd name="connsiteX97" fmla="*/ 858370 w 1378659"/>
                            <a:gd name="connsiteY97" fmla="*/ 222239 h 476250"/>
                            <a:gd name="connsiteX98" fmla="*/ 839574 w 1378659"/>
                            <a:gd name="connsiteY98" fmla="*/ 209540 h 476250"/>
                            <a:gd name="connsiteX99" fmla="*/ 820777 w 1378659"/>
                            <a:gd name="connsiteY99" fmla="*/ 203190 h 476250"/>
                            <a:gd name="connsiteX100" fmla="*/ 811379 w 1378659"/>
                            <a:gd name="connsiteY100" fmla="*/ 200015 h 476250"/>
                            <a:gd name="connsiteX101" fmla="*/ 786317 w 1378659"/>
                            <a:gd name="connsiteY101" fmla="*/ 190491 h 476250"/>
                            <a:gd name="connsiteX102" fmla="*/ 767521 w 1378659"/>
                            <a:gd name="connsiteY102" fmla="*/ 177791 h 476250"/>
                            <a:gd name="connsiteX103" fmla="*/ 758122 w 1378659"/>
                            <a:gd name="connsiteY103" fmla="*/ 171442 h 476250"/>
                            <a:gd name="connsiteX104" fmla="*/ 733061 w 1378659"/>
                            <a:gd name="connsiteY104" fmla="*/ 165092 h 476250"/>
                            <a:gd name="connsiteX105" fmla="*/ 698600 w 1378659"/>
                            <a:gd name="connsiteY105" fmla="*/ 158742 h 476250"/>
                            <a:gd name="connsiteX106" fmla="*/ 651609 w 1378659"/>
                            <a:gd name="connsiteY106" fmla="*/ 161917 h 476250"/>
                            <a:gd name="connsiteX107" fmla="*/ 639078 w 1378659"/>
                            <a:gd name="connsiteY107" fmla="*/ 168267 h 476250"/>
                            <a:gd name="connsiteX108" fmla="*/ 629680 w 1378659"/>
                            <a:gd name="connsiteY108" fmla="*/ 171442 h 476250"/>
                            <a:gd name="connsiteX109" fmla="*/ 620282 w 1378659"/>
                            <a:gd name="connsiteY109" fmla="*/ 180966 h 476250"/>
                            <a:gd name="connsiteX110" fmla="*/ 610884 w 1378659"/>
                            <a:gd name="connsiteY110" fmla="*/ 187316 h 476250"/>
                            <a:gd name="connsiteX111" fmla="*/ 604618 w 1378659"/>
                            <a:gd name="connsiteY111" fmla="*/ 196840 h 476250"/>
                            <a:gd name="connsiteX112" fmla="*/ 595220 w 1378659"/>
                            <a:gd name="connsiteY112" fmla="*/ 209540 h 476250"/>
                            <a:gd name="connsiteX113" fmla="*/ 585822 w 1378659"/>
                            <a:gd name="connsiteY113" fmla="*/ 215890 h 476250"/>
                            <a:gd name="connsiteX114" fmla="*/ 570158 w 1378659"/>
                            <a:gd name="connsiteY114" fmla="*/ 231764 h 476250"/>
                            <a:gd name="connsiteX115" fmla="*/ 541963 w 1378659"/>
                            <a:gd name="connsiteY115" fmla="*/ 253988 h 476250"/>
                            <a:gd name="connsiteX116" fmla="*/ 523167 w 1378659"/>
                            <a:gd name="connsiteY116" fmla="*/ 260337 h 476250"/>
                            <a:gd name="connsiteX117" fmla="*/ 466778 w 1378659"/>
                            <a:gd name="connsiteY117" fmla="*/ 266687 h 476250"/>
                            <a:gd name="connsiteX118" fmla="*/ 457379 w 1378659"/>
                            <a:gd name="connsiteY118" fmla="*/ 269862 h 476250"/>
                            <a:gd name="connsiteX119" fmla="*/ 407256 w 1378659"/>
                            <a:gd name="connsiteY119" fmla="*/ 263512 h 476250"/>
                            <a:gd name="connsiteX120" fmla="*/ 247486 w 1378659"/>
                            <a:gd name="connsiteY120" fmla="*/ 266687 h 476250"/>
                            <a:gd name="connsiteX121" fmla="*/ 216159 w 1378659"/>
                            <a:gd name="connsiteY121" fmla="*/ 273037 h 476250"/>
                            <a:gd name="connsiteX122" fmla="*/ 194229 w 1378659"/>
                            <a:gd name="connsiteY122" fmla="*/ 288911 h 476250"/>
                            <a:gd name="connsiteX123" fmla="*/ 181698 w 1378659"/>
                            <a:gd name="connsiteY123" fmla="*/ 295261 h 476250"/>
                            <a:gd name="connsiteX124" fmla="*/ 172300 w 1378659"/>
                            <a:gd name="connsiteY124" fmla="*/ 301611 h 476250"/>
                            <a:gd name="connsiteX125" fmla="*/ 150371 w 1378659"/>
                            <a:gd name="connsiteY125" fmla="*/ 311135 h 476250"/>
                            <a:gd name="connsiteX126" fmla="*/ 122176 w 1378659"/>
                            <a:gd name="connsiteY126" fmla="*/ 320660 h 476250"/>
                            <a:gd name="connsiteX127" fmla="*/ 112778 w 1378659"/>
                            <a:gd name="connsiteY127" fmla="*/ 327009 h 476250"/>
                            <a:gd name="connsiteX128" fmla="*/ 78318 w 1378659"/>
                            <a:gd name="connsiteY128" fmla="*/ 336534 h 476250"/>
                            <a:gd name="connsiteX129" fmla="*/ 65787 w 1378659"/>
                            <a:gd name="connsiteY129" fmla="*/ 342884 h 476250"/>
                            <a:gd name="connsiteX130" fmla="*/ 46991 w 1378659"/>
                            <a:gd name="connsiteY130" fmla="*/ 349233 h 476250"/>
                            <a:gd name="connsiteX131" fmla="*/ 37592 w 1378659"/>
                            <a:gd name="connsiteY131" fmla="*/ 355583 h 476250"/>
                            <a:gd name="connsiteX132" fmla="*/ 9398 w 1378659"/>
                            <a:gd name="connsiteY132" fmla="*/ 365108 h 476250"/>
                            <a:gd name="connsiteX133" fmla="*/ 0 w 1378659"/>
                            <a:gd name="connsiteY133" fmla="*/ 368282 h 476250"/>
                            <a:gd name="connsiteX134" fmla="*/ 9398 w 1378659"/>
                            <a:gd name="connsiteY134" fmla="*/ 403206 h 476250"/>
                            <a:gd name="connsiteX135" fmla="*/ 12530 w 1378659"/>
                            <a:gd name="connsiteY135" fmla="*/ 450829 h 476250"/>
                            <a:gd name="connsiteX136" fmla="*/ 28194 w 1378659"/>
                            <a:gd name="connsiteY136" fmla="*/ 476228 h 476250"/>
                            <a:gd name="connsiteX137" fmla="*/ 28194 w 1378659"/>
                            <a:gd name="connsiteY137" fmla="*/ 466703 h 476250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  <a:cxn ang="0">
                              <a:pos x="connsiteX5" y="connsiteY5"/>
                            </a:cxn>
                            <a:cxn ang="0">
                              <a:pos x="connsiteX6" y="connsiteY6"/>
                            </a:cxn>
                            <a:cxn ang="0">
                              <a:pos x="connsiteX7" y="connsiteY7"/>
                            </a:cxn>
                            <a:cxn ang="0">
                              <a:pos x="connsiteX8" y="connsiteY8"/>
                            </a:cxn>
                            <a:cxn ang="0">
                              <a:pos x="connsiteX9" y="connsiteY9"/>
                            </a:cxn>
                            <a:cxn ang="0">
                              <a:pos x="connsiteX10" y="connsiteY10"/>
                            </a:cxn>
                            <a:cxn ang="0">
                              <a:pos x="connsiteX11" y="connsiteY11"/>
                            </a:cxn>
                            <a:cxn ang="0">
                              <a:pos x="connsiteX12" y="connsiteY12"/>
                            </a:cxn>
                            <a:cxn ang="0">
                              <a:pos x="connsiteX13" y="connsiteY13"/>
                            </a:cxn>
                            <a:cxn ang="0">
                              <a:pos x="connsiteX14" y="connsiteY14"/>
                            </a:cxn>
                            <a:cxn ang="0">
                              <a:pos x="connsiteX15" y="connsiteY15"/>
                            </a:cxn>
                            <a:cxn ang="0">
                              <a:pos x="connsiteX16" y="connsiteY16"/>
                            </a:cxn>
                            <a:cxn ang="0">
                              <a:pos x="connsiteX17" y="connsiteY17"/>
                            </a:cxn>
                            <a:cxn ang="0">
                              <a:pos x="connsiteX18" y="connsiteY18"/>
                            </a:cxn>
                            <a:cxn ang="0">
                              <a:pos x="connsiteX19" y="connsiteY19"/>
                            </a:cxn>
                            <a:cxn ang="0">
                              <a:pos x="connsiteX20" y="connsiteY20"/>
                            </a:cxn>
                            <a:cxn ang="0">
                              <a:pos x="connsiteX21" y="connsiteY21"/>
                            </a:cxn>
                            <a:cxn ang="0">
                              <a:pos x="connsiteX22" y="connsiteY22"/>
                            </a:cxn>
                            <a:cxn ang="0">
                              <a:pos x="connsiteX23" y="connsiteY23"/>
                            </a:cxn>
                            <a:cxn ang="0">
                              <a:pos x="connsiteX24" y="connsiteY24"/>
                            </a:cxn>
                            <a:cxn ang="0">
                              <a:pos x="connsiteX25" y="connsiteY25"/>
                            </a:cxn>
                            <a:cxn ang="0">
                              <a:pos x="connsiteX26" y="connsiteY26"/>
                            </a:cxn>
                            <a:cxn ang="0">
                              <a:pos x="connsiteX27" y="connsiteY27"/>
                            </a:cxn>
                            <a:cxn ang="0">
                              <a:pos x="connsiteX28" y="connsiteY28"/>
                            </a:cxn>
                            <a:cxn ang="0">
                              <a:pos x="connsiteX29" y="connsiteY29"/>
                            </a:cxn>
                            <a:cxn ang="0">
                              <a:pos x="connsiteX30" y="connsiteY30"/>
                            </a:cxn>
                            <a:cxn ang="0">
                              <a:pos x="connsiteX31" y="connsiteY31"/>
                            </a:cxn>
                            <a:cxn ang="0">
                              <a:pos x="connsiteX32" y="connsiteY32"/>
                            </a:cxn>
                            <a:cxn ang="0">
                              <a:pos x="connsiteX33" y="connsiteY33"/>
                            </a:cxn>
                            <a:cxn ang="0">
                              <a:pos x="connsiteX34" y="connsiteY34"/>
                            </a:cxn>
                            <a:cxn ang="0">
                              <a:pos x="connsiteX35" y="connsiteY35"/>
                            </a:cxn>
                            <a:cxn ang="0">
                              <a:pos x="connsiteX36" y="connsiteY36"/>
                            </a:cxn>
                            <a:cxn ang="0">
                              <a:pos x="connsiteX37" y="connsiteY37"/>
                            </a:cxn>
                            <a:cxn ang="0">
                              <a:pos x="connsiteX38" y="connsiteY38"/>
                            </a:cxn>
                            <a:cxn ang="0">
                              <a:pos x="connsiteX39" y="connsiteY39"/>
                            </a:cxn>
                            <a:cxn ang="0">
                              <a:pos x="connsiteX40" y="connsiteY40"/>
                            </a:cxn>
                            <a:cxn ang="0">
                              <a:pos x="connsiteX41" y="connsiteY41"/>
                            </a:cxn>
                            <a:cxn ang="0">
                              <a:pos x="connsiteX42" y="connsiteY42"/>
                            </a:cxn>
                            <a:cxn ang="0">
                              <a:pos x="connsiteX43" y="connsiteY43"/>
                            </a:cxn>
                            <a:cxn ang="0">
                              <a:pos x="connsiteX44" y="connsiteY44"/>
                            </a:cxn>
                            <a:cxn ang="0">
                              <a:pos x="connsiteX45" y="connsiteY45"/>
                            </a:cxn>
                            <a:cxn ang="0">
                              <a:pos x="connsiteX46" y="connsiteY46"/>
                            </a:cxn>
                            <a:cxn ang="0">
                              <a:pos x="connsiteX47" y="connsiteY47"/>
                            </a:cxn>
                            <a:cxn ang="0">
                              <a:pos x="connsiteX48" y="connsiteY48"/>
                            </a:cxn>
                            <a:cxn ang="0">
                              <a:pos x="connsiteX49" y="connsiteY49"/>
                            </a:cxn>
                            <a:cxn ang="0">
                              <a:pos x="connsiteX50" y="connsiteY50"/>
                            </a:cxn>
                            <a:cxn ang="0">
                              <a:pos x="connsiteX51" y="connsiteY51"/>
                            </a:cxn>
                            <a:cxn ang="0">
                              <a:pos x="connsiteX52" y="connsiteY52"/>
                            </a:cxn>
                            <a:cxn ang="0">
                              <a:pos x="connsiteX53" y="connsiteY53"/>
                            </a:cxn>
                            <a:cxn ang="0">
                              <a:pos x="connsiteX54" y="connsiteY54"/>
                            </a:cxn>
                            <a:cxn ang="0">
                              <a:pos x="connsiteX55" y="connsiteY55"/>
                            </a:cxn>
                            <a:cxn ang="0">
                              <a:pos x="connsiteX56" y="connsiteY56"/>
                            </a:cxn>
                            <a:cxn ang="0">
                              <a:pos x="connsiteX57" y="connsiteY57"/>
                            </a:cxn>
                            <a:cxn ang="0">
                              <a:pos x="connsiteX58" y="connsiteY58"/>
                            </a:cxn>
                            <a:cxn ang="0">
                              <a:pos x="connsiteX59" y="connsiteY59"/>
                            </a:cxn>
                            <a:cxn ang="0">
                              <a:pos x="connsiteX60" y="connsiteY60"/>
                            </a:cxn>
                            <a:cxn ang="0">
                              <a:pos x="connsiteX61" y="connsiteY61"/>
                            </a:cxn>
                            <a:cxn ang="0">
                              <a:pos x="connsiteX62" y="connsiteY62"/>
                            </a:cxn>
                            <a:cxn ang="0">
                              <a:pos x="connsiteX63" y="connsiteY63"/>
                            </a:cxn>
                            <a:cxn ang="0">
                              <a:pos x="connsiteX64" y="connsiteY64"/>
                            </a:cxn>
                            <a:cxn ang="0">
                              <a:pos x="connsiteX65" y="connsiteY65"/>
                            </a:cxn>
                            <a:cxn ang="0">
                              <a:pos x="connsiteX66" y="connsiteY66"/>
                            </a:cxn>
                            <a:cxn ang="0">
                              <a:pos x="connsiteX67" y="connsiteY67"/>
                            </a:cxn>
                            <a:cxn ang="0">
                              <a:pos x="connsiteX68" y="connsiteY68"/>
                            </a:cxn>
                            <a:cxn ang="0">
                              <a:pos x="connsiteX69" y="connsiteY69"/>
                            </a:cxn>
                            <a:cxn ang="0">
                              <a:pos x="connsiteX70" y="connsiteY70"/>
                            </a:cxn>
                            <a:cxn ang="0">
                              <a:pos x="connsiteX71" y="connsiteY71"/>
                            </a:cxn>
                            <a:cxn ang="0">
                              <a:pos x="connsiteX72" y="connsiteY72"/>
                            </a:cxn>
                            <a:cxn ang="0">
                              <a:pos x="connsiteX73" y="connsiteY73"/>
                            </a:cxn>
                            <a:cxn ang="0">
                              <a:pos x="connsiteX74" y="connsiteY74"/>
                            </a:cxn>
                            <a:cxn ang="0">
                              <a:pos x="connsiteX75" y="connsiteY75"/>
                            </a:cxn>
                            <a:cxn ang="0">
                              <a:pos x="connsiteX76" y="connsiteY76"/>
                            </a:cxn>
                            <a:cxn ang="0">
                              <a:pos x="connsiteX77" y="connsiteY77"/>
                            </a:cxn>
                            <a:cxn ang="0">
                              <a:pos x="connsiteX78" y="connsiteY78"/>
                            </a:cxn>
                            <a:cxn ang="0">
                              <a:pos x="connsiteX79" y="connsiteY79"/>
                            </a:cxn>
                            <a:cxn ang="0">
                              <a:pos x="connsiteX80" y="connsiteY80"/>
                            </a:cxn>
                            <a:cxn ang="0">
                              <a:pos x="connsiteX81" y="connsiteY81"/>
                            </a:cxn>
                            <a:cxn ang="0">
                              <a:pos x="connsiteX82" y="connsiteY82"/>
                            </a:cxn>
                            <a:cxn ang="0">
                              <a:pos x="connsiteX83" y="connsiteY83"/>
                            </a:cxn>
                            <a:cxn ang="0">
                              <a:pos x="connsiteX84" y="connsiteY84"/>
                            </a:cxn>
                            <a:cxn ang="0">
                              <a:pos x="connsiteX85" y="connsiteY85"/>
                            </a:cxn>
                            <a:cxn ang="0">
                              <a:pos x="connsiteX86" y="connsiteY86"/>
                            </a:cxn>
                            <a:cxn ang="0">
                              <a:pos x="connsiteX87" y="connsiteY87"/>
                            </a:cxn>
                            <a:cxn ang="0">
                              <a:pos x="connsiteX88" y="connsiteY88"/>
                            </a:cxn>
                            <a:cxn ang="0">
                              <a:pos x="connsiteX89" y="connsiteY89"/>
                            </a:cxn>
                            <a:cxn ang="0">
                              <a:pos x="connsiteX90" y="connsiteY90"/>
                            </a:cxn>
                            <a:cxn ang="0">
                              <a:pos x="connsiteX91" y="connsiteY91"/>
                            </a:cxn>
                            <a:cxn ang="0">
                              <a:pos x="connsiteX92" y="connsiteY92"/>
                            </a:cxn>
                            <a:cxn ang="0">
                              <a:pos x="connsiteX93" y="connsiteY93"/>
                            </a:cxn>
                            <a:cxn ang="0">
                              <a:pos x="connsiteX94" y="connsiteY94"/>
                            </a:cxn>
                            <a:cxn ang="0">
                              <a:pos x="connsiteX95" y="connsiteY95"/>
                            </a:cxn>
                            <a:cxn ang="0">
                              <a:pos x="connsiteX96" y="connsiteY96"/>
                            </a:cxn>
                            <a:cxn ang="0">
                              <a:pos x="connsiteX97" y="connsiteY97"/>
                            </a:cxn>
                            <a:cxn ang="0">
                              <a:pos x="connsiteX98" y="connsiteY98"/>
                            </a:cxn>
                            <a:cxn ang="0">
                              <a:pos x="connsiteX99" y="connsiteY99"/>
                            </a:cxn>
                            <a:cxn ang="0">
                              <a:pos x="connsiteX100" y="connsiteY100"/>
                            </a:cxn>
                            <a:cxn ang="0">
                              <a:pos x="connsiteX101" y="connsiteY101"/>
                            </a:cxn>
                            <a:cxn ang="0">
                              <a:pos x="connsiteX102" y="connsiteY102"/>
                            </a:cxn>
                            <a:cxn ang="0">
                              <a:pos x="connsiteX103" y="connsiteY103"/>
                            </a:cxn>
                            <a:cxn ang="0">
                              <a:pos x="connsiteX104" y="connsiteY104"/>
                            </a:cxn>
                            <a:cxn ang="0">
                              <a:pos x="connsiteX105" y="connsiteY105"/>
                            </a:cxn>
                            <a:cxn ang="0">
                              <a:pos x="connsiteX106" y="connsiteY106"/>
                            </a:cxn>
                            <a:cxn ang="0">
                              <a:pos x="connsiteX107" y="connsiteY107"/>
                            </a:cxn>
                            <a:cxn ang="0">
                              <a:pos x="connsiteX108" y="connsiteY108"/>
                            </a:cxn>
                            <a:cxn ang="0">
                              <a:pos x="connsiteX109" y="connsiteY109"/>
                            </a:cxn>
                            <a:cxn ang="0">
                              <a:pos x="connsiteX110" y="connsiteY110"/>
                            </a:cxn>
                            <a:cxn ang="0">
                              <a:pos x="connsiteX111" y="connsiteY111"/>
                            </a:cxn>
                            <a:cxn ang="0">
                              <a:pos x="connsiteX112" y="connsiteY112"/>
                            </a:cxn>
                            <a:cxn ang="0">
                              <a:pos x="connsiteX113" y="connsiteY113"/>
                            </a:cxn>
                            <a:cxn ang="0">
                              <a:pos x="connsiteX114" y="connsiteY114"/>
                            </a:cxn>
                            <a:cxn ang="0">
                              <a:pos x="connsiteX115" y="connsiteY115"/>
                            </a:cxn>
                            <a:cxn ang="0">
                              <a:pos x="connsiteX116" y="connsiteY116"/>
                            </a:cxn>
                            <a:cxn ang="0">
                              <a:pos x="connsiteX117" y="connsiteY117"/>
                            </a:cxn>
                            <a:cxn ang="0">
                              <a:pos x="connsiteX118" y="connsiteY118"/>
                            </a:cxn>
                            <a:cxn ang="0">
                              <a:pos x="connsiteX119" y="connsiteY119"/>
                            </a:cxn>
                            <a:cxn ang="0">
                              <a:pos x="connsiteX120" y="connsiteY120"/>
                            </a:cxn>
                            <a:cxn ang="0">
                              <a:pos x="connsiteX121" y="connsiteY121"/>
                            </a:cxn>
                            <a:cxn ang="0">
                              <a:pos x="connsiteX122" y="connsiteY122"/>
                            </a:cxn>
                            <a:cxn ang="0">
                              <a:pos x="connsiteX123" y="connsiteY123"/>
                            </a:cxn>
                            <a:cxn ang="0">
                              <a:pos x="connsiteX124" y="connsiteY124"/>
                            </a:cxn>
                            <a:cxn ang="0">
                              <a:pos x="connsiteX125" y="connsiteY125"/>
                            </a:cxn>
                            <a:cxn ang="0">
                              <a:pos x="connsiteX126" y="connsiteY126"/>
                            </a:cxn>
                            <a:cxn ang="0">
                              <a:pos x="connsiteX127" y="connsiteY127"/>
                            </a:cxn>
                            <a:cxn ang="0">
                              <a:pos x="connsiteX128" y="connsiteY128"/>
                            </a:cxn>
                            <a:cxn ang="0">
                              <a:pos x="connsiteX129" y="connsiteY129"/>
                            </a:cxn>
                            <a:cxn ang="0">
                              <a:pos x="connsiteX130" y="connsiteY130"/>
                            </a:cxn>
                            <a:cxn ang="0">
                              <a:pos x="connsiteX131" y="connsiteY131"/>
                            </a:cxn>
                            <a:cxn ang="0">
                              <a:pos x="connsiteX132" y="connsiteY132"/>
                            </a:cxn>
                            <a:cxn ang="0">
                              <a:pos x="connsiteX133" y="connsiteY133"/>
                            </a:cxn>
                            <a:cxn ang="0">
                              <a:pos x="connsiteX134" y="connsiteY134"/>
                            </a:cxn>
                            <a:cxn ang="0">
                              <a:pos x="connsiteX135" y="connsiteY135"/>
                            </a:cxn>
                            <a:cxn ang="0">
                              <a:pos x="connsiteX136" y="connsiteY136"/>
                            </a:cxn>
                            <a:cxn ang="0">
                              <a:pos x="connsiteX137" y="connsiteY137"/>
                            </a:cxn>
                          </a:cxnLst>
                          <a:rect l="l" t="t" r="r" b="b"/>
                          <a:pathLst>
                            <a:path w="1378659" h="476250" extrusionOk="0">
                              <a:moveTo>
                                <a:pt x="28194" y="466703"/>
                              </a:moveTo>
                              <a:cubicBezTo>
                                <a:pt x="33944" y="462888"/>
                                <a:pt x="42254" y="466219"/>
                                <a:pt x="68920" y="457178"/>
                              </a:cubicBezTo>
                              <a:cubicBezTo>
                                <a:pt x="72448" y="456203"/>
                                <a:pt x="74789" y="455884"/>
                                <a:pt x="78318" y="454004"/>
                              </a:cubicBezTo>
                              <a:cubicBezTo>
                                <a:pt x="81092" y="452238"/>
                                <a:pt x="84119" y="449281"/>
                                <a:pt x="87716" y="447654"/>
                              </a:cubicBezTo>
                              <a:cubicBezTo>
                                <a:pt x="94059" y="443715"/>
                                <a:pt x="105291" y="443220"/>
                                <a:pt x="112778" y="441304"/>
                              </a:cubicBezTo>
                              <a:cubicBezTo>
                                <a:pt x="141833" y="437252"/>
                                <a:pt x="125679" y="438231"/>
                                <a:pt x="153504" y="434954"/>
                              </a:cubicBezTo>
                              <a:cubicBezTo>
                                <a:pt x="158672" y="432670"/>
                                <a:pt x="166264" y="432828"/>
                                <a:pt x="172300" y="428605"/>
                              </a:cubicBezTo>
                              <a:cubicBezTo>
                                <a:pt x="175422" y="426385"/>
                                <a:pt x="178144" y="423964"/>
                                <a:pt x="181698" y="422255"/>
                              </a:cubicBezTo>
                              <a:cubicBezTo>
                                <a:pt x="200556" y="414524"/>
                                <a:pt x="206334" y="416448"/>
                                <a:pt x="225557" y="409556"/>
                              </a:cubicBezTo>
                              <a:cubicBezTo>
                                <a:pt x="267398" y="394009"/>
                                <a:pt x="227290" y="412529"/>
                                <a:pt x="256884" y="400031"/>
                              </a:cubicBezTo>
                              <a:cubicBezTo>
                                <a:pt x="260172" y="399280"/>
                                <a:pt x="263097" y="397855"/>
                                <a:pt x="266282" y="396856"/>
                              </a:cubicBezTo>
                              <a:cubicBezTo>
                                <a:pt x="284269" y="392480"/>
                                <a:pt x="278941" y="396061"/>
                                <a:pt x="294477" y="390506"/>
                              </a:cubicBezTo>
                              <a:cubicBezTo>
                                <a:pt x="301886" y="387636"/>
                                <a:pt x="307205" y="385345"/>
                                <a:pt x="313273" y="384157"/>
                              </a:cubicBezTo>
                              <a:cubicBezTo>
                                <a:pt x="316140" y="383050"/>
                                <a:pt x="319487" y="382049"/>
                                <a:pt x="322672" y="380982"/>
                              </a:cubicBezTo>
                              <a:cubicBezTo>
                                <a:pt x="325374" y="379282"/>
                                <a:pt x="329212" y="380076"/>
                                <a:pt x="332070" y="377807"/>
                              </a:cubicBezTo>
                              <a:cubicBezTo>
                                <a:pt x="338165" y="373062"/>
                                <a:pt x="344413" y="367381"/>
                                <a:pt x="350866" y="365108"/>
                              </a:cubicBezTo>
                              <a:cubicBezTo>
                                <a:pt x="387658" y="355284"/>
                                <a:pt x="323991" y="371107"/>
                                <a:pt x="372796" y="358758"/>
                              </a:cubicBezTo>
                              <a:cubicBezTo>
                                <a:pt x="379718" y="355759"/>
                                <a:pt x="384898" y="353435"/>
                                <a:pt x="391592" y="352408"/>
                              </a:cubicBezTo>
                              <a:cubicBezTo>
                                <a:pt x="400015" y="351114"/>
                                <a:pt x="406355" y="351584"/>
                                <a:pt x="413521" y="349233"/>
                              </a:cubicBezTo>
                              <a:cubicBezTo>
                                <a:pt x="419719" y="348028"/>
                                <a:pt x="423854" y="345975"/>
                                <a:pt x="429185" y="346059"/>
                              </a:cubicBezTo>
                              <a:cubicBezTo>
                                <a:pt x="488048" y="344422"/>
                                <a:pt x="540756" y="348050"/>
                                <a:pt x="601486" y="342884"/>
                              </a:cubicBezTo>
                              <a:cubicBezTo>
                                <a:pt x="645957" y="333210"/>
                                <a:pt x="604002" y="347858"/>
                                <a:pt x="632813" y="336534"/>
                              </a:cubicBezTo>
                              <a:cubicBezTo>
                                <a:pt x="641888" y="336549"/>
                                <a:pt x="667054" y="331440"/>
                                <a:pt x="676671" y="327009"/>
                              </a:cubicBezTo>
                              <a:cubicBezTo>
                                <a:pt x="683126" y="325521"/>
                                <a:pt x="690410" y="322422"/>
                                <a:pt x="695468" y="320660"/>
                              </a:cubicBezTo>
                              <a:cubicBezTo>
                                <a:pt x="698717" y="319232"/>
                                <a:pt x="702607" y="317992"/>
                                <a:pt x="704866" y="317485"/>
                              </a:cubicBezTo>
                              <a:cubicBezTo>
                                <a:pt x="707769" y="315704"/>
                                <a:pt x="711611" y="316094"/>
                                <a:pt x="714264" y="314310"/>
                              </a:cubicBezTo>
                              <a:cubicBezTo>
                                <a:pt x="717464" y="312077"/>
                                <a:pt x="719880" y="309379"/>
                                <a:pt x="723662" y="307960"/>
                              </a:cubicBezTo>
                              <a:cubicBezTo>
                                <a:pt x="729698" y="305242"/>
                                <a:pt x="742459" y="301611"/>
                                <a:pt x="742459" y="301611"/>
                              </a:cubicBezTo>
                              <a:cubicBezTo>
                                <a:pt x="755716" y="304637"/>
                                <a:pt x="769547" y="302712"/>
                                <a:pt x="780052" y="304785"/>
                              </a:cubicBezTo>
                              <a:cubicBezTo>
                                <a:pt x="783122" y="305985"/>
                                <a:pt x="787316" y="305996"/>
                                <a:pt x="789450" y="307960"/>
                              </a:cubicBezTo>
                              <a:cubicBezTo>
                                <a:pt x="804846" y="316589"/>
                                <a:pt x="787624" y="314426"/>
                                <a:pt x="805114" y="323835"/>
                              </a:cubicBezTo>
                              <a:cubicBezTo>
                                <a:pt x="811408" y="326820"/>
                                <a:pt x="818229" y="328626"/>
                                <a:pt x="823910" y="330184"/>
                              </a:cubicBezTo>
                              <a:cubicBezTo>
                                <a:pt x="827284" y="331830"/>
                                <a:pt x="830334" y="332774"/>
                                <a:pt x="833308" y="333359"/>
                              </a:cubicBezTo>
                              <a:cubicBezTo>
                                <a:pt x="836912" y="333826"/>
                                <a:pt x="849964" y="338205"/>
                                <a:pt x="855237" y="339709"/>
                              </a:cubicBezTo>
                              <a:cubicBezTo>
                                <a:pt x="873964" y="349079"/>
                                <a:pt x="858837" y="340523"/>
                                <a:pt x="874034" y="349233"/>
                              </a:cubicBezTo>
                              <a:cubicBezTo>
                                <a:pt x="877892" y="349928"/>
                                <a:pt x="881856" y="351473"/>
                                <a:pt x="886565" y="352408"/>
                              </a:cubicBezTo>
                              <a:cubicBezTo>
                                <a:pt x="889789" y="354062"/>
                                <a:pt x="892173" y="354423"/>
                                <a:pt x="895963" y="355583"/>
                              </a:cubicBezTo>
                              <a:cubicBezTo>
                                <a:pt x="924987" y="357547"/>
                                <a:pt x="969803" y="362027"/>
                                <a:pt x="989945" y="361933"/>
                              </a:cubicBezTo>
                              <a:cubicBezTo>
                                <a:pt x="1012601" y="361358"/>
                                <a:pt x="1029025" y="360821"/>
                                <a:pt x="1049467" y="358758"/>
                              </a:cubicBezTo>
                              <a:cubicBezTo>
                                <a:pt x="1052751" y="358284"/>
                                <a:pt x="1055669" y="356036"/>
                                <a:pt x="1058865" y="355583"/>
                              </a:cubicBezTo>
                              <a:cubicBezTo>
                                <a:pt x="1065409" y="353171"/>
                                <a:pt x="1070741" y="353861"/>
                                <a:pt x="1077662" y="352408"/>
                              </a:cubicBezTo>
                              <a:cubicBezTo>
                                <a:pt x="1081098" y="351350"/>
                                <a:pt x="1084202" y="349902"/>
                                <a:pt x="1087060" y="349233"/>
                              </a:cubicBezTo>
                              <a:cubicBezTo>
                                <a:pt x="1092097" y="347964"/>
                                <a:pt x="1095498" y="347194"/>
                                <a:pt x="1099591" y="346059"/>
                              </a:cubicBezTo>
                              <a:cubicBezTo>
                                <a:pt x="1105917" y="344136"/>
                                <a:pt x="1118388" y="339710"/>
                                <a:pt x="1118388" y="339709"/>
                              </a:cubicBezTo>
                              <a:cubicBezTo>
                                <a:pt x="1118969" y="336039"/>
                                <a:pt x="1120219" y="333383"/>
                                <a:pt x="1121520" y="330184"/>
                              </a:cubicBezTo>
                              <a:cubicBezTo>
                                <a:pt x="1123854" y="324776"/>
                                <a:pt x="1128806" y="319538"/>
                                <a:pt x="1134051" y="314310"/>
                              </a:cubicBezTo>
                              <a:cubicBezTo>
                                <a:pt x="1142009" y="302733"/>
                                <a:pt x="1151166" y="299391"/>
                                <a:pt x="1159113" y="288911"/>
                              </a:cubicBezTo>
                              <a:cubicBezTo>
                                <a:pt x="1164499" y="282194"/>
                                <a:pt x="1166232" y="278316"/>
                                <a:pt x="1171644" y="269862"/>
                              </a:cubicBezTo>
                              <a:cubicBezTo>
                                <a:pt x="1174514" y="266467"/>
                                <a:pt x="1175386" y="262490"/>
                                <a:pt x="1177910" y="260337"/>
                              </a:cubicBezTo>
                              <a:cubicBezTo>
                                <a:pt x="1181946" y="256079"/>
                                <a:pt x="1182687" y="255334"/>
                                <a:pt x="1187308" y="250813"/>
                              </a:cubicBezTo>
                              <a:cubicBezTo>
                                <a:pt x="1188967" y="245088"/>
                                <a:pt x="1189549" y="238234"/>
                                <a:pt x="1193573" y="231764"/>
                              </a:cubicBezTo>
                              <a:cubicBezTo>
                                <a:pt x="1224119" y="183888"/>
                                <a:pt x="1191558" y="234662"/>
                                <a:pt x="1215502" y="203190"/>
                              </a:cubicBezTo>
                              <a:cubicBezTo>
                                <a:pt x="1217536" y="200194"/>
                                <a:pt x="1218908" y="195505"/>
                                <a:pt x="1221768" y="193666"/>
                              </a:cubicBezTo>
                              <a:cubicBezTo>
                                <a:pt x="1228188" y="187196"/>
                                <a:pt x="1236389" y="185166"/>
                                <a:pt x="1240564" y="180966"/>
                              </a:cubicBezTo>
                              <a:cubicBezTo>
                                <a:pt x="1256796" y="165007"/>
                                <a:pt x="1248129" y="172364"/>
                                <a:pt x="1268759" y="158742"/>
                              </a:cubicBezTo>
                              <a:cubicBezTo>
                                <a:pt x="1272055" y="157548"/>
                                <a:pt x="1274911" y="153985"/>
                                <a:pt x="1278157" y="152392"/>
                              </a:cubicBezTo>
                              <a:cubicBezTo>
                                <a:pt x="1283439" y="150344"/>
                                <a:pt x="1286358" y="147440"/>
                                <a:pt x="1290688" y="146043"/>
                              </a:cubicBezTo>
                              <a:cubicBezTo>
                                <a:pt x="1293052" y="144799"/>
                                <a:pt x="1297635" y="145025"/>
                                <a:pt x="1300086" y="142868"/>
                              </a:cubicBezTo>
                              <a:cubicBezTo>
                                <a:pt x="1306022" y="140739"/>
                                <a:pt x="1313458" y="131977"/>
                                <a:pt x="1318883" y="130168"/>
                              </a:cubicBezTo>
                              <a:cubicBezTo>
                                <a:pt x="1322274" y="128493"/>
                                <a:pt x="1325569" y="128696"/>
                                <a:pt x="1328281" y="126994"/>
                              </a:cubicBezTo>
                              <a:cubicBezTo>
                                <a:pt x="1335149" y="122838"/>
                                <a:pt x="1342424" y="119466"/>
                                <a:pt x="1347078" y="114294"/>
                              </a:cubicBezTo>
                              <a:cubicBezTo>
                                <a:pt x="1351088" y="111276"/>
                                <a:pt x="1352801" y="107416"/>
                                <a:pt x="1356476" y="104770"/>
                              </a:cubicBezTo>
                              <a:cubicBezTo>
                                <a:pt x="1358981" y="102823"/>
                                <a:pt x="1363221" y="103072"/>
                                <a:pt x="1365874" y="101595"/>
                              </a:cubicBezTo>
                              <a:cubicBezTo>
                                <a:pt x="1369221" y="98975"/>
                                <a:pt x="1372644" y="96996"/>
                                <a:pt x="1375272" y="95245"/>
                              </a:cubicBezTo>
                              <a:cubicBezTo>
                                <a:pt x="1383135" y="77024"/>
                                <a:pt x="1378040" y="96654"/>
                                <a:pt x="1375272" y="76196"/>
                              </a:cubicBezTo>
                              <a:cubicBezTo>
                                <a:pt x="1374224" y="-4286"/>
                                <a:pt x="1394454" y="13143"/>
                                <a:pt x="1362741" y="0"/>
                              </a:cubicBezTo>
                              <a:cubicBezTo>
                                <a:pt x="1360352" y="970"/>
                                <a:pt x="1331193" y="-1096"/>
                                <a:pt x="1318883" y="6349"/>
                              </a:cubicBezTo>
                              <a:cubicBezTo>
                                <a:pt x="1313565" y="10500"/>
                                <a:pt x="1306612" y="13273"/>
                                <a:pt x="1300086" y="19049"/>
                              </a:cubicBezTo>
                              <a:cubicBezTo>
                                <a:pt x="1296758" y="20734"/>
                                <a:pt x="1294360" y="24944"/>
                                <a:pt x="1290688" y="25398"/>
                              </a:cubicBezTo>
                              <a:cubicBezTo>
                                <a:pt x="1282992" y="27273"/>
                                <a:pt x="1277324" y="30179"/>
                                <a:pt x="1271892" y="31748"/>
                              </a:cubicBezTo>
                              <a:cubicBezTo>
                                <a:pt x="1268327" y="32546"/>
                                <a:pt x="1265357" y="32301"/>
                                <a:pt x="1262494" y="34923"/>
                              </a:cubicBezTo>
                              <a:cubicBezTo>
                                <a:pt x="1258793" y="37175"/>
                                <a:pt x="1256842" y="40378"/>
                                <a:pt x="1253095" y="41273"/>
                              </a:cubicBezTo>
                              <a:cubicBezTo>
                                <a:pt x="1246923" y="44449"/>
                                <a:pt x="1240002" y="45545"/>
                                <a:pt x="1234299" y="47622"/>
                              </a:cubicBezTo>
                              <a:cubicBezTo>
                                <a:pt x="1229994" y="49081"/>
                                <a:pt x="1221925" y="52730"/>
                                <a:pt x="1215502" y="53972"/>
                              </a:cubicBezTo>
                              <a:cubicBezTo>
                                <a:pt x="1212267" y="54867"/>
                                <a:pt x="1208764" y="55942"/>
                                <a:pt x="1206104" y="57147"/>
                              </a:cubicBezTo>
                              <a:cubicBezTo>
                                <a:pt x="1203279" y="59519"/>
                                <a:pt x="1200272" y="61404"/>
                                <a:pt x="1196706" y="63497"/>
                              </a:cubicBezTo>
                              <a:cubicBezTo>
                                <a:pt x="1190913" y="65776"/>
                                <a:pt x="1185699" y="68080"/>
                                <a:pt x="1177910" y="69846"/>
                              </a:cubicBezTo>
                              <a:cubicBezTo>
                                <a:pt x="1174309" y="71188"/>
                                <a:pt x="1171652" y="72320"/>
                                <a:pt x="1168511" y="73021"/>
                              </a:cubicBezTo>
                              <a:cubicBezTo>
                                <a:pt x="1164776" y="74160"/>
                                <a:pt x="1160711" y="74651"/>
                                <a:pt x="1155980" y="76196"/>
                              </a:cubicBezTo>
                              <a:cubicBezTo>
                                <a:pt x="1149169" y="77410"/>
                                <a:pt x="1142327" y="79693"/>
                                <a:pt x="1137184" y="82546"/>
                              </a:cubicBezTo>
                              <a:cubicBezTo>
                                <a:pt x="1116715" y="101088"/>
                                <a:pt x="1142004" y="79274"/>
                                <a:pt x="1115255" y="95245"/>
                              </a:cubicBezTo>
                              <a:cubicBezTo>
                                <a:pt x="1112038" y="97764"/>
                                <a:pt x="1108371" y="100038"/>
                                <a:pt x="1105857" y="101595"/>
                              </a:cubicBezTo>
                              <a:cubicBezTo>
                                <a:pt x="1102817" y="103447"/>
                                <a:pt x="1098766" y="103120"/>
                                <a:pt x="1096458" y="104770"/>
                              </a:cubicBezTo>
                              <a:cubicBezTo>
                                <a:pt x="1092970" y="106545"/>
                                <a:pt x="1090686" y="108542"/>
                                <a:pt x="1087060" y="111119"/>
                              </a:cubicBezTo>
                              <a:cubicBezTo>
                                <a:pt x="1083849" y="112464"/>
                                <a:pt x="1080621" y="112984"/>
                                <a:pt x="1077662" y="114294"/>
                              </a:cubicBezTo>
                              <a:cubicBezTo>
                                <a:pt x="1071080" y="118001"/>
                                <a:pt x="1058866" y="126994"/>
                                <a:pt x="1058865" y="126994"/>
                              </a:cubicBezTo>
                              <a:cubicBezTo>
                                <a:pt x="1054533" y="135071"/>
                                <a:pt x="1049031" y="139251"/>
                                <a:pt x="1046335" y="146043"/>
                              </a:cubicBezTo>
                              <a:cubicBezTo>
                                <a:pt x="1042182" y="159019"/>
                                <a:pt x="1043869" y="153201"/>
                                <a:pt x="1036936" y="165092"/>
                              </a:cubicBezTo>
                              <a:cubicBezTo>
                                <a:pt x="1036917" y="169538"/>
                                <a:pt x="1036119" y="174217"/>
                                <a:pt x="1033804" y="177791"/>
                              </a:cubicBezTo>
                              <a:cubicBezTo>
                                <a:pt x="1032676" y="181003"/>
                                <a:pt x="1028813" y="184061"/>
                                <a:pt x="1027538" y="187316"/>
                              </a:cubicBezTo>
                              <a:cubicBezTo>
                                <a:pt x="1025769" y="197838"/>
                                <a:pt x="1032379" y="214481"/>
                                <a:pt x="1021273" y="219064"/>
                              </a:cubicBezTo>
                              <a:cubicBezTo>
                                <a:pt x="1016910" y="221977"/>
                                <a:pt x="1006113" y="228385"/>
                                <a:pt x="1002476" y="231764"/>
                              </a:cubicBezTo>
                              <a:cubicBezTo>
                                <a:pt x="998892" y="234421"/>
                                <a:pt x="996812" y="236849"/>
                                <a:pt x="993078" y="238114"/>
                              </a:cubicBezTo>
                              <a:cubicBezTo>
                                <a:pt x="985047" y="240725"/>
                                <a:pt x="978521" y="243711"/>
                                <a:pt x="974282" y="244463"/>
                              </a:cubicBezTo>
                              <a:cubicBezTo>
                                <a:pt x="950296" y="239787"/>
                                <a:pt x="926986" y="241144"/>
                                <a:pt x="905361" y="241288"/>
                              </a:cubicBezTo>
                              <a:cubicBezTo>
                                <a:pt x="895268" y="240445"/>
                                <a:pt x="895910" y="235862"/>
                                <a:pt x="886565" y="231764"/>
                              </a:cubicBezTo>
                              <a:cubicBezTo>
                                <a:pt x="880138" y="229143"/>
                                <a:pt x="872616" y="227010"/>
                                <a:pt x="867768" y="225414"/>
                              </a:cubicBezTo>
                              <a:cubicBezTo>
                                <a:pt x="864568" y="224121"/>
                                <a:pt x="861343" y="224493"/>
                                <a:pt x="858370" y="222239"/>
                              </a:cubicBezTo>
                              <a:cubicBezTo>
                                <a:pt x="851129" y="218957"/>
                                <a:pt x="846614" y="213217"/>
                                <a:pt x="839574" y="209540"/>
                              </a:cubicBezTo>
                              <a:cubicBezTo>
                                <a:pt x="835383" y="208426"/>
                                <a:pt x="828751" y="206381"/>
                                <a:pt x="820777" y="203190"/>
                              </a:cubicBezTo>
                              <a:cubicBezTo>
                                <a:pt x="817125" y="201789"/>
                                <a:pt x="814192" y="201348"/>
                                <a:pt x="811379" y="200015"/>
                              </a:cubicBezTo>
                              <a:cubicBezTo>
                                <a:pt x="796899" y="189124"/>
                                <a:pt x="804383" y="194981"/>
                                <a:pt x="786317" y="190491"/>
                              </a:cubicBezTo>
                              <a:cubicBezTo>
                                <a:pt x="777369" y="183609"/>
                                <a:pt x="775999" y="183526"/>
                                <a:pt x="767521" y="177791"/>
                              </a:cubicBezTo>
                              <a:cubicBezTo>
                                <a:pt x="764621" y="175722"/>
                                <a:pt x="761553" y="172375"/>
                                <a:pt x="758122" y="171442"/>
                              </a:cubicBezTo>
                              <a:cubicBezTo>
                                <a:pt x="748451" y="168445"/>
                                <a:pt x="742980" y="165960"/>
                                <a:pt x="733061" y="165092"/>
                              </a:cubicBezTo>
                              <a:cubicBezTo>
                                <a:pt x="708962" y="158778"/>
                                <a:pt x="722412" y="163821"/>
                                <a:pt x="698600" y="158742"/>
                              </a:cubicBezTo>
                              <a:cubicBezTo>
                                <a:pt x="684312" y="159585"/>
                                <a:pt x="666520" y="162151"/>
                                <a:pt x="651609" y="161917"/>
                              </a:cubicBezTo>
                              <a:cubicBezTo>
                                <a:pt x="646883" y="162714"/>
                                <a:pt x="643322" y="166288"/>
                                <a:pt x="639078" y="168267"/>
                              </a:cubicBezTo>
                              <a:cubicBezTo>
                                <a:pt x="636172" y="169454"/>
                                <a:pt x="632316" y="169991"/>
                                <a:pt x="629680" y="171442"/>
                              </a:cubicBezTo>
                              <a:cubicBezTo>
                                <a:pt x="627291" y="174492"/>
                                <a:pt x="624236" y="177410"/>
                                <a:pt x="620282" y="180966"/>
                              </a:cubicBezTo>
                              <a:cubicBezTo>
                                <a:pt x="617481" y="183107"/>
                                <a:pt x="614034" y="184067"/>
                                <a:pt x="610884" y="187316"/>
                              </a:cubicBezTo>
                              <a:cubicBezTo>
                                <a:pt x="607954" y="189920"/>
                                <a:pt x="606532" y="193493"/>
                                <a:pt x="604618" y="196840"/>
                              </a:cubicBezTo>
                              <a:cubicBezTo>
                                <a:pt x="601718" y="201101"/>
                                <a:pt x="599628" y="205992"/>
                                <a:pt x="595220" y="209540"/>
                              </a:cubicBezTo>
                              <a:cubicBezTo>
                                <a:pt x="592619" y="212800"/>
                                <a:pt x="589010" y="214352"/>
                                <a:pt x="585822" y="215890"/>
                              </a:cubicBezTo>
                              <a:cubicBezTo>
                                <a:pt x="577346" y="230272"/>
                                <a:pt x="584022" y="219795"/>
                                <a:pt x="570158" y="231764"/>
                              </a:cubicBezTo>
                              <a:cubicBezTo>
                                <a:pt x="558620" y="240827"/>
                                <a:pt x="559013" y="249956"/>
                                <a:pt x="541963" y="253988"/>
                              </a:cubicBezTo>
                              <a:cubicBezTo>
                                <a:pt x="536972" y="255993"/>
                                <a:pt x="529666" y="257973"/>
                                <a:pt x="523167" y="260337"/>
                              </a:cubicBezTo>
                              <a:cubicBezTo>
                                <a:pt x="484573" y="268311"/>
                                <a:pt x="510224" y="262675"/>
                                <a:pt x="466778" y="266687"/>
                              </a:cubicBezTo>
                              <a:cubicBezTo>
                                <a:pt x="463760" y="267929"/>
                                <a:pt x="460530" y="270161"/>
                                <a:pt x="457379" y="269862"/>
                              </a:cubicBezTo>
                              <a:cubicBezTo>
                                <a:pt x="440565" y="268965"/>
                                <a:pt x="407255" y="263512"/>
                                <a:pt x="407256" y="263512"/>
                              </a:cubicBezTo>
                              <a:cubicBezTo>
                                <a:pt x="333319" y="262712"/>
                                <a:pt x="281912" y="273046"/>
                                <a:pt x="247486" y="266687"/>
                              </a:cubicBezTo>
                              <a:cubicBezTo>
                                <a:pt x="241918" y="267295"/>
                                <a:pt x="225564" y="268709"/>
                                <a:pt x="216159" y="273037"/>
                              </a:cubicBezTo>
                              <a:cubicBezTo>
                                <a:pt x="210320" y="276209"/>
                                <a:pt x="200706" y="285125"/>
                                <a:pt x="194229" y="288911"/>
                              </a:cubicBezTo>
                              <a:cubicBezTo>
                                <a:pt x="189861" y="292203"/>
                                <a:pt x="185195" y="293462"/>
                                <a:pt x="181698" y="295261"/>
                              </a:cubicBezTo>
                              <a:cubicBezTo>
                                <a:pt x="178588" y="297483"/>
                                <a:pt x="175643" y="299522"/>
                                <a:pt x="172300" y="301611"/>
                              </a:cubicBezTo>
                              <a:cubicBezTo>
                                <a:pt x="157398" y="309735"/>
                                <a:pt x="163845" y="306350"/>
                                <a:pt x="150371" y="311135"/>
                              </a:cubicBezTo>
                              <a:cubicBezTo>
                                <a:pt x="127817" y="319259"/>
                                <a:pt x="142913" y="312630"/>
                                <a:pt x="122176" y="320660"/>
                              </a:cubicBezTo>
                              <a:cubicBezTo>
                                <a:pt x="118244" y="322920"/>
                                <a:pt x="116006" y="325822"/>
                                <a:pt x="112778" y="327009"/>
                              </a:cubicBezTo>
                              <a:cubicBezTo>
                                <a:pt x="103004" y="331344"/>
                                <a:pt x="90059" y="330876"/>
                                <a:pt x="78318" y="336534"/>
                              </a:cubicBezTo>
                              <a:cubicBezTo>
                                <a:pt x="74689" y="338992"/>
                                <a:pt x="70597" y="342151"/>
                                <a:pt x="65787" y="342884"/>
                              </a:cubicBezTo>
                              <a:cubicBezTo>
                                <a:pt x="58078" y="344963"/>
                                <a:pt x="51267" y="345151"/>
                                <a:pt x="46991" y="349233"/>
                              </a:cubicBezTo>
                              <a:cubicBezTo>
                                <a:pt x="43313" y="350992"/>
                                <a:pt x="41331" y="353584"/>
                                <a:pt x="37592" y="355583"/>
                              </a:cubicBezTo>
                              <a:cubicBezTo>
                                <a:pt x="26639" y="360677"/>
                                <a:pt x="18194" y="361733"/>
                                <a:pt x="9398" y="365108"/>
                              </a:cubicBezTo>
                              <a:cubicBezTo>
                                <a:pt x="6085" y="365807"/>
                                <a:pt x="3365" y="367515"/>
                                <a:pt x="0" y="368282"/>
                              </a:cubicBezTo>
                              <a:cubicBezTo>
                                <a:pt x="7745" y="392887"/>
                                <a:pt x="2438" y="382215"/>
                                <a:pt x="9398" y="403206"/>
                              </a:cubicBezTo>
                              <a:cubicBezTo>
                                <a:pt x="13107" y="419794"/>
                                <a:pt x="9833" y="435713"/>
                                <a:pt x="12530" y="450829"/>
                              </a:cubicBezTo>
                              <a:cubicBezTo>
                                <a:pt x="12718" y="462058"/>
                                <a:pt x="16221" y="473409"/>
                                <a:pt x="28194" y="476228"/>
                              </a:cubicBezTo>
                              <a:cubicBezTo>
                                <a:pt x="30835" y="475687"/>
                                <a:pt x="21746" y="468497"/>
                                <a:pt x="28194" y="466703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dirty="0"/>
                </a:p>
              </p:txBody>
            </p:sp>
          </p:grpSp>
          <p:sp>
            <p:nvSpPr>
              <p:cNvPr id="21" name="Freihandform 20">
                <a:extLst>
                  <a:ext uri="{FF2B5EF4-FFF2-40B4-BE49-F238E27FC236}">
                    <a16:creationId xmlns:a16="http://schemas.microsoft.com/office/drawing/2014/main" id="{716D099A-82DA-9FE5-9A1F-40D5BD8361A1}"/>
                  </a:ext>
                </a:extLst>
              </p:cNvPr>
              <p:cNvSpPr/>
              <p:nvPr/>
            </p:nvSpPr>
            <p:spPr>
              <a:xfrm>
                <a:off x="2549234" y="3630304"/>
                <a:ext cx="1416572" cy="863087"/>
              </a:xfrm>
              <a:custGeom>
                <a:avLst/>
                <a:gdLst>
                  <a:gd name="connsiteX0" fmla="*/ 0 w 1378580"/>
                  <a:gd name="connsiteY0" fmla="*/ 387399 h 844599"/>
                  <a:gd name="connsiteX1" fmla="*/ 0 w 1378580"/>
                  <a:gd name="connsiteY1" fmla="*/ 844599 h 844599"/>
                  <a:gd name="connsiteX2" fmla="*/ 1378580 w 1378580"/>
                  <a:gd name="connsiteY2" fmla="*/ 844599 h 844599"/>
                  <a:gd name="connsiteX3" fmla="*/ 1364620 w 1378580"/>
                  <a:gd name="connsiteY3" fmla="*/ 0 h 844599"/>
                  <a:gd name="connsiteX4" fmla="*/ 1315759 w 1378580"/>
                  <a:gd name="connsiteY4" fmla="*/ 41881 h 844599"/>
                  <a:gd name="connsiteX5" fmla="*/ 1256427 w 1378580"/>
                  <a:gd name="connsiteY5" fmla="*/ 76782 h 844599"/>
                  <a:gd name="connsiteX6" fmla="*/ 1183136 w 1378580"/>
                  <a:gd name="connsiteY6" fmla="*/ 153564 h 844599"/>
                  <a:gd name="connsiteX7" fmla="*/ 1148235 w 1378580"/>
                  <a:gd name="connsiteY7" fmla="*/ 219875 h 844599"/>
                  <a:gd name="connsiteX8" fmla="*/ 1078433 w 1378580"/>
                  <a:gd name="connsiteY8" fmla="*/ 272226 h 844599"/>
                  <a:gd name="connsiteX9" fmla="*/ 949301 w 1378580"/>
                  <a:gd name="connsiteY9" fmla="*/ 275716 h 844599"/>
                  <a:gd name="connsiteX10" fmla="*/ 841108 w 1378580"/>
                  <a:gd name="connsiteY10" fmla="*/ 272226 h 844599"/>
                  <a:gd name="connsiteX11" fmla="*/ 753856 w 1378580"/>
                  <a:gd name="connsiteY11" fmla="*/ 233835 h 844599"/>
                  <a:gd name="connsiteX12" fmla="*/ 704995 w 1378580"/>
                  <a:gd name="connsiteY12" fmla="*/ 233835 h 844599"/>
                  <a:gd name="connsiteX13" fmla="*/ 631704 w 1378580"/>
                  <a:gd name="connsiteY13" fmla="*/ 261756 h 844599"/>
                  <a:gd name="connsiteX14" fmla="*/ 520021 w 1378580"/>
                  <a:gd name="connsiteY14" fmla="*/ 261756 h 844599"/>
                  <a:gd name="connsiteX15" fmla="*/ 450220 w 1378580"/>
                  <a:gd name="connsiteY15" fmla="*/ 268736 h 844599"/>
                  <a:gd name="connsiteX16" fmla="*/ 369948 w 1378580"/>
                  <a:gd name="connsiteY16" fmla="*/ 275716 h 844599"/>
                  <a:gd name="connsiteX17" fmla="*/ 303637 w 1378580"/>
                  <a:gd name="connsiteY17" fmla="*/ 303637 h 844599"/>
                  <a:gd name="connsiteX18" fmla="*/ 209404 w 1378580"/>
                  <a:gd name="connsiteY18" fmla="*/ 335047 h 844599"/>
                  <a:gd name="connsiteX19" fmla="*/ 122153 w 1378580"/>
                  <a:gd name="connsiteY19" fmla="*/ 355988 h 844599"/>
                  <a:gd name="connsiteX20" fmla="*/ 52351 w 1378580"/>
                  <a:gd name="connsiteY20" fmla="*/ 376928 h 844599"/>
                  <a:gd name="connsiteX21" fmla="*/ 0 w 1378580"/>
                  <a:gd name="connsiteY21" fmla="*/ 387399 h 8445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378580" h="844599">
                    <a:moveTo>
                      <a:pt x="0" y="387399"/>
                    </a:moveTo>
                    <a:lnTo>
                      <a:pt x="0" y="844599"/>
                    </a:lnTo>
                    <a:lnTo>
                      <a:pt x="1378580" y="844599"/>
                    </a:lnTo>
                    <a:lnTo>
                      <a:pt x="1364620" y="0"/>
                    </a:lnTo>
                    <a:lnTo>
                      <a:pt x="1315759" y="41881"/>
                    </a:lnTo>
                    <a:lnTo>
                      <a:pt x="1256427" y="76782"/>
                    </a:lnTo>
                    <a:lnTo>
                      <a:pt x="1183136" y="153564"/>
                    </a:lnTo>
                    <a:lnTo>
                      <a:pt x="1148235" y="219875"/>
                    </a:lnTo>
                    <a:lnTo>
                      <a:pt x="1078433" y="272226"/>
                    </a:lnTo>
                    <a:lnTo>
                      <a:pt x="949301" y="275716"/>
                    </a:lnTo>
                    <a:lnTo>
                      <a:pt x="841108" y="272226"/>
                    </a:lnTo>
                    <a:lnTo>
                      <a:pt x="753856" y="233835"/>
                    </a:lnTo>
                    <a:lnTo>
                      <a:pt x="704995" y="233835"/>
                    </a:lnTo>
                    <a:lnTo>
                      <a:pt x="631704" y="261756"/>
                    </a:lnTo>
                    <a:lnTo>
                      <a:pt x="520021" y="261756"/>
                    </a:lnTo>
                    <a:lnTo>
                      <a:pt x="450220" y="268736"/>
                    </a:lnTo>
                    <a:lnTo>
                      <a:pt x="369948" y="275716"/>
                    </a:lnTo>
                    <a:lnTo>
                      <a:pt x="303637" y="303637"/>
                    </a:lnTo>
                    <a:lnTo>
                      <a:pt x="209404" y="335047"/>
                    </a:lnTo>
                    <a:lnTo>
                      <a:pt x="122153" y="355988"/>
                    </a:lnTo>
                    <a:lnTo>
                      <a:pt x="52351" y="376928"/>
                    </a:lnTo>
                    <a:lnTo>
                      <a:pt x="0" y="387399"/>
                    </a:ln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  <a:prstDash val="dash"/>
                <a:extLst>
                  <a:ext uri="{C807C97D-BFC1-408E-A445-0C87EB9F89A2}">
                    <ask:lineSketchStyleProps xmlns:ask="http://schemas.microsoft.com/office/drawing/2018/sketchyshapes" xmlns="" sd="1219033472">
                      <a:custGeom>
                        <a:avLst/>
                        <a:gdLst>
                          <a:gd name="connsiteX0" fmla="*/ 0 w 1378659"/>
                          <a:gd name="connsiteY0" fmla="*/ 363313 h 792089"/>
                          <a:gd name="connsiteX1" fmla="*/ 0 w 1378659"/>
                          <a:gd name="connsiteY1" fmla="*/ 792089 h 792089"/>
                          <a:gd name="connsiteX2" fmla="*/ 1378659 w 1378659"/>
                          <a:gd name="connsiteY2" fmla="*/ 792089 h 792089"/>
                          <a:gd name="connsiteX3" fmla="*/ 1364698 w 1378659"/>
                          <a:gd name="connsiteY3" fmla="*/ 0 h 792089"/>
                          <a:gd name="connsiteX4" fmla="*/ 1315834 w 1378659"/>
                          <a:gd name="connsiteY4" fmla="*/ 39277 h 792089"/>
                          <a:gd name="connsiteX5" fmla="*/ 1256498 w 1378659"/>
                          <a:gd name="connsiteY5" fmla="*/ 72008 h 792089"/>
                          <a:gd name="connsiteX6" fmla="*/ 1183203 w 1378659"/>
                          <a:gd name="connsiteY6" fmla="*/ 144016 h 792089"/>
                          <a:gd name="connsiteX7" fmla="*/ 1148300 w 1378659"/>
                          <a:gd name="connsiteY7" fmla="*/ 206205 h 792089"/>
                          <a:gd name="connsiteX8" fmla="*/ 1078494 w 1378659"/>
                          <a:gd name="connsiteY8" fmla="*/ 255301 h 792089"/>
                          <a:gd name="connsiteX9" fmla="*/ 949355 w 1378659"/>
                          <a:gd name="connsiteY9" fmla="*/ 258574 h 792089"/>
                          <a:gd name="connsiteX10" fmla="*/ 841156 w 1378659"/>
                          <a:gd name="connsiteY10" fmla="*/ 255301 h 792089"/>
                          <a:gd name="connsiteX11" fmla="*/ 753899 w 1378659"/>
                          <a:gd name="connsiteY11" fmla="*/ 219297 h 792089"/>
                          <a:gd name="connsiteX12" fmla="*/ 705035 w 1378659"/>
                          <a:gd name="connsiteY12" fmla="*/ 219297 h 792089"/>
                          <a:gd name="connsiteX13" fmla="*/ 631740 w 1378659"/>
                          <a:gd name="connsiteY13" fmla="*/ 245482 h 792089"/>
                          <a:gd name="connsiteX14" fmla="*/ 520050 w 1378659"/>
                          <a:gd name="connsiteY14" fmla="*/ 245482 h 792089"/>
                          <a:gd name="connsiteX15" fmla="*/ 450245 w 1378659"/>
                          <a:gd name="connsiteY15" fmla="*/ 252028 h 792089"/>
                          <a:gd name="connsiteX16" fmla="*/ 369969 w 1378659"/>
                          <a:gd name="connsiteY16" fmla="*/ 258574 h 792089"/>
                          <a:gd name="connsiteX17" fmla="*/ 303654 w 1378659"/>
                          <a:gd name="connsiteY17" fmla="*/ 284759 h 792089"/>
                          <a:gd name="connsiteX18" fmla="*/ 209415 w 1378659"/>
                          <a:gd name="connsiteY18" fmla="*/ 314216 h 792089"/>
                          <a:gd name="connsiteX19" fmla="*/ 122160 w 1378659"/>
                          <a:gd name="connsiteY19" fmla="*/ 333855 h 792089"/>
                          <a:gd name="connsiteX20" fmla="*/ 52353 w 1378659"/>
                          <a:gd name="connsiteY20" fmla="*/ 353493 h 792089"/>
                          <a:gd name="connsiteX21" fmla="*/ 0 w 1378659"/>
                          <a:gd name="connsiteY21" fmla="*/ 363313 h 792089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  <a:cxn ang="0">
                            <a:pos x="connsiteX5" y="connsiteY5"/>
                          </a:cxn>
                          <a:cxn ang="0">
                            <a:pos x="connsiteX6" y="connsiteY6"/>
                          </a:cxn>
                          <a:cxn ang="0">
                            <a:pos x="connsiteX7" y="connsiteY7"/>
                          </a:cxn>
                          <a:cxn ang="0">
                            <a:pos x="connsiteX8" y="connsiteY8"/>
                          </a:cxn>
                          <a:cxn ang="0">
                            <a:pos x="connsiteX9" y="connsiteY9"/>
                          </a:cxn>
                          <a:cxn ang="0">
                            <a:pos x="connsiteX10" y="connsiteY10"/>
                          </a:cxn>
                          <a:cxn ang="0">
                            <a:pos x="connsiteX11" y="connsiteY11"/>
                          </a:cxn>
                          <a:cxn ang="0">
                            <a:pos x="connsiteX12" y="connsiteY12"/>
                          </a:cxn>
                          <a:cxn ang="0">
                            <a:pos x="connsiteX13" y="connsiteY13"/>
                          </a:cxn>
                          <a:cxn ang="0">
                            <a:pos x="connsiteX14" y="connsiteY14"/>
                          </a:cxn>
                          <a:cxn ang="0">
                            <a:pos x="connsiteX15" y="connsiteY15"/>
                          </a:cxn>
                          <a:cxn ang="0">
                            <a:pos x="connsiteX16" y="connsiteY16"/>
                          </a:cxn>
                          <a:cxn ang="0">
                            <a:pos x="connsiteX17" y="connsiteY17"/>
                          </a:cxn>
                          <a:cxn ang="0">
                            <a:pos x="connsiteX18" y="connsiteY18"/>
                          </a:cxn>
                          <a:cxn ang="0">
                            <a:pos x="connsiteX19" y="connsiteY19"/>
                          </a:cxn>
                          <a:cxn ang="0">
                            <a:pos x="connsiteX20" y="connsiteY20"/>
                          </a:cxn>
                          <a:cxn ang="0">
                            <a:pos x="connsiteX21" y="connsiteY21"/>
                          </a:cxn>
                        </a:cxnLst>
                        <a:rect l="l" t="t" r="r" b="b"/>
                        <a:pathLst>
                          <a:path w="1378659" h="792089" extrusionOk="0">
                            <a:moveTo>
                              <a:pt x="0" y="363313"/>
                            </a:moveTo>
                            <a:cubicBezTo>
                              <a:pt x="-23348" y="504724"/>
                              <a:pt x="-3892" y="675597"/>
                              <a:pt x="0" y="792089"/>
                            </a:cubicBezTo>
                            <a:cubicBezTo>
                              <a:pt x="680032" y="840451"/>
                              <a:pt x="852334" y="795618"/>
                              <a:pt x="1378659" y="792089"/>
                            </a:cubicBezTo>
                            <a:cubicBezTo>
                              <a:pt x="1369980" y="560562"/>
                              <a:pt x="1327470" y="234062"/>
                              <a:pt x="1364698" y="0"/>
                            </a:cubicBezTo>
                            <a:cubicBezTo>
                              <a:pt x="1350938" y="14172"/>
                              <a:pt x="1329349" y="34661"/>
                              <a:pt x="1315834" y="39277"/>
                            </a:cubicBezTo>
                            <a:cubicBezTo>
                              <a:pt x="1291289" y="59379"/>
                              <a:pt x="1266914" y="70370"/>
                              <a:pt x="1256498" y="72008"/>
                            </a:cubicBezTo>
                            <a:cubicBezTo>
                              <a:pt x="1240299" y="94466"/>
                              <a:pt x="1200515" y="135507"/>
                              <a:pt x="1183203" y="144016"/>
                            </a:cubicBezTo>
                            <a:cubicBezTo>
                              <a:pt x="1170581" y="177657"/>
                              <a:pt x="1155202" y="192630"/>
                              <a:pt x="1148300" y="206205"/>
                            </a:cubicBezTo>
                            <a:cubicBezTo>
                              <a:pt x="1127675" y="217352"/>
                              <a:pt x="1091875" y="244548"/>
                              <a:pt x="1078494" y="255301"/>
                            </a:cubicBezTo>
                            <a:cubicBezTo>
                              <a:pt x="1038705" y="253320"/>
                              <a:pt x="967917" y="263085"/>
                              <a:pt x="949355" y="258574"/>
                            </a:cubicBezTo>
                            <a:cubicBezTo>
                              <a:pt x="921570" y="260238"/>
                              <a:pt x="881739" y="263748"/>
                              <a:pt x="841156" y="255301"/>
                            </a:cubicBezTo>
                            <a:cubicBezTo>
                              <a:pt x="818270" y="248325"/>
                              <a:pt x="776970" y="235377"/>
                              <a:pt x="753899" y="219297"/>
                            </a:cubicBezTo>
                            <a:cubicBezTo>
                              <a:pt x="738560" y="221913"/>
                              <a:pt x="726522" y="222661"/>
                              <a:pt x="705035" y="219297"/>
                            </a:cubicBezTo>
                            <a:cubicBezTo>
                              <a:pt x="681992" y="227386"/>
                              <a:pt x="665156" y="234068"/>
                              <a:pt x="631740" y="245482"/>
                            </a:cubicBezTo>
                            <a:cubicBezTo>
                              <a:pt x="594667" y="248752"/>
                              <a:pt x="569816" y="252903"/>
                              <a:pt x="520050" y="245482"/>
                            </a:cubicBezTo>
                            <a:cubicBezTo>
                              <a:pt x="506234" y="249328"/>
                              <a:pt x="482007" y="247751"/>
                              <a:pt x="450245" y="252028"/>
                            </a:cubicBezTo>
                            <a:cubicBezTo>
                              <a:pt x="417651" y="252295"/>
                              <a:pt x="379533" y="262622"/>
                              <a:pt x="369969" y="258574"/>
                            </a:cubicBezTo>
                            <a:cubicBezTo>
                              <a:pt x="344236" y="270360"/>
                              <a:pt x="319515" y="280181"/>
                              <a:pt x="303654" y="284759"/>
                            </a:cubicBezTo>
                            <a:cubicBezTo>
                              <a:pt x="265863" y="291307"/>
                              <a:pt x="230605" y="315207"/>
                              <a:pt x="209415" y="314216"/>
                            </a:cubicBezTo>
                            <a:cubicBezTo>
                              <a:pt x="196595" y="322481"/>
                              <a:pt x="133278" y="326435"/>
                              <a:pt x="122160" y="333855"/>
                            </a:cubicBezTo>
                            <a:cubicBezTo>
                              <a:pt x="100599" y="343179"/>
                              <a:pt x="70463" y="354210"/>
                              <a:pt x="52353" y="353493"/>
                            </a:cubicBezTo>
                            <a:cubicBezTo>
                              <a:pt x="39313" y="357745"/>
                              <a:pt x="5027" y="359809"/>
                              <a:pt x="0" y="363313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</p:grpSp>
        <p:grpSp>
          <p:nvGrpSpPr>
            <p:cNvPr id="25" name="Gruppieren 24">
              <a:extLst>
                <a:ext uri="{FF2B5EF4-FFF2-40B4-BE49-F238E27FC236}">
                  <a16:creationId xmlns:a16="http://schemas.microsoft.com/office/drawing/2014/main" id="{ABBFD5E1-FDAC-BFBB-37C0-B496E776437C}"/>
                </a:ext>
              </a:extLst>
            </p:cNvPr>
            <p:cNvGrpSpPr/>
            <p:nvPr/>
          </p:nvGrpSpPr>
          <p:grpSpPr>
            <a:xfrm>
              <a:off x="1070547" y="1486074"/>
              <a:ext cx="2981684" cy="2119275"/>
              <a:chOff x="2465000" y="1959430"/>
              <a:chExt cx="1874771" cy="1413356"/>
            </a:xfrm>
          </p:grpSpPr>
          <p:grpSp>
            <p:nvGrpSpPr>
              <p:cNvPr id="24" name="Gruppieren 23">
                <a:extLst>
                  <a:ext uri="{FF2B5EF4-FFF2-40B4-BE49-F238E27FC236}">
                    <a16:creationId xmlns:a16="http://schemas.microsoft.com/office/drawing/2014/main" id="{AD7A9CAE-34C7-15E1-0211-91C609DC08B7}"/>
                  </a:ext>
                </a:extLst>
              </p:cNvPr>
              <p:cNvGrpSpPr/>
              <p:nvPr/>
            </p:nvGrpSpPr>
            <p:grpSpPr>
              <a:xfrm>
                <a:off x="2465000" y="1959430"/>
                <a:ext cx="1874771" cy="1413356"/>
                <a:chOff x="2465000" y="2378194"/>
                <a:chExt cx="1389349" cy="994591"/>
              </a:xfrm>
            </p:grpSpPr>
            <p:pic>
              <p:nvPicPr>
                <p:cNvPr id="7" name="Grafik 6">
                  <a:extLst>
                    <a:ext uri="{FF2B5EF4-FFF2-40B4-BE49-F238E27FC236}">
                      <a16:creationId xmlns:a16="http://schemas.microsoft.com/office/drawing/2014/main" id="{C6E628FD-D04E-C3BE-461C-737B5E375EA3}"/>
                    </a:ext>
                  </a:extLst>
                </p:cNvPr>
                <p:cNvPicPr>
                  <a:picLocks/>
                </p:cNvPicPr>
                <p:nvPr/>
              </p:nvPicPr>
              <p:blipFill rotWithShape="1">
                <a:blip r:embed="rId4" cstate="email">
                  <a:extLst>
                    <a:ext uri="{BEBA8EAE-BF5A-486C-A8C5-ECC9F3942E4B}">
                      <a14:imgProps xmlns:a14="http://schemas.microsoft.com/office/drawing/2010/main">
                        <a14:imgLayer r:embed="rId5">
                          <a14:imgEffect>
                            <a14:sharpenSoften amount="50000"/>
                          </a14:imgEffect>
                          <a14:imgEffect>
                            <a14:brightnessContrast bright="55000" contrast="45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 bwMode="auto">
                <a:xfrm rot="5400000">
                  <a:off x="2662379" y="2180815"/>
                  <a:ext cx="994591" cy="1389349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13" name="Freihandform 12">
                  <a:extLst>
                    <a:ext uri="{FF2B5EF4-FFF2-40B4-BE49-F238E27FC236}">
                      <a16:creationId xmlns:a16="http://schemas.microsoft.com/office/drawing/2014/main" id="{F32C971B-E0CC-BF91-62E3-698A74583813}"/>
                    </a:ext>
                  </a:extLst>
                </p:cNvPr>
                <p:cNvSpPr/>
                <p:nvPr/>
              </p:nvSpPr>
              <p:spPr>
                <a:xfrm>
                  <a:off x="2465000" y="2430849"/>
                  <a:ext cx="1378659" cy="476250"/>
                </a:xfrm>
                <a:custGeom>
                  <a:avLst/>
                  <a:gdLst>
                    <a:gd name="connsiteX0" fmla="*/ 28575 w 1397257"/>
                    <a:gd name="connsiteY0" fmla="*/ 466725 h 476272"/>
                    <a:gd name="connsiteX1" fmla="*/ 69850 w 1397257"/>
                    <a:gd name="connsiteY1" fmla="*/ 457200 h 476272"/>
                    <a:gd name="connsiteX2" fmla="*/ 79375 w 1397257"/>
                    <a:gd name="connsiteY2" fmla="*/ 454025 h 476272"/>
                    <a:gd name="connsiteX3" fmla="*/ 88900 w 1397257"/>
                    <a:gd name="connsiteY3" fmla="*/ 447675 h 476272"/>
                    <a:gd name="connsiteX4" fmla="*/ 114300 w 1397257"/>
                    <a:gd name="connsiteY4" fmla="*/ 441325 h 476272"/>
                    <a:gd name="connsiteX5" fmla="*/ 155575 w 1397257"/>
                    <a:gd name="connsiteY5" fmla="*/ 434975 h 476272"/>
                    <a:gd name="connsiteX6" fmla="*/ 174625 w 1397257"/>
                    <a:gd name="connsiteY6" fmla="*/ 428625 h 476272"/>
                    <a:gd name="connsiteX7" fmla="*/ 184150 w 1397257"/>
                    <a:gd name="connsiteY7" fmla="*/ 422275 h 476272"/>
                    <a:gd name="connsiteX8" fmla="*/ 228600 w 1397257"/>
                    <a:gd name="connsiteY8" fmla="*/ 409575 h 476272"/>
                    <a:gd name="connsiteX9" fmla="*/ 260350 w 1397257"/>
                    <a:gd name="connsiteY9" fmla="*/ 400050 h 476272"/>
                    <a:gd name="connsiteX10" fmla="*/ 269875 w 1397257"/>
                    <a:gd name="connsiteY10" fmla="*/ 396875 h 476272"/>
                    <a:gd name="connsiteX11" fmla="*/ 298450 w 1397257"/>
                    <a:gd name="connsiteY11" fmla="*/ 390525 h 476272"/>
                    <a:gd name="connsiteX12" fmla="*/ 317500 w 1397257"/>
                    <a:gd name="connsiteY12" fmla="*/ 384175 h 476272"/>
                    <a:gd name="connsiteX13" fmla="*/ 327025 w 1397257"/>
                    <a:gd name="connsiteY13" fmla="*/ 381000 h 476272"/>
                    <a:gd name="connsiteX14" fmla="*/ 336550 w 1397257"/>
                    <a:gd name="connsiteY14" fmla="*/ 377825 h 476272"/>
                    <a:gd name="connsiteX15" fmla="*/ 355600 w 1397257"/>
                    <a:gd name="connsiteY15" fmla="*/ 365125 h 476272"/>
                    <a:gd name="connsiteX16" fmla="*/ 377825 w 1397257"/>
                    <a:gd name="connsiteY16" fmla="*/ 358775 h 476272"/>
                    <a:gd name="connsiteX17" fmla="*/ 396875 w 1397257"/>
                    <a:gd name="connsiteY17" fmla="*/ 352425 h 476272"/>
                    <a:gd name="connsiteX18" fmla="*/ 419100 w 1397257"/>
                    <a:gd name="connsiteY18" fmla="*/ 349250 h 476272"/>
                    <a:gd name="connsiteX19" fmla="*/ 434975 w 1397257"/>
                    <a:gd name="connsiteY19" fmla="*/ 346075 h 476272"/>
                    <a:gd name="connsiteX20" fmla="*/ 609600 w 1397257"/>
                    <a:gd name="connsiteY20" fmla="*/ 342900 h 476272"/>
                    <a:gd name="connsiteX21" fmla="*/ 641350 w 1397257"/>
                    <a:gd name="connsiteY21" fmla="*/ 336550 h 476272"/>
                    <a:gd name="connsiteX22" fmla="*/ 685800 w 1397257"/>
                    <a:gd name="connsiteY22" fmla="*/ 327025 h 476272"/>
                    <a:gd name="connsiteX23" fmla="*/ 704850 w 1397257"/>
                    <a:gd name="connsiteY23" fmla="*/ 320675 h 476272"/>
                    <a:gd name="connsiteX24" fmla="*/ 714375 w 1397257"/>
                    <a:gd name="connsiteY24" fmla="*/ 317500 h 476272"/>
                    <a:gd name="connsiteX25" fmla="*/ 723900 w 1397257"/>
                    <a:gd name="connsiteY25" fmla="*/ 314325 h 476272"/>
                    <a:gd name="connsiteX26" fmla="*/ 733425 w 1397257"/>
                    <a:gd name="connsiteY26" fmla="*/ 307975 h 476272"/>
                    <a:gd name="connsiteX27" fmla="*/ 752475 w 1397257"/>
                    <a:gd name="connsiteY27" fmla="*/ 301625 h 476272"/>
                    <a:gd name="connsiteX28" fmla="*/ 790575 w 1397257"/>
                    <a:gd name="connsiteY28" fmla="*/ 304800 h 476272"/>
                    <a:gd name="connsiteX29" fmla="*/ 800100 w 1397257"/>
                    <a:gd name="connsiteY29" fmla="*/ 307975 h 476272"/>
                    <a:gd name="connsiteX30" fmla="*/ 815975 w 1397257"/>
                    <a:gd name="connsiteY30" fmla="*/ 323850 h 476272"/>
                    <a:gd name="connsiteX31" fmla="*/ 835025 w 1397257"/>
                    <a:gd name="connsiteY31" fmla="*/ 330200 h 476272"/>
                    <a:gd name="connsiteX32" fmla="*/ 844550 w 1397257"/>
                    <a:gd name="connsiteY32" fmla="*/ 333375 h 476272"/>
                    <a:gd name="connsiteX33" fmla="*/ 866775 w 1397257"/>
                    <a:gd name="connsiteY33" fmla="*/ 339725 h 476272"/>
                    <a:gd name="connsiteX34" fmla="*/ 885825 w 1397257"/>
                    <a:gd name="connsiteY34" fmla="*/ 349250 h 476272"/>
                    <a:gd name="connsiteX35" fmla="*/ 898525 w 1397257"/>
                    <a:gd name="connsiteY35" fmla="*/ 352425 h 476272"/>
                    <a:gd name="connsiteX36" fmla="*/ 908050 w 1397257"/>
                    <a:gd name="connsiteY36" fmla="*/ 355600 h 476272"/>
                    <a:gd name="connsiteX37" fmla="*/ 1003300 w 1397257"/>
                    <a:gd name="connsiteY37" fmla="*/ 361950 h 476272"/>
                    <a:gd name="connsiteX38" fmla="*/ 1063625 w 1397257"/>
                    <a:gd name="connsiteY38" fmla="*/ 358775 h 476272"/>
                    <a:gd name="connsiteX39" fmla="*/ 1073150 w 1397257"/>
                    <a:gd name="connsiteY39" fmla="*/ 355600 h 476272"/>
                    <a:gd name="connsiteX40" fmla="*/ 1092200 w 1397257"/>
                    <a:gd name="connsiteY40" fmla="*/ 352425 h 476272"/>
                    <a:gd name="connsiteX41" fmla="*/ 1101725 w 1397257"/>
                    <a:gd name="connsiteY41" fmla="*/ 349250 h 476272"/>
                    <a:gd name="connsiteX42" fmla="*/ 1114425 w 1397257"/>
                    <a:gd name="connsiteY42" fmla="*/ 346075 h 476272"/>
                    <a:gd name="connsiteX43" fmla="*/ 1133475 w 1397257"/>
                    <a:gd name="connsiteY43" fmla="*/ 339725 h 476272"/>
                    <a:gd name="connsiteX44" fmla="*/ 1136650 w 1397257"/>
                    <a:gd name="connsiteY44" fmla="*/ 330200 h 476272"/>
                    <a:gd name="connsiteX45" fmla="*/ 1149350 w 1397257"/>
                    <a:gd name="connsiteY45" fmla="*/ 314325 h 476272"/>
                    <a:gd name="connsiteX46" fmla="*/ 1174750 w 1397257"/>
                    <a:gd name="connsiteY46" fmla="*/ 288925 h 476272"/>
                    <a:gd name="connsiteX47" fmla="*/ 1187450 w 1397257"/>
                    <a:gd name="connsiteY47" fmla="*/ 269875 h 476272"/>
                    <a:gd name="connsiteX48" fmla="*/ 1193800 w 1397257"/>
                    <a:gd name="connsiteY48" fmla="*/ 260350 h 476272"/>
                    <a:gd name="connsiteX49" fmla="*/ 1203325 w 1397257"/>
                    <a:gd name="connsiteY49" fmla="*/ 250825 h 476272"/>
                    <a:gd name="connsiteX50" fmla="*/ 1209675 w 1397257"/>
                    <a:gd name="connsiteY50" fmla="*/ 231775 h 476272"/>
                    <a:gd name="connsiteX51" fmla="*/ 1231900 w 1397257"/>
                    <a:gd name="connsiteY51" fmla="*/ 203200 h 476272"/>
                    <a:gd name="connsiteX52" fmla="*/ 1238250 w 1397257"/>
                    <a:gd name="connsiteY52" fmla="*/ 193675 h 476272"/>
                    <a:gd name="connsiteX53" fmla="*/ 1257300 w 1397257"/>
                    <a:gd name="connsiteY53" fmla="*/ 180975 h 476272"/>
                    <a:gd name="connsiteX54" fmla="*/ 1285875 w 1397257"/>
                    <a:gd name="connsiteY54" fmla="*/ 158750 h 476272"/>
                    <a:gd name="connsiteX55" fmla="*/ 1295400 w 1397257"/>
                    <a:gd name="connsiteY55" fmla="*/ 152400 h 476272"/>
                    <a:gd name="connsiteX56" fmla="*/ 1308100 w 1397257"/>
                    <a:gd name="connsiteY56" fmla="*/ 146050 h 476272"/>
                    <a:gd name="connsiteX57" fmla="*/ 1317625 w 1397257"/>
                    <a:gd name="connsiteY57" fmla="*/ 142875 h 476272"/>
                    <a:gd name="connsiteX58" fmla="*/ 1336675 w 1397257"/>
                    <a:gd name="connsiteY58" fmla="*/ 130175 h 476272"/>
                    <a:gd name="connsiteX59" fmla="*/ 1346200 w 1397257"/>
                    <a:gd name="connsiteY59" fmla="*/ 127000 h 476272"/>
                    <a:gd name="connsiteX60" fmla="*/ 1365250 w 1397257"/>
                    <a:gd name="connsiteY60" fmla="*/ 114300 h 476272"/>
                    <a:gd name="connsiteX61" fmla="*/ 1374775 w 1397257"/>
                    <a:gd name="connsiteY61" fmla="*/ 104775 h 476272"/>
                    <a:gd name="connsiteX62" fmla="*/ 1384300 w 1397257"/>
                    <a:gd name="connsiteY62" fmla="*/ 101600 h 476272"/>
                    <a:gd name="connsiteX63" fmla="*/ 1393825 w 1397257"/>
                    <a:gd name="connsiteY63" fmla="*/ 95250 h 476272"/>
                    <a:gd name="connsiteX64" fmla="*/ 1393825 w 1397257"/>
                    <a:gd name="connsiteY64" fmla="*/ 76200 h 476272"/>
                    <a:gd name="connsiteX65" fmla="*/ 1381125 w 1397257"/>
                    <a:gd name="connsiteY65" fmla="*/ 0 h 476272"/>
                    <a:gd name="connsiteX66" fmla="*/ 1336675 w 1397257"/>
                    <a:gd name="connsiteY66" fmla="*/ 6350 h 476272"/>
                    <a:gd name="connsiteX67" fmla="*/ 1317625 w 1397257"/>
                    <a:gd name="connsiteY67" fmla="*/ 19050 h 476272"/>
                    <a:gd name="connsiteX68" fmla="*/ 1308100 w 1397257"/>
                    <a:gd name="connsiteY68" fmla="*/ 25400 h 476272"/>
                    <a:gd name="connsiteX69" fmla="*/ 1289050 w 1397257"/>
                    <a:gd name="connsiteY69" fmla="*/ 31750 h 476272"/>
                    <a:gd name="connsiteX70" fmla="*/ 1279525 w 1397257"/>
                    <a:gd name="connsiteY70" fmla="*/ 34925 h 476272"/>
                    <a:gd name="connsiteX71" fmla="*/ 1270000 w 1397257"/>
                    <a:gd name="connsiteY71" fmla="*/ 41275 h 476272"/>
                    <a:gd name="connsiteX72" fmla="*/ 1250950 w 1397257"/>
                    <a:gd name="connsiteY72" fmla="*/ 47625 h 476272"/>
                    <a:gd name="connsiteX73" fmla="*/ 1231900 w 1397257"/>
                    <a:gd name="connsiteY73" fmla="*/ 53975 h 476272"/>
                    <a:gd name="connsiteX74" fmla="*/ 1222375 w 1397257"/>
                    <a:gd name="connsiteY74" fmla="*/ 57150 h 476272"/>
                    <a:gd name="connsiteX75" fmla="*/ 1212850 w 1397257"/>
                    <a:gd name="connsiteY75" fmla="*/ 63500 h 476272"/>
                    <a:gd name="connsiteX76" fmla="*/ 1193800 w 1397257"/>
                    <a:gd name="connsiteY76" fmla="*/ 69850 h 476272"/>
                    <a:gd name="connsiteX77" fmla="*/ 1184275 w 1397257"/>
                    <a:gd name="connsiteY77" fmla="*/ 73025 h 476272"/>
                    <a:gd name="connsiteX78" fmla="*/ 1171575 w 1397257"/>
                    <a:gd name="connsiteY78" fmla="*/ 76200 h 476272"/>
                    <a:gd name="connsiteX79" fmla="*/ 1152525 w 1397257"/>
                    <a:gd name="connsiteY79" fmla="*/ 82550 h 476272"/>
                    <a:gd name="connsiteX80" fmla="*/ 1130300 w 1397257"/>
                    <a:gd name="connsiteY80" fmla="*/ 95250 h 476272"/>
                    <a:gd name="connsiteX81" fmla="*/ 1120775 w 1397257"/>
                    <a:gd name="connsiteY81" fmla="*/ 101600 h 476272"/>
                    <a:gd name="connsiteX82" fmla="*/ 1111250 w 1397257"/>
                    <a:gd name="connsiteY82" fmla="*/ 104775 h 476272"/>
                    <a:gd name="connsiteX83" fmla="*/ 1101725 w 1397257"/>
                    <a:gd name="connsiteY83" fmla="*/ 111125 h 476272"/>
                    <a:gd name="connsiteX84" fmla="*/ 1092200 w 1397257"/>
                    <a:gd name="connsiteY84" fmla="*/ 114300 h 476272"/>
                    <a:gd name="connsiteX85" fmla="*/ 1073150 w 1397257"/>
                    <a:gd name="connsiteY85" fmla="*/ 127000 h 476272"/>
                    <a:gd name="connsiteX86" fmla="*/ 1060450 w 1397257"/>
                    <a:gd name="connsiteY86" fmla="*/ 146050 h 476272"/>
                    <a:gd name="connsiteX87" fmla="*/ 1050925 w 1397257"/>
                    <a:gd name="connsiteY87" fmla="*/ 165100 h 476272"/>
                    <a:gd name="connsiteX88" fmla="*/ 1047750 w 1397257"/>
                    <a:gd name="connsiteY88" fmla="*/ 177800 h 476272"/>
                    <a:gd name="connsiteX89" fmla="*/ 1041400 w 1397257"/>
                    <a:gd name="connsiteY89" fmla="*/ 187325 h 476272"/>
                    <a:gd name="connsiteX90" fmla="*/ 1035050 w 1397257"/>
                    <a:gd name="connsiteY90" fmla="*/ 219075 h 476272"/>
                    <a:gd name="connsiteX91" fmla="*/ 1016000 w 1397257"/>
                    <a:gd name="connsiteY91" fmla="*/ 231775 h 476272"/>
                    <a:gd name="connsiteX92" fmla="*/ 1006475 w 1397257"/>
                    <a:gd name="connsiteY92" fmla="*/ 238125 h 476272"/>
                    <a:gd name="connsiteX93" fmla="*/ 987425 w 1397257"/>
                    <a:gd name="connsiteY93" fmla="*/ 244475 h 476272"/>
                    <a:gd name="connsiteX94" fmla="*/ 917575 w 1397257"/>
                    <a:gd name="connsiteY94" fmla="*/ 241300 h 476272"/>
                    <a:gd name="connsiteX95" fmla="*/ 898525 w 1397257"/>
                    <a:gd name="connsiteY95" fmla="*/ 231775 h 476272"/>
                    <a:gd name="connsiteX96" fmla="*/ 879475 w 1397257"/>
                    <a:gd name="connsiteY96" fmla="*/ 225425 h 476272"/>
                    <a:gd name="connsiteX97" fmla="*/ 869950 w 1397257"/>
                    <a:gd name="connsiteY97" fmla="*/ 222250 h 476272"/>
                    <a:gd name="connsiteX98" fmla="*/ 850900 w 1397257"/>
                    <a:gd name="connsiteY98" fmla="*/ 209550 h 476272"/>
                    <a:gd name="connsiteX99" fmla="*/ 831850 w 1397257"/>
                    <a:gd name="connsiteY99" fmla="*/ 203200 h 476272"/>
                    <a:gd name="connsiteX100" fmla="*/ 822325 w 1397257"/>
                    <a:gd name="connsiteY100" fmla="*/ 200025 h 476272"/>
                    <a:gd name="connsiteX101" fmla="*/ 796925 w 1397257"/>
                    <a:gd name="connsiteY101" fmla="*/ 190500 h 476272"/>
                    <a:gd name="connsiteX102" fmla="*/ 777875 w 1397257"/>
                    <a:gd name="connsiteY102" fmla="*/ 177800 h 476272"/>
                    <a:gd name="connsiteX103" fmla="*/ 768350 w 1397257"/>
                    <a:gd name="connsiteY103" fmla="*/ 171450 h 476272"/>
                    <a:gd name="connsiteX104" fmla="*/ 742950 w 1397257"/>
                    <a:gd name="connsiteY104" fmla="*/ 165100 h 476272"/>
                    <a:gd name="connsiteX105" fmla="*/ 708025 w 1397257"/>
                    <a:gd name="connsiteY105" fmla="*/ 158750 h 476272"/>
                    <a:gd name="connsiteX106" fmla="*/ 660400 w 1397257"/>
                    <a:gd name="connsiteY106" fmla="*/ 161925 h 476272"/>
                    <a:gd name="connsiteX107" fmla="*/ 647700 w 1397257"/>
                    <a:gd name="connsiteY107" fmla="*/ 168275 h 476272"/>
                    <a:gd name="connsiteX108" fmla="*/ 638175 w 1397257"/>
                    <a:gd name="connsiteY108" fmla="*/ 171450 h 476272"/>
                    <a:gd name="connsiteX109" fmla="*/ 628650 w 1397257"/>
                    <a:gd name="connsiteY109" fmla="*/ 180975 h 476272"/>
                    <a:gd name="connsiteX110" fmla="*/ 619125 w 1397257"/>
                    <a:gd name="connsiteY110" fmla="*/ 187325 h 476272"/>
                    <a:gd name="connsiteX111" fmla="*/ 612775 w 1397257"/>
                    <a:gd name="connsiteY111" fmla="*/ 196850 h 476272"/>
                    <a:gd name="connsiteX112" fmla="*/ 603250 w 1397257"/>
                    <a:gd name="connsiteY112" fmla="*/ 209550 h 476272"/>
                    <a:gd name="connsiteX113" fmla="*/ 593725 w 1397257"/>
                    <a:gd name="connsiteY113" fmla="*/ 215900 h 476272"/>
                    <a:gd name="connsiteX114" fmla="*/ 577850 w 1397257"/>
                    <a:gd name="connsiteY114" fmla="*/ 231775 h 476272"/>
                    <a:gd name="connsiteX115" fmla="*/ 549275 w 1397257"/>
                    <a:gd name="connsiteY115" fmla="*/ 254000 h 476272"/>
                    <a:gd name="connsiteX116" fmla="*/ 530225 w 1397257"/>
                    <a:gd name="connsiteY116" fmla="*/ 260350 h 476272"/>
                    <a:gd name="connsiteX117" fmla="*/ 473075 w 1397257"/>
                    <a:gd name="connsiteY117" fmla="*/ 266700 h 476272"/>
                    <a:gd name="connsiteX118" fmla="*/ 463550 w 1397257"/>
                    <a:gd name="connsiteY118" fmla="*/ 269875 h 476272"/>
                    <a:gd name="connsiteX119" fmla="*/ 412750 w 1397257"/>
                    <a:gd name="connsiteY119" fmla="*/ 263525 h 476272"/>
                    <a:gd name="connsiteX120" fmla="*/ 250825 w 1397257"/>
                    <a:gd name="connsiteY120" fmla="*/ 266700 h 476272"/>
                    <a:gd name="connsiteX121" fmla="*/ 219075 w 1397257"/>
                    <a:gd name="connsiteY121" fmla="*/ 273050 h 476272"/>
                    <a:gd name="connsiteX122" fmla="*/ 196850 w 1397257"/>
                    <a:gd name="connsiteY122" fmla="*/ 288925 h 476272"/>
                    <a:gd name="connsiteX123" fmla="*/ 184150 w 1397257"/>
                    <a:gd name="connsiteY123" fmla="*/ 295275 h 476272"/>
                    <a:gd name="connsiteX124" fmla="*/ 174625 w 1397257"/>
                    <a:gd name="connsiteY124" fmla="*/ 301625 h 476272"/>
                    <a:gd name="connsiteX125" fmla="*/ 152400 w 1397257"/>
                    <a:gd name="connsiteY125" fmla="*/ 311150 h 476272"/>
                    <a:gd name="connsiteX126" fmla="*/ 123825 w 1397257"/>
                    <a:gd name="connsiteY126" fmla="*/ 320675 h 476272"/>
                    <a:gd name="connsiteX127" fmla="*/ 114300 w 1397257"/>
                    <a:gd name="connsiteY127" fmla="*/ 327025 h 476272"/>
                    <a:gd name="connsiteX128" fmla="*/ 79375 w 1397257"/>
                    <a:gd name="connsiteY128" fmla="*/ 336550 h 476272"/>
                    <a:gd name="connsiteX129" fmla="*/ 66675 w 1397257"/>
                    <a:gd name="connsiteY129" fmla="*/ 342900 h 476272"/>
                    <a:gd name="connsiteX130" fmla="*/ 47625 w 1397257"/>
                    <a:gd name="connsiteY130" fmla="*/ 349250 h 476272"/>
                    <a:gd name="connsiteX131" fmla="*/ 38100 w 1397257"/>
                    <a:gd name="connsiteY131" fmla="*/ 355600 h 476272"/>
                    <a:gd name="connsiteX132" fmla="*/ 9525 w 1397257"/>
                    <a:gd name="connsiteY132" fmla="*/ 365125 h 476272"/>
                    <a:gd name="connsiteX133" fmla="*/ 0 w 1397257"/>
                    <a:gd name="connsiteY133" fmla="*/ 368300 h 476272"/>
                    <a:gd name="connsiteX134" fmla="*/ 9525 w 1397257"/>
                    <a:gd name="connsiteY134" fmla="*/ 403225 h 476272"/>
                    <a:gd name="connsiteX135" fmla="*/ 12700 w 1397257"/>
                    <a:gd name="connsiteY135" fmla="*/ 450850 h 476272"/>
                    <a:gd name="connsiteX136" fmla="*/ 28575 w 1397257"/>
                    <a:gd name="connsiteY136" fmla="*/ 476250 h 476272"/>
                    <a:gd name="connsiteX137" fmla="*/ 28575 w 1397257"/>
                    <a:gd name="connsiteY137" fmla="*/ 466725 h 476272"/>
                  </a:gdLst>
                  <a:ahLst/>
                  <a:cxnLst>
                    <a:cxn ang="0">
                      <a:pos x="connsiteX0" y="connsiteY0"/>
                    </a:cxn>
                    <a:cxn ang="0">
                      <a:pos x="connsiteX1" y="connsiteY1"/>
                    </a:cxn>
                    <a:cxn ang="0">
                      <a:pos x="connsiteX2" y="connsiteY2"/>
                    </a:cxn>
                    <a:cxn ang="0">
                      <a:pos x="connsiteX3" y="connsiteY3"/>
                    </a:cxn>
                    <a:cxn ang="0">
                      <a:pos x="connsiteX4" y="connsiteY4"/>
                    </a:cxn>
                    <a:cxn ang="0">
                      <a:pos x="connsiteX5" y="connsiteY5"/>
                    </a:cxn>
                    <a:cxn ang="0">
                      <a:pos x="connsiteX6" y="connsiteY6"/>
                    </a:cxn>
                    <a:cxn ang="0">
                      <a:pos x="connsiteX7" y="connsiteY7"/>
                    </a:cxn>
                    <a:cxn ang="0">
                      <a:pos x="connsiteX8" y="connsiteY8"/>
                    </a:cxn>
                    <a:cxn ang="0">
                      <a:pos x="connsiteX9" y="connsiteY9"/>
                    </a:cxn>
                    <a:cxn ang="0">
                      <a:pos x="connsiteX10" y="connsiteY10"/>
                    </a:cxn>
                    <a:cxn ang="0">
                      <a:pos x="connsiteX11" y="connsiteY11"/>
                    </a:cxn>
                    <a:cxn ang="0">
                      <a:pos x="connsiteX12" y="connsiteY12"/>
                    </a:cxn>
                    <a:cxn ang="0">
                      <a:pos x="connsiteX13" y="connsiteY13"/>
                    </a:cxn>
                    <a:cxn ang="0">
                      <a:pos x="connsiteX14" y="connsiteY14"/>
                    </a:cxn>
                    <a:cxn ang="0">
                      <a:pos x="connsiteX15" y="connsiteY15"/>
                    </a:cxn>
                    <a:cxn ang="0">
                      <a:pos x="connsiteX16" y="connsiteY16"/>
                    </a:cxn>
                    <a:cxn ang="0">
                      <a:pos x="connsiteX17" y="connsiteY17"/>
                    </a:cxn>
                    <a:cxn ang="0">
                      <a:pos x="connsiteX18" y="connsiteY18"/>
                    </a:cxn>
                    <a:cxn ang="0">
                      <a:pos x="connsiteX19" y="connsiteY19"/>
                    </a:cxn>
                    <a:cxn ang="0">
                      <a:pos x="connsiteX20" y="connsiteY20"/>
                    </a:cxn>
                    <a:cxn ang="0">
                      <a:pos x="connsiteX21" y="connsiteY21"/>
                    </a:cxn>
                    <a:cxn ang="0">
                      <a:pos x="connsiteX22" y="connsiteY22"/>
                    </a:cxn>
                    <a:cxn ang="0">
                      <a:pos x="connsiteX23" y="connsiteY23"/>
                    </a:cxn>
                    <a:cxn ang="0">
                      <a:pos x="connsiteX24" y="connsiteY24"/>
                    </a:cxn>
                    <a:cxn ang="0">
                      <a:pos x="connsiteX25" y="connsiteY25"/>
                    </a:cxn>
                    <a:cxn ang="0">
                      <a:pos x="connsiteX26" y="connsiteY26"/>
                    </a:cxn>
                    <a:cxn ang="0">
                      <a:pos x="connsiteX27" y="connsiteY27"/>
                    </a:cxn>
                    <a:cxn ang="0">
                      <a:pos x="connsiteX28" y="connsiteY28"/>
                    </a:cxn>
                    <a:cxn ang="0">
                      <a:pos x="connsiteX29" y="connsiteY29"/>
                    </a:cxn>
                    <a:cxn ang="0">
                      <a:pos x="connsiteX30" y="connsiteY30"/>
                    </a:cxn>
                    <a:cxn ang="0">
                      <a:pos x="connsiteX31" y="connsiteY31"/>
                    </a:cxn>
                    <a:cxn ang="0">
                      <a:pos x="connsiteX32" y="connsiteY32"/>
                    </a:cxn>
                    <a:cxn ang="0">
                      <a:pos x="connsiteX33" y="connsiteY33"/>
                    </a:cxn>
                    <a:cxn ang="0">
                      <a:pos x="connsiteX34" y="connsiteY34"/>
                    </a:cxn>
                    <a:cxn ang="0">
                      <a:pos x="connsiteX35" y="connsiteY35"/>
                    </a:cxn>
                    <a:cxn ang="0">
                      <a:pos x="connsiteX36" y="connsiteY36"/>
                    </a:cxn>
                    <a:cxn ang="0">
                      <a:pos x="connsiteX37" y="connsiteY37"/>
                    </a:cxn>
                    <a:cxn ang="0">
                      <a:pos x="connsiteX38" y="connsiteY38"/>
                    </a:cxn>
                    <a:cxn ang="0">
                      <a:pos x="connsiteX39" y="connsiteY39"/>
                    </a:cxn>
                    <a:cxn ang="0">
                      <a:pos x="connsiteX40" y="connsiteY40"/>
                    </a:cxn>
                    <a:cxn ang="0">
                      <a:pos x="connsiteX41" y="connsiteY41"/>
                    </a:cxn>
                    <a:cxn ang="0">
                      <a:pos x="connsiteX42" y="connsiteY42"/>
                    </a:cxn>
                    <a:cxn ang="0">
                      <a:pos x="connsiteX43" y="connsiteY43"/>
                    </a:cxn>
                    <a:cxn ang="0">
                      <a:pos x="connsiteX44" y="connsiteY44"/>
                    </a:cxn>
                    <a:cxn ang="0">
                      <a:pos x="connsiteX45" y="connsiteY45"/>
                    </a:cxn>
                    <a:cxn ang="0">
                      <a:pos x="connsiteX46" y="connsiteY46"/>
                    </a:cxn>
                    <a:cxn ang="0">
                      <a:pos x="connsiteX47" y="connsiteY47"/>
                    </a:cxn>
                    <a:cxn ang="0">
                      <a:pos x="connsiteX48" y="connsiteY48"/>
                    </a:cxn>
                    <a:cxn ang="0">
                      <a:pos x="connsiteX49" y="connsiteY49"/>
                    </a:cxn>
                    <a:cxn ang="0">
                      <a:pos x="connsiteX50" y="connsiteY50"/>
                    </a:cxn>
                    <a:cxn ang="0">
                      <a:pos x="connsiteX51" y="connsiteY51"/>
                    </a:cxn>
                    <a:cxn ang="0">
                      <a:pos x="connsiteX52" y="connsiteY52"/>
                    </a:cxn>
                    <a:cxn ang="0">
                      <a:pos x="connsiteX53" y="connsiteY53"/>
                    </a:cxn>
                    <a:cxn ang="0">
                      <a:pos x="connsiteX54" y="connsiteY54"/>
                    </a:cxn>
                    <a:cxn ang="0">
                      <a:pos x="connsiteX55" y="connsiteY55"/>
                    </a:cxn>
                    <a:cxn ang="0">
                      <a:pos x="connsiteX56" y="connsiteY56"/>
                    </a:cxn>
                    <a:cxn ang="0">
                      <a:pos x="connsiteX57" y="connsiteY57"/>
                    </a:cxn>
                    <a:cxn ang="0">
                      <a:pos x="connsiteX58" y="connsiteY58"/>
                    </a:cxn>
                    <a:cxn ang="0">
                      <a:pos x="connsiteX59" y="connsiteY59"/>
                    </a:cxn>
                    <a:cxn ang="0">
                      <a:pos x="connsiteX60" y="connsiteY60"/>
                    </a:cxn>
                    <a:cxn ang="0">
                      <a:pos x="connsiteX61" y="connsiteY61"/>
                    </a:cxn>
                    <a:cxn ang="0">
                      <a:pos x="connsiteX62" y="connsiteY62"/>
                    </a:cxn>
                    <a:cxn ang="0">
                      <a:pos x="connsiteX63" y="connsiteY63"/>
                    </a:cxn>
                    <a:cxn ang="0">
                      <a:pos x="connsiteX64" y="connsiteY64"/>
                    </a:cxn>
                    <a:cxn ang="0">
                      <a:pos x="connsiteX65" y="connsiteY65"/>
                    </a:cxn>
                    <a:cxn ang="0">
                      <a:pos x="connsiteX66" y="connsiteY66"/>
                    </a:cxn>
                    <a:cxn ang="0">
                      <a:pos x="connsiteX67" y="connsiteY67"/>
                    </a:cxn>
                    <a:cxn ang="0">
                      <a:pos x="connsiteX68" y="connsiteY68"/>
                    </a:cxn>
                    <a:cxn ang="0">
                      <a:pos x="connsiteX69" y="connsiteY69"/>
                    </a:cxn>
                    <a:cxn ang="0">
                      <a:pos x="connsiteX70" y="connsiteY70"/>
                    </a:cxn>
                    <a:cxn ang="0">
                      <a:pos x="connsiteX71" y="connsiteY71"/>
                    </a:cxn>
                    <a:cxn ang="0">
                      <a:pos x="connsiteX72" y="connsiteY72"/>
                    </a:cxn>
                    <a:cxn ang="0">
                      <a:pos x="connsiteX73" y="connsiteY73"/>
                    </a:cxn>
                    <a:cxn ang="0">
                      <a:pos x="connsiteX74" y="connsiteY74"/>
                    </a:cxn>
                    <a:cxn ang="0">
                      <a:pos x="connsiteX75" y="connsiteY75"/>
                    </a:cxn>
                    <a:cxn ang="0">
                      <a:pos x="connsiteX76" y="connsiteY76"/>
                    </a:cxn>
                    <a:cxn ang="0">
                      <a:pos x="connsiteX77" y="connsiteY77"/>
                    </a:cxn>
                    <a:cxn ang="0">
                      <a:pos x="connsiteX78" y="connsiteY78"/>
                    </a:cxn>
                    <a:cxn ang="0">
                      <a:pos x="connsiteX79" y="connsiteY79"/>
                    </a:cxn>
                    <a:cxn ang="0">
                      <a:pos x="connsiteX80" y="connsiteY80"/>
                    </a:cxn>
                    <a:cxn ang="0">
                      <a:pos x="connsiteX81" y="connsiteY81"/>
                    </a:cxn>
                    <a:cxn ang="0">
                      <a:pos x="connsiteX82" y="connsiteY82"/>
                    </a:cxn>
                    <a:cxn ang="0">
                      <a:pos x="connsiteX83" y="connsiteY83"/>
                    </a:cxn>
                    <a:cxn ang="0">
                      <a:pos x="connsiteX84" y="connsiteY84"/>
                    </a:cxn>
                    <a:cxn ang="0">
                      <a:pos x="connsiteX85" y="connsiteY85"/>
                    </a:cxn>
                    <a:cxn ang="0">
                      <a:pos x="connsiteX86" y="connsiteY86"/>
                    </a:cxn>
                    <a:cxn ang="0">
                      <a:pos x="connsiteX87" y="connsiteY87"/>
                    </a:cxn>
                    <a:cxn ang="0">
                      <a:pos x="connsiteX88" y="connsiteY88"/>
                    </a:cxn>
                    <a:cxn ang="0">
                      <a:pos x="connsiteX89" y="connsiteY89"/>
                    </a:cxn>
                    <a:cxn ang="0">
                      <a:pos x="connsiteX90" y="connsiteY90"/>
                    </a:cxn>
                    <a:cxn ang="0">
                      <a:pos x="connsiteX91" y="connsiteY91"/>
                    </a:cxn>
                    <a:cxn ang="0">
                      <a:pos x="connsiteX92" y="connsiteY92"/>
                    </a:cxn>
                    <a:cxn ang="0">
                      <a:pos x="connsiteX93" y="connsiteY93"/>
                    </a:cxn>
                    <a:cxn ang="0">
                      <a:pos x="connsiteX94" y="connsiteY94"/>
                    </a:cxn>
                    <a:cxn ang="0">
                      <a:pos x="connsiteX95" y="connsiteY95"/>
                    </a:cxn>
                    <a:cxn ang="0">
                      <a:pos x="connsiteX96" y="connsiteY96"/>
                    </a:cxn>
                    <a:cxn ang="0">
                      <a:pos x="connsiteX97" y="connsiteY97"/>
                    </a:cxn>
                    <a:cxn ang="0">
                      <a:pos x="connsiteX98" y="connsiteY98"/>
                    </a:cxn>
                    <a:cxn ang="0">
                      <a:pos x="connsiteX99" y="connsiteY99"/>
                    </a:cxn>
                    <a:cxn ang="0">
                      <a:pos x="connsiteX100" y="connsiteY100"/>
                    </a:cxn>
                    <a:cxn ang="0">
                      <a:pos x="connsiteX101" y="connsiteY101"/>
                    </a:cxn>
                    <a:cxn ang="0">
                      <a:pos x="connsiteX102" y="connsiteY102"/>
                    </a:cxn>
                    <a:cxn ang="0">
                      <a:pos x="connsiteX103" y="connsiteY103"/>
                    </a:cxn>
                    <a:cxn ang="0">
                      <a:pos x="connsiteX104" y="connsiteY104"/>
                    </a:cxn>
                    <a:cxn ang="0">
                      <a:pos x="connsiteX105" y="connsiteY105"/>
                    </a:cxn>
                    <a:cxn ang="0">
                      <a:pos x="connsiteX106" y="connsiteY106"/>
                    </a:cxn>
                    <a:cxn ang="0">
                      <a:pos x="connsiteX107" y="connsiteY107"/>
                    </a:cxn>
                    <a:cxn ang="0">
                      <a:pos x="connsiteX108" y="connsiteY108"/>
                    </a:cxn>
                    <a:cxn ang="0">
                      <a:pos x="connsiteX109" y="connsiteY109"/>
                    </a:cxn>
                    <a:cxn ang="0">
                      <a:pos x="connsiteX110" y="connsiteY110"/>
                    </a:cxn>
                    <a:cxn ang="0">
                      <a:pos x="connsiteX111" y="connsiteY111"/>
                    </a:cxn>
                    <a:cxn ang="0">
                      <a:pos x="connsiteX112" y="connsiteY112"/>
                    </a:cxn>
                    <a:cxn ang="0">
                      <a:pos x="connsiteX113" y="connsiteY113"/>
                    </a:cxn>
                    <a:cxn ang="0">
                      <a:pos x="connsiteX114" y="connsiteY114"/>
                    </a:cxn>
                    <a:cxn ang="0">
                      <a:pos x="connsiteX115" y="connsiteY115"/>
                    </a:cxn>
                    <a:cxn ang="0">
                      <a:pos x="connsiteX116" y="connsiteY116"/>
                    </a:cxn>
                    <a:cxn ang="0">
                      <a:pos x="connsiteX117" y="connsiteY117"/>
                    </a:cxn>
                    <a:cxn ang="0">
                      <a:pos x="connsiteX118" y="connsiteY118"/>
                    </a:cxn>
                    <a:cxn ang="0">
                      <a:pos x="connsiteX119" y="connsiteY119"/>
                    </a:cxn>
                    <a:cxn ang="0">
                      <a:pos x="connsiteX120" y="connsiteY120"/>
                    </a:cxn>
                    <a:cxn ang="0">
                      <a:pos x="connsiteX121" y="connsiteY121"/>
                    </a:cxn>
                    <a:cxn ang="0">
                      <a:pos x="connsiteX122" y="connsiteY122"/>
                    </a:cxn>
                    <a:cxn ang="0">
                      <a:pos x="connsiteX123" y="connsiteY123"/>
                    </a:cxn>
                    <a:cxn ang="0">
                      <a:pos x="connsiteX124" y="connsiteY124"/>
                    </a:cxn>
                    <a:cxn ang="0">
                      <a:pos x="connsiteX125" y="connsiteY125"/>
                    </a:cxn>
                    <a:cxn ang="0">
                      <a:pos x="connsiteX126" y="connsiteY126"/>
                    </a:cxn>
                    <a:cxn ang="0">
                      <a:pos x="connsiteX127" y="connsiteY127"/>
                    </a:cxn>
                    <a:cxn ang="0">
                      <a:pos x="connsiteX128" y="connsiteY128"/>
                    </a:cxn>
                    <a:cxn ang="0">
                      <a:pos x="connsiteX129" y="connsiteY129"/>
                    </a:cxn>
                    <a:cxn ang="0">
                      <a:pos x="connsiteX130" y="connsiteY130"/>
                    </a:cxn>
                    <a:cxn ang="0">
                      <a:pos x="connsiteX131" y="connsiteY131"/>
                    </a:cxn>
                    <a:cxn ang="0">
                      <a:pos x="connsiteX132" y="connsiteY132"/>
                    </a:cxn>
                    <a:cxn ang="0">
                      <a:pos x="connsiteX133" y="connsiteY133"/>
                    </a:cxn>
                    <a:cxn ang="0">
                      <a:pos x="connsiteX134" y="connsiteY134"/>
                    </a:cxn>
                    <a:cxn ang="0">
                      <a:pos x="connsiteX135" y="connsiteY135"/>
                    </a:cxn>
                    <a:cxn ang="0">
                      <a:pos x="connsiteX136" y="connsiteY136"/>
                    </a:cxn>
                    <a:cxn ang="0">
                      <a:pos x="connsiteX137" y="connsiteY137"/>
                    </a:cxn>
                  </a:cxnLst>
                  <a:rect l="l" t="t" r="r" b="b"/>
                  <a:pathLst>
                    <a:path w="1397257" h="476272">
                      <a:moveTo>
                        <a:pt x="28575" y="466725"/>
                      </a:moveTo>
                      <a:cubicBezTo>
                        <a:pt x="35454" y="463550"/>
                        <a:pt x="43700" y="465917"/>
                        <a:pt x="69850" y="457200"/>
                      </a:cubicBezTo>
                      <a:cubicBezTo>
                        <a:pt x="73025" y="456142"/>
                        <a:pt x="76590" y="455881"/>
                        <a:pt x="79375" y="454025"/>
                      </a:cubicBezTo>
                      <a:cubicBezTo>
                        <a:pt x="82550" y="451908"/>
                        <a:pt x="85314" y="448979"/>
                        <a:pt x="88900" y="447675"/>
                      </a:cubicBezTo>
                      <a:cubicBezTo>
                        <a:pt x="97102" y="444693"/>
                        <a:pt x="105692" y="442760"/>
                        <a:pt x="114300" y="441325"/>
                      </a:cubicBezTo>
                      <a:cubicBezTo>
                        <a:pt x="140732" y="436920"/>
                        <a:pt x="126977" y="439060"/>
                        <a:pt x="155575" y="434975"/>
                      </a:cubicBezTo>
                      <a:cubicBezTo>
                        <a:pt x="161925" y="432858"/>
                        <a:pt x="169056" y="432338"/>
                        <a:pt x="174625" y="428625"/>
                      </a:cubicBezTo>
                      <a:cubicBezTo>
                        <a:pt x="177800" y="426508"/>
                        <a:pt x="180663" y="423825"/>
                        <a:pt x="184150" y="422275"/>
                      </a:cubicBezTo>
                      <a:cubicBezTo>
                        <a:pt x="202496" y="414121"/>
                        <a:pt x="208419" y="416302"/>
                        <a:pt x="228600" y="409575"/>
                      </a:cubicBezTo>
                      <a:cubicBezTo>
                        <a:pt x="273871" y="394485"/>
                        <a:pt x="226761" y="409647"/>
                        <a:pt x="260350" y="400050"/>
                      </a:cubicBezTo>
                      <a:cubicBezTo>
                        <a:pt x="263568" y="399131"/>
                        <a:pt x="266628" y="397687"/>
                        <a:pt x="269875" y="396875"/>
                      </a:cubicBezTo>
                      <a:cubicBezTo>
                        <a:pt x="288002" y="392343"/>
                        <a:pt x="282153" y="395414"/>
                        <a:pt x="298450" y="390525"/>
                      </a:cubicBezTo>
                      <a:cubicBezTo>
                        <a:pt x="304861" y="388602"/>
                        <a:pt x="311150" y="386292"/>
                        <a:pt x="317500" y="384175"/>
                      </a:cubicBezTo>
                      <a:lnTo>
                        <a:pt x="327025" y="381000"/>
                      </a:lnTo>
                      <a:cubicBezTo>
                        <a:pt x="330200" y="379942"/>
                        <a:pt x="333765" y="379681"/>
                        <a:pt x="336550" y="377825"/>
                      </a:cubicBezTo>
                      <a:cubicBezTo>
                        <a:pt x="342900" y="373592"/>
                        <a:pt x="348360" y="367538"/>
                        <a:pt x="355600" y="365125"/>
                      </a:cubicBezTo>
                      <a:cubicBezTo>
                        <a:pt x="387611" y="354455"/>
                        <a:pt x="337958" y="370735"/>
                        <a:pt x="377825" y="358775"/>
                      </a:cubicBezTo>
                      <a:cubicBezTo>
                        <a:pt x="384236" y="356852"/>
                        <a:pt x="390249" y="353372"/>
                        <a:pt x="396875" y="352425"/>
                      </a:cubicBezTo>
                      <a:cubicBezTo>
                        <a:pt x="404283" y="351367"/>
                        <a:pt x="411718" y="350480"/>
                        <a:pt x="419100" y="349250"/>
                      </a:cubicBezTo>
                      <a:cubicBezTo>
                        <a:pt x="424423" y="348363"/>
                        <a:pt x="429582" y="346255"/>
                        <a:pt x="434975" y="346075"/>
                      </a:cubicBezTo>
                      <a:cubicBezTo>
                        <a:pt x="493161" y="344135"/>
                        <a:pt x="551392" y="343958"/>
                        <a:pt x="609600" y="342900"/>
                      </a:cubicBezTo>
                      <a:cubicBezTo>
                        <a:pt x="653917" y="335514"/>
                        <a:pt x="608196" y="343655"/>
                        <a:pt x="641350" y="336550"/>
                      </a:cubicBezTo>
                      <a:cubicBezTo>
                        <a:pt x="649953" y="334707"/>
                        <a:pt x="673718" y="330650"/>
                        <a:pt x="685800" y="327025"/>
                      </a:cubicBezTo>
                      <a:cubicBezTo>
                        <a:pt x="692211" y="325102"/>
                        <a:pt x="698500" y="322792"/>
                        <a:pt x="704850" y="320675"/>
                      </a:cubicBezTo>
                      <a:lnTo>
                        <a:pt x="714375" y="317500"/>
                      </a:lnTo>
                      <a:cubicBezTo>
                        <a:pt x="717550" y="316442"/>
                        <a:pt x="721115" y="316181"/>
                        <a:pt x="723900" y="314325"/>
                      </a:cubicBezTo>
                      <a:cubicBezTo>
                        <a:pt x="727075" y="312208"/>
                        <a:pt x="729938" y="309525"/>
                        <a:pt x="733425" y="307975"/>
                      </a:cubicBezTo>
                      <a:cubicBezTo>
                        <a:pt x="739542" y="305257"/>
                        <a:pt x="752475" y="301625"/>
                        <a:pt x="752475" y="301625"/>
                      </a:cubicBezTo>
                      <a:cubicBezTo>
                        <a:pt x="765175" y="302683"/>
                        <a:pt x="777943" y="303116"/>
                        <a:pt x="790575" y="304800"/>
                      </a:cubicBezTo>
                      <a:cubicBezTo>
                        <a:pt x="793892" y="305242"/>
                        <a:pt x="797487" y="305884"/>
                        <a:pt x="800100" y="307975"/>
                      </a:cubicBezTo>
                      <a:cubicBezTo>
                        <a:pt x="817298" y="321733"/>
                        <a:pt x="794544" y="314325"/>
                        <a:pt x="815975" y="323850"/>
                      </a:cubicBezTo>
                      <a:cubicBezTo>
                        <a:pt x="822092" y="326568"/>
                        <a:pt x="828675" y="328083"/>
                        <a:pt x="835025" y="330200"/>
                      </a:cubicBezTo>
                      <a:cubicBezTo>
                        <a:pt x="838200" y="331258"/>
                        <a:pt x="841303" y="332563"/>
                        <a:pt x="844550" y="333375"/>
                      </a:cubicBezTo>
                      <a:cubicBezTo>
                        <a:pt x="848619" y="334392"/>
                        <a:pt x="862220" y="337448"/>
                        <a:pt x="866775" y="339725"/>
                      </a:cubicBezTo>
                      <a:cubicBezTo>
                        <a:pt x="885328" y="349002"/>
                        <a:pt x="867204" y="343930"/>
                        <a:pt x="885825" y="349250"/>
                      </a:cubicBezTo>
                      <a:cubicBezTo>
                        <a:pt x="890021" y="350449"/>
                        <a:pt x="894329" y="351226"/>
                        <a:pt x="898525" y="352425"/>
                      </a:cubicBezTo>
                      <a:cubicBezTo>
                        <a:pt x="901743" y="353344"/>
                        <a:pt x="904749" y="355050"/>
                        <a:pt x="908050" y="355600"/>
                      </a:cubicBezTo>
                      <a:cubicBezTo>
                        <a:pt x="935084" y="360106"/>
                        <a:pt x="981972" y="360934"/>
                        <a:pt x="1003300" y="361950"/>
                      </a:cubicBezTo>
                      <a:cubicBezTo>
                        <a:pt x="1023408" y="360892"/>
                        <a:pt x="1043572" y="360598"/>
                        <a:pt x="1063625" y="358775"/>
                      </a:cubicBezTo>
                      <a:cubicBezTo>
                        <a:pt x="1066958" y="358472"/>
                        <a:pt x="1069883" y="356326"/>
                        <a:pt x="1073150" y="355600"/>
                      </a:cubicBezTo>
                      <a:cubicBezTo>
                        <a:pt x="1079434" y="354203"/>
                        <a:pt x="1085916" y="353822"/>
                        <a:pt x="1092200" y="352425"/>
                      </a:cubicBezTo>
                      <a:cubicBezTo>
                        <a:pt x="1095467" y="351699"/>
                        <a:pt x="1098507" y="350169"/>
                        <a:pt x="1101725" y="349250"/>
                      </a:cubicBezTo>
                      <a:cubicBezTo>
                        <a:pt x="1105921" y="348051"/>
                        <a:pt x="1110245" y="347329"/>
                        <a:pt x="1114425" y="346075"/>
                      </a:cubicBezTo>
                      <a:cubicBezTo>
                        <a:pt x="1120836" y="344152"/>
                        <a:pt x="1133475" y="339725"/>
                        <a:pt x="1133475" y="339725"/>
                      </a:cubicBezTo>
                      <a:cubicBezTo>
                        <a:pt x="1134533" y="336550"/>
                        <a:pt x="1134876" y="333038"/>
                        <a:pt x="1136650" y="330200"/>
                      </a:cubicBezTo>
                      <a:cubicBezTo>
                        <a:pt x="1140242" y="324453"/>
                        <a:pt x="1144754" y="319304"/>
                        <a:pt x="1149350" y="314325"/>
                      </a:cubicBezTo>
                      <a:cubicBezTo>
                        <a:pt x="1157472" y="305527"/>
                        <a:pt x="1168108" y="298888"/>
                        <a:pt x="1174750" y="288925"/>
                      </a:cubicBezTo>
                      <a:lnTo>
                        <a:pt x="1187450" y="269875"/>
                      </a:lnTo>
                      <a:cubicBezTo>
                        <a:pt x="1189567" y="266700"/>
                        <a:pt x="1191102" y="263048"/>
                        <a:pt x="1193800" y="260350"/>
                      </a:cubicBezTo>
                      <a:lnTo>
                        <a:pt x="1203325" y="250825"/>
                      </a:lnTo>
                      <a:cubicBezTo>
                        <a:pt x="1205442" y="244475"/>
                        <a:pt x="1205962" y="237344"/>
                        <a:pt x="1209675" y="231775"/>
                      </a:cubicBezTo>
                      <a:cubicBezTo>
                        <a:pt x="1241773" y="183627"/>
                        <a:pt x="1207031" y="233043"/>
                        <a:pt x="1231900" y="203200"/>
                      </a:cubicBezTo>
                      <a:cubicBezTo>
                        <a:pt x="1234343" y="200269"/>
                        <a:pt x="1235378" y="196188"/>
                        <a:pt x="1238250" y="193675"/>
                      </a:cubicBezTo>
                      <a:cubicBezTo>
                        <a:pt x="1243993" y="188649"/>
                        <a:pt x="1251904" y="186371"/>
                        <a:pt x="1257300" y="180975"/>
                      </a:cubicBezTo>
                      <a:cubicBezTo>
                        <a:pt x="1272221" y="166054"/>
                        <a:pt x="1263089" y="173941"/>
                        <a:pt x="1285875" y="158750"/>
                      </a:cubicBezTo>
                      <a:cubicBezTo>
                        <a:pt x="1289050" y="156633"/>
                        <a:pt x="1291987" y="154107"/>
                        <a:pt x="1295400" y="152400"/>
                      </a:cubicBezTo>
                      <a:cubicBezTo>
                        <a:pt x="1299633" y="150283"/>
                        <a:pt x="1303750" y="147914"/>
                        <a:pt x="1308100" y="146050"/>
                      </a:cubicBezTo>
                      <a:cubicBezTo>
                        <a:pt x="1311176" y="144732"/>
                        <a:pt x="1314699" y="144500"/>
                        <a:pt x="1317625" y="142875"/>
                      </a:cubicBezTo>
                      <a:cubicBezTo>
                        <a:pt x="1324296" y="139169"/>
                        <a:pt x="1329435" y="132588"/>
                        <a:pt x="1336675" y="130175"/>
                      </a:cubicBezTo>
                      <a:cubicBezTo>
                        <a:pt x="1339850" y="129117"/>
                        <a:pt x="1343274" y="128625"/>
                        <a:pt x="1346200" y="127000"/>
                      </a:cubicBezTo>
                      <a:cubicBezTo>
                        <a:pt x="1352871" y="123294"/>
                        <a:pt x="1359854" y="119696"/>
                        <a:pt x="1365250" y="114300"/>
                      </a:cubicBezTo>
                      <a:cubicBezTo>
                        <a:pt x="1368425" y="111125"/>
                        <a:pt x="1371039" y="107266"/>
                        <a:pt x="1374775" y="104775"/>
                      </a:cubicBezTo>
                      <a:cubicBezTo>
                        <a:pt x="1377560" y="102919"/>
                        <a:pt x="1381307" y="103097"/>
                        <a:pt x="1384300" y="101600"/>
                      </a:cubicBezTo>
                      <a:cubicBezTo>
                        <a:pt x="1387713" y="99893"/>
                        <a:pt x="1390650" y="97367"/>
                        <a:pt x="1393825" y="95250"/>
                      </a:cubicBezTo>
                      <a:cubicBezTo>
                        <a:pt x="1400653" y="74766"/>
                        <a:pt x="1395464" y="96684"/>
                        <a:pt x="1393825" y="76200"/>
                      </a:cubicBezTo>
                      <a:cubicBezTo>
                        <a:pt x="1387789" y="746"/>
                        <a:pt x="1410483" y="19572"/>
                        <a:pt x="1381125" y="0"/>
                      </a:cubicBezTo>
                      <a:cubicBezTo>
                        <a:pt x="1377304" y="347"/>
                        <a:pt x="1347431" y="375"/>
                        <a:pt x="1336675" y="6350"/>
                      </a:cubicBezTo>
                      <a:cubicBezTo>
                        <a:pt x="1330004" y="10056"/>
                        <a:pt x="1323975" y="14817"/>
                        <a:pt x="1317625" y="19050"/>
                      </a:cubicBezTo>
                      <a:cubicBezTo>
                        <a:pt x="1314450" y="21167"/>
                        <a:pt x="1311720" y="24193"/>
                        <a:pt x="1308100" y="25400"/>
                      </a:cubicBezTo>
                      <a:lnTo>
                        <a:pt x="1289050" y="31750"/>
                      </a:lnTo>
                      <a:cubicBezTo>
                        <a:pt x="1285875" y="32808"/>
                        <a:pt x="1282310" y="33069"/>
                        <a:pt x="1279525" y="34925"/>
                      </a:cubicBezTo>
                      <a:cubicBezTo>
                        <a:pt x="1276350" y="37042"/>
                        <a:pt x="1273487" y="39725"/>
                        <a:pt x="1270000" y="41275"/>
                      </a:cubicBezTo>
                      <a:cubicBezTo>
                        <a:pt x="1263883" y="43993"/>
                        <a:pt x="1257300" y="45508"/>
                        <a:pt x="1250950" y="47625"/>
                      </a:cubicBezTo>
                      <a:lnTo>
                        <a:pt x="1231900" y="53975"/>
                      </a:lnTo>
                      <a:cubicBezTo>
                        <a:pt x="1228725" y="55033"/>
                        <a:pt x="1225160" y="55294"/>
                        <a:pt x="1222375" y="57150"/>
                      </a:cubicBezTo>
                      <a:cubicBezTo>
                        <a:pt x="1219200" y="59267"/>
                        <a:pt x="1216337" y="61950"/>
                        <a:pt x="1212850" y="63500"/>
                      </a:cubicBezTo>
                      <a:cubicBezTo>
                        <a:pt x="1206733" y="66218"/>
                        <a:pt x="1200150" y="67733"/>
                        <a:pt x="1193800" y="69850"/>
                      </a:cubicBezTo>
                      <a:cubicBezTo>
                        <a:pt x="1190625" y="70908"/>
                        <a:pt x="1187522" y="72213"/>
                        <a:pt x="1184275" y="73025"/>
                      </a:cubicBezTo>
                      <a:cubicBezTo>
                        <a:pt x="1180042" y="74083"/>
                        <a:pt x="1175755" y="74946"/>
                        <a:pt x="1171575" y="76200"/>
                      </a:cubicBezTo>
                      <a:cubicBezTo>
                        <a:pt x="1165164" y="78123"/>
                        <a:pt x="1158094" y="78837"/>
                        <a:pt x="1152525" y="82550"/>
                      </a:cubicBezTo>
                      <a:cubicBezTo>
                        <a:pt x="1129319" y="98021"/>
                        <a:pt x="1158498" y="79137"/>
                        <a:pt x="1130300" y="95250"/>
                      </a:cubicBezTo>
                      <a:cubicBezTo>
                        <a:pt x="1126987" y="97143"/>
                        <a:pt x="1124188" y="99893"/>
                        <a:pt x="1120775" y="101600"/>
                      </a:cubicBezTo>
                      <a:cubicBezTo>
                        <a:pt x="1117782" y="103097"/>
                        <a:pt x="1114243" y="103278"/>
                        <a:pt x="1111250" y="104775"/>
                      </a:cubicBezTo>
                      <a:cubicBezTo>
                        <a:pt x="1107837" y="106482"/>
                        <a:pt x="1105138" y="109418"/>
                        <a:pt x="1101725" y="111125"/>
                      </a:cubicBezTo>
                      <a:cubicBezTo>
                        <a:pt x="1098732" y="112622"/>
                        <a:pt x="1095126" y="112675"/>
                        <a:pt x="1092200" y="114300"/>
                      </a:cubicBezTo>
                      <a:cubicBezTo>
                        <a:pt x="1085529" y="118006"/>
                        <a:pt x="1073150" y="127000"/>
                        <a:pt x="1073150" y="127000"/>
                      </a:cubicBezTo>
                      <a:cubicBezTo>
                        <a:pt x="1068917" y="133350"/>
                        <a:pt x="1062863" y="138810"/>
                        <a:pt x="1060450" y="146050"/>
                      </a:cubicBezTo>
                      <a:cubicBezTo>
                        <a:pt x="1056068" y="159195"/>
                        <a:pt x="1059131" y="152790"/>
                        <a:pt x="1050925" y="165100"/>
                      </a:cubicBezTo>
                      <a:cubicBezTo>
                        <a:pt x="1049867" y="169333"/>
                        <a:pt x="1049469" y="173789"/>
                        <a:pt x="1047750" y="177800"/>
                      </a:cubicBezTo>
                      <a:cubicBezTo>
                        <a:pt x="1046247" y="181307"/>
                        <a:pt x="1042522" y="183678"/>
                        <a:pt x="1041400" y="187325"/>
                      </a:cubicBezTo>
                      <a:cubicBezTo>
                        <a:pt x="1038226" y="197641"/>
                        <a:pt x="1044030" y="213088"/>
                        <a:pt x="1035050" y="219075"/>
                      </a:cubicBezTo>
                      <a:lnTo>
                        <a:pt x="1016000" y="231775"/>
                      </a:lnTo>
                      <a:cubicBezTo>
                        <a:pt x="1012825" y="233892"/>
                        <a:pt x="1010095" y="236918"/>
                        <a:pt x="1006475" y="238125"/>
                      </a:cubicBezTo>
                      <a:lnTo>
                        <a:pt x="987425" y="244475"/>
                      </a:lnTo>
                      <a:cubicBezTo>
                        <a:pt x="964142" y="243417"/>
                        <a:pt x="940808" y="243159"/>
                        <a:pt x="917575" y="241300"/>
                      </a:cubicBezTo>
                      <a:cubicBezTo>
                        <a:pt x="906984" y="240453"/>
                        <a:pt x="907922" y="235952"/>
                        <a:pt x="898525" y="231775"/>
                      </a:cubicBezTo>
                      <a:cubicBezTo>
                        <a:pt x="892408" y="229057"/>
                        <a:pt x="885825" y="227542"/>
                        <a:pt x="879475" y="225425"/>
                      </a:cubicBezTo>
                      <a:cubicBezTo>
                        <a:pt x="876300" y="224367"/>
                        <a:pt x="872735" y="224106"/>
                        <a:pt x="869950" y="222250"/>
                      </a:cubicBezTo>
                      <a:cubicBezTo>
                        <a:pt x="863600" y="218017"/>
                        <a:pt x="858140" y="211963"/>
                        <a:pt x="850900" y="209550"/>
                      </a:cubicBezTo>
                      <a:lnTo>
                        <a:pt x="831850" y="203200"/>
                      </a:lnTo>
                      <a:cubicBezTo>
                        <a:pt x="828675" y="202142"/>
                        <a:pt x="825110" y="201881"/>
                        <a:pt x="822325" y="200025"/>
                      </a:cubicBezTo>
                      <a:cubicBezTo>
                        <a:pt x="808310" y="190682"/>
                        <a:pt x="816542" y="194423"/>
                        <a:pt x="796925" y="190500"/>
                      </a:cubicBezTo>
                      <a:lnTo>
                        <a:pt x="777875" y="177800"/>
                      </a:lnTo>
                      <a:cubicBezTo>
                        <a:pt x="774700" y="175683"/>
                        <a:pt x="772052" y="172375"/>
                        <a:pt x="768350" y="171450"/>
                      </a:cubicBezTo>
                      <a:cubicBezTo>
                        <a:pt x="759883" y="169333"/>
                        <a:pt x="751558" y="166535"/>
                        <a:pt x="742950" y="165100"/>
                      </a:cubicBezTo>
                      <a:cubicBezTo>
                        <a:pt x="718577" y="161038"/>
                        <a:pt x="730213" y="163188"/>
                        <a:pt x="708025" y="158750"/>
                      </a:cubicBezTo>
                      <a:cubicBezTo>
                        <a:pt x="692150" y="159808"/>
                        <a:pt x="676116" y="159444"/>
                        <a:pt x="660400" y="161925"/>
                      </a:cubicBezTo>
                      <a:cubicBezTo>
                        <a:pt x="655725" y="162663"/>
                        <a:pt x="652050" y="166411"/>
                        <a:pt x="647700" y="168275"/>
                      </a:cubicBezTo>
                      <a:cubicBezTo>
                        <a:pt x="644624" y="169593"/>
                        <a:pt x="641350" y="170392"/>
                        <a:pt x="638175" y="171450"/>
                      </a:cubicBezTo>
                      <a:cubicBezTo>
                        <a:pt x="635000" y="174625"/>
                        <a:pt x="632099" y="178100"/>
                        <a:pt x="628650" y="180975"/>
                      </a:cubicBezTo>
                      <a:cubicBezTo>
                        <a:pt x="625719" y="183418"/>
                        <a:pt x="621823" y="184627"/>
                        <a:pt x="619125" y="187325"/>
                      </a:cubicBezTo>
                      <a:cubicBezTo>
                        <a:pt x="616427" y="190023"/>
                        <a:pt x="614993" y="193745"/>
                        <a:pt x="612775" y="196850"/>
                      </a:cubicBezTo>
                      <a:cubicBezTo>
                        <a:pt x="609699" y="201156"/>
                        <a:pt x="606992" y="205808"/>
                        <a:pt x="603250" y="209550"/>
                      </a:cubicBezTo>
                      <a:cubicBezTo>
                        <a:pt x="600552" y="212248"/>
                        <a:pt x="596900" y="213783"/>
                        <a:pt x="593725" y="215900"/>
                      </a:cubicBezTo>
                      <a:cubicBezTo>
                        <a:pt x="582083" y="233362"/>
                        <a:pt x="593725" y="218546"/>
                        <a:pt x="577850" y="231775"/>
                      </a:cubicBezTo>
                      <a:cubicBezTo>
                        <a:pt x="566892" y="240907"/>
                        <a:pt x="565324" y="248650"/>
                        <a:pt x="549275" y="254000"/>
                      </a:cubicBezTo>
                      <a:cubicBezTo>
                        <a:pt x="542925" y="256117"/>
                        <a:pt x="536867" y="259520"/>
                        <a:pt x="530225" y="260350"/>
                      </a:cubicBezTo>
                      <a:cubicBezTo>
                        <a:pt x="494271" y="264844"/>
                        <a:pt x="513315" y="262676"/>
                        <a:pt x="473075" y="266700"/>
                      </a:cubicBezTo>
                      <a:cubicBezTo>
                        <a:pt x="469900" y="267758"/>
                        <a:pt x="466892" y="270051"/>
                        <a:pt x="463550" y="269875"/>
                      </a:cubicBezTo>
                      <a:cubicBezTo>
                        <a:pt x="446508" y="268978"/>
                        <a:pt x="412750" y="263525"/>
                        <a:pt x="412750" y="263525"/>
                      </a:cubicBezTo>
                      <a:lnTo>
                        <a:pt x="250825" y="266700"/>
                      </a:lnTo>
                      <a:cubicBezTo>
                        <a:pt x="244541" y="266917"/>
                        <a:pt x="227089" y="269043"/>
                        <a:pt x="219075" y="273050"/>
                      </a:cubicBezTo>
                      <a:cubicBezTo>
                        <a:pt x="212358" y="276408"/>
                        <a:pt x="202603" y="285330"/>
                        <a:pt x="196850" y="288925"/>
                      </a:cubicBezTo>
                      <a:cubicBezTo>
                        <a:pt x="192836" y="291433"/>
                        <a:pt x="188259" y="292927"/>
                        <a:pt x="184150" y="295275"/>
                      </a:cubicBezTo>
                      <a:cubicBezTo>
                        <a:pt x="180837" y="297168"/>
                        <a:pt x="177938" y="299732"/>
                        <a:pt x="174625" y="301625"/>
                      </a:cubicBezTo>
                      <a:cubicBezTo>
                        <a:pt x="160434" y="309734"/>
                        <a:pt x="165353" y="306293"/>
                        <a:pt x="152400" y="311150"/>
                      </a:cubicBezTo>
                      <a:cubicBezTo>
                        <a:pt x="128488" y="320117"/>
                        <a:pt x="145105" y="315355"/>
                        <a:pt x="123825" y="320675"/>
                      </a:cubicBezTo>
                      <a:cubicBezTo>
                        <a:pt x="120650" y="322792"/>
                        <a:pt x="117886" y="325721"/>
                        <a:pt x="114300" y="327025"/>
                      </a:cubicBezTo>
                      <a:cubicBezTo>
                        <a:pt x="103616" y="330910"/>
                        <a:pt x="90291" y="331872"/>
                        <a:pt x="79375" y="336550"/>
                      </a:cubicBezTo>
                      <a:cubicBezTo>
                        <a:pt x="75025" y="338414"/>
                        <a:pt x="71069" y="341142"/>
                        <a:pt x="66675" y="342900"/>
                      </a:cubicBezTo>
                      <a:cubicBezTo>
                        <a:pt x="60460" y="345386"/>
                        <a:pt x="53194" y="345537"/>
                        <a:pt x="47625" y="349250"/>
                      </a:cubicBezTo>
                      <a:cubicBezTo>
                        <a:pt x="44450" y="351367"/>
                        <a:pt x="41587" y="354050"/>
                        <a:pt x="38100" y="355600"/>
                      </a:cubicBezTo>
                      <a:lnTo>
                        <a:pt x="9525" y="365125"/>
                      </a:lnTo>
                      <a:lnTo>
                        <a:pt x="0" y="368300"/>
                      </a:lnTo>
                      <a:cubicBezTo>
                        <a:pt x="8057" y="392470"/>
                        <a:pt x="5037" y="380786"/>
                        <a:pt x="9525" y="403225"/>
                      </a:cubicBezTo>
                      <a:cubicBezTo>
                        <a:pt x="10583" y="419100"/>
                        <a:pt x="10450" y="435100"/>
                        <a:pt x="12700" y="450850"/>
                      </a:cubicBezTo>
                      <a:cubicBezTo>
                        <a:pt x="13995" y="459912"/>
                        <a:pt x="17051" y="473945"/>
                        <a:pt x="28575" y="476250"/>
                      </a:cubicBezTo>
                      <a:cubicBezTo>
                        <a:pt x="30896" y="476714"/>
                        <a:pt x="21696" y="469900"/>
                        <a:pt x="28575" y="466725"/>
                      </a:cubicBezTo>
                      <a:close/>
                    </a:path>
                  </a:pathLst>
                </a:custGeom>
                <a:noFill/>
                <a:ln>
                  <a:solidFill>
                    <a:srgbClr val="00B0F0"/>
                  </a:solidFill>
                  <a:prstDash val="dash"/>
                  <a:extLst>
                    <a:ext uri="{C807C97D-BFC1-408E-A445-0C87EB9F89A2}">
                      <ask:lineSketchStyleProps xmlns:ask="http://schemas.microsoft.com/office/drawing/2018/sketchyshapes" xmlns="" sd="1219033472">
                        <a:custGeom>
                          <a:avLst/>
                          <a:gdLst>
                            <a:gd name="connsiteX0" fmla="*/ 28194 w 1378659"/>
                            <a:gd name="connsiteY0" fmla="*/ 466703 h 476250"/>
                            <a:gd name="connsiteX1" fmla="*/ 68920 w 1378659"/>
                            <a:gd name="connsiteY1" fmla="*/ 457178 h 476250"/>
                            <a:gd name="connsiteX2" fmla="*/ 78318 w 1378659"/>
                            <a:gd name="connsiteY2" fmla="*/ 454004 h 476250"/>
                            <a:gd name="connsiteX3" fmla="*/ 87716 w 1378659"/>
                            <a:gd name="connsiteY3" fmla="*/ 447654 h 476250"/>
                            <a:gd name="connsiteX4" fmla="*/ 112778 w 1378659"/>
                            <a:gd name="connsiteY4" fmla="*/ 441304 h 476250"/>
                            <a:gd name="connsiteX5" fmla="*/ 153504 w 1378659"/>
                            <a:gd name="connsiteY5" fmla="*/ 434954 h 476250"/>
                            <a:gd name="connsiteX6" fmla="*/ 172300 w 1378659"/>
                            <a:gd name="connsiteY6" fmla="*/ 428605 h 476250"/>
                            <a:gd name="connsiteX7" fmla="*/ 181698 w 1378659"/>
                            <a:gd name="connsiteY7" fmla="*/ 422255 h 476250"/>
                            <a:gd name="connsiteX8" fmla="*/ 225557 w 1378659"/>
                            <a:gd name="connsiteY8" fmla="*/ 409556 h 476250"/>
                            <a:gd name="connsiteX9" fmla="*/ 256884 w 1378659"/>
                            <a:gd name="connsiteY9" fmla="*/ 400031 h 476250"/>
                            <a:gd name="connsiteX10" fmla="*/ 266282 w 1378659"/>
                            <a:gd name="connsiteY10" fmla="*/ 396856 h 476250"/>
                            <a:gd name="connsiteX11" fmla="*/ 294477 w 1378659"/>
                            <a:gd name="connsiteY11" fmla="*/ 390506 h 476250"/>
                            <a:gd name="connsiteX12" fmla="*/ 313273 w 1378659"/>
                            <a:gd name="connsiteY12" fmla="*/ 384157 h 476250"/>
                            <a:gd name="connsiteX13" fmla="*/ 322672 w 1378659"/>
                            <a:gd name="connsiteY13" fmla="*/ 380982 h 476250"/>
                            <a:gd name="connsiteX14" fmla="*/ 332070 w 1378659"/>
                            <a:gd name="connsiteY14" fmla="*/ 377807 h 476250"/>
                            <a:gd name="connsiteX15" fmla="*/ 350866 w 1378659"/>
                            <a:gd name="connsiteY15" fmla="*/ 365108 h 476250"/>
                            <a:gd name="connsiteX16" fmla="*/ 372796 w 1378659"/>
                            <a:gd name="connsiteY16" fmla="*/ 358758 h 476250"/>
                            <a:gd name="connsiteX17" fmla="*/ 391592 w 1378659"/>
                            <a:gd name="connsiteY17" fmla="*/ 352408 h 476250"/>
                            <a:gd name="connsiteX18" fmla="*/ 413521 w 1378659"/>
                            <a:gd name="connsiteY18" fmla="*/ 349233 h 476250"/>
                            <a:gd name="connsiteX19" fmla="*/ 429185 w 1378659"/>
                            <a:gd name="connsiteY19" fmla="*/ 346059 h 476250"/>
                            <a:gd name="connsiteX20" fmla="*/ 601486 w 1378659"/>
                            <a:gd name="connsiteY20" fmla="*/ 342884 h 476250"/>
                            <a:gd name="connsiteX21" fmla="*/ 632813 w 1378659"/>
                            <a:gd name="connsiteY21" fmla="*/ 336534 h 476250"/>
                            <a:gd name="connsiteX22" fmla="*/ 676671 w 1378659"/>
                            <a:gd name="connsiteY22" fmla="*/ 327009 h 476250"/>
                            <a:gd name="connsiteX23" fmla="*/ 695468 w 1378659"/>
                            <a:gd name="connsiteY23" fmla="*/ 320660 h 476250"/>
                            <a:gd name="connsiteX24" fmla="*/ 704866 w 1378659"/>
                            <a:gd name="connsiteY24" fmla="*/ 317485 h 476250"/>
                            <a:gd name="connsiteX25" fmla="*/ 714264 w 1378659"/>
                            <a:gd name="connsiteY25" fmla="*/ 314310 h 476250"/>
                            <a:gd name="connsiteX26" fmla="*/ 723662 w 1378659"/>
                            <a:gd name="connsiteY26" fmla="*/ 307960 h 476250"/>
                            <a:gd name="connsiteX27" fmla="*/ 742459 w 1378659"/>
                            <a:gd name="connsiteY27" fmla="*/ 301611 h 476250"/>
                            <a:gd name="connsiteX28" fmla="*/ 780052 w 1378659"/>
                            <a:gd name="connsiteY28" fmla="*/ 304785 h 476250"/>
                            <a:gd name="connsiteX29" fmla="*/ 789450 w 1378659"/>
                            <a:gd name="connsiteY29" fmla="*/ 307960 h 476250"/>
                            <a:gd name="connsiteX30" fmla="*/ 805114 w 1378659"/>
                            <a:gd name="connsiteY30" fmla="*/ 323835 h 476250"/>
                            <a:gd name="connsiteX31" fmla="*/ 823910 w 1378659"/>
                            <a:gd name="connsiteY31" fmla="*/ 330184 h 476250"/>
                            <a:gd name="connsiteX32" fmla="*/ 833308 w 1378659"/>
                            <a:gd name="connsiteY32" fmla="*/ 333359 h 476250"/>
                            <a:gd name="connsiteX33" fmla="*/ 855237 w 1378659"/>
                            <a:gd name="connsiteY33" fmla="*/ 339709 h 476250"/>
                            <a:gd name="connsiteX34" fmla="*/ 874034 w 1378659"/>
                            <a:gd name="connsiteY34" fmla="*/ 349233 h 476250"/>
                            <a:gd name="connsiteX35" fmla="*/ 886565 w 1378659"/>
                            <a:gd name="connsiteY35" fmla="*/ 352408 h 476250"/>
                            <a:gd name="connsiteX36" fmla="*/ 895963 w 1378659"/>
                            <a:gd name="connsiteY36" fmla="*/ 355583 h 476250"/>
                            <a:gd name="connsiteX37" fmla="*/ 989945 w 1378659"/>
                            <a:gd name="connsiteY37" fmla="*/ 361933 h 476250"/>
                            <a:gd name="connsiteX38" fmla="*/ 1049467 w 1378659"/>
                            <a:gd name="connsiteY38" fmla="*/ 358758 h 476250"/>
                            <a:gd name="connsiteX39" fmla="*/ 1058865 w 1378659"/>
                            <a:gd name="connsiteY39" fmla="*/ 355583 h 476250"/>
                            <a:gd name="connsiteX40" fmla="*/ 1077662 w 1378659"/>
                            <a:gd name="connsiteY40" fmla="*/ 352408 h 476250"/>
                            <a:gd name="connsiteX41" fmla="*/ 1087060 w 1378659"/>
                            <a:gd name="connsiteY41" fmla="*/ 349233 h 476250"/>
                            <a:gd name="connsiteX42" fmla="*/ 1099591 w 1378659"/>
                            <a:gd name="connsiteY42" fmla="*/ 346059 h 476250"/>
                            <a:gd name="connsiteX43" fmla="*/ 1118388 w 1378659"/>
                            <a:gd name="connsiteY43" fmla="*/ 339709 h 476250"/>
                            <a:gd name="connsiteX44" fmla="*/ 1121520 w 1378659"/>
                            <a:gd name="connsiteY44" fmla="*/ 330184 h 476250"/>
                            <a:gd name="connsiteX45" fmla="*/ 1134051 w 1378659"/>
                            <a:gd name="connsiteY45" fmla="*/ 314310 h 476250"/>
                            <a:gd name="connsiteX46" fmla="*/ 1159113 w 1378659"/>
                            <a:gd name="connsiteY46" fmla="*/ 288911 h 476250"/>
                            <a:gd name="connsiteX47" fmla="*/ 1171644 w 1378659"/>
                            <a:gd name="connsiteY47" fmla="*/ 269862 h 476250"/>
                            <a:gd name="connsiteX48" fmla="*/ 1177910 w 1378659"/>
                            <a:gd name="connsiteY48" fmla="*/ 260337 h 476250"/>
                            <a:gd name="connsiteX49" fmla="*/ 1187308 w 1378659"/>
                            <a:gd name="connsiteY49" fmla="*/ 250813 h 476250"/>
                            <a:gd name="connsiteX50" fmla="*/ 1193573 w 1378659"/>
                            <a:gd name="connsiteY50" fmla="*/ 231764 h 476250"/>
                            <a:gd name="connsiteX51" fmla="*/ 1215502 w 1378659"/>
                            <a:gd name="connsiteY51" fmla="*/ 203190 h 476250"/>
                            <a:gd name="connsiteX52" fmla="*/ 1221768 w 1378659"/>
                            <a:gd name="connsiteY52" fmla="*/ 193666 h 476250"/>
                            <a:gd name="connsiteX53" fmla="*/ 1240564 w 1378659"/>
                            <a:gd name="connsiteY53" fmla="*/ 180966 h 476250"/>
                            <a:gd name="connsiteX54" fmla="*/ 1268759 w 1378659"/>
                            <a:gd name="connsiteY54" fmla="*/ 158742 h 476250"/>
                            <a:gd name="connsiteX55" fmla="*/ 1278157 w 1378659"/>
                            <a:gd name="connsiteY55" fmla="*/ 152392 h 476250"/>
                            <a:gd name="connsiteX56" fmla="*/ 1290688 w 1378659"/>
                            <a:gd name="connsiteY56" fmla="*/ 146043 h 476250"/>
                            <a:gd name="connsiteX57" fmla="*/ 1300086 w 1378659"/>
                            <a:gd name="connsiteY57" fmla="*/ 142868 h 476250"/>
                            <a:gd name="connsiteX58" fmla="*/ 1318883 w 1378659"/>
                            <a:gd name="connsiteY58" fmla="*/ 130168 h 476250"/>
                            <a:gd name="connsiteX59" fmla="*/ 1328281 w 1378659"/>
                            <a:gd name="connsiteY59" fmla="*/ 126994 h 476250"/>
                            <a:gd name="connsiteX60" fmla="*/ 1347078 w 1378659"/>
                            <a:gd name="connsiteY60" fmla="*/ 114294 h 476250"/>
                            <a:gd name="connsiteX61" fmla="*/ 1356476 w 1378659"/>
                            <a:gd name="connsiteY61" fmla="*/ 104770 h 476250"/>
                            <a:gd name="connsiteX62" fmla="*/ 1365874 w 1378659"/>
                            <a:gd name="connsiteY62" fmla="*/ 101595 h 476250"/>
                            <a:gd name="connsiteX63" fmla="*/ 1375272 w 1378659"/>
                            <a:gd name="connsiteY63" fmla="*/ 95245 h 476250"/>
                            <a:gd name="connsiteX64" fmla="*/ 1375272 w 1378659"/>
                            <a:gd name="connsiteY64" fmla="*/ 76196 h 476250"/>
                            <a:gd name="connsiteX65" fmla="*/ 1362741 w 1378659"/>
                            <a:gd name="connsiteY65" fmla="*/ 0 h 476250"/>
                            <a:gd name="connsiteX66" fmla="*/ 1318883 w 1378659"/>
                            <a:gd name="connsiteY66" fmla="*/ 6349 h 476250"/>
                            <a:gd name="connsiteX67" fmla="*/ 1300086 w 1378659"/>
                            <a:gd name="connsiteY67" fmla="*/ 19049 h 476250"/>
                            <a:gd name="connsiteX68" fmla="*/ 1290688 w 1378659"/>
                            <a:gd name="connsiteY68" fmla="*/ 25398 h 476250"/>
                            <a:gd name="connsiteX69" fmla="*/ 1271892 w 1378659"/>
                            <a:gd name="connsiteY69" fmla="*/ 31748 h 476250"/>
                            <a:gd name="connsiteX70" fmla="*/ 1262494 w 1378659"/>
                            <a:gd name="connsiteY70" fmla="*/ 34923 h 476250"/>
                            <a:gd name="connsiteX71" fmla="*/ 1253095 w 1378659"/>
                            <a:gd name="connsiteY71" fmla="*/ 41273 h 476250"/>
                            <a:gd name="connsiteX72" fmla="*/ 1234299 w 1378659"/>
                            <a:gd name="connsiteY72" fmla="*/ 47622 h 476250"/>
                            <a:gd name="connsiteX73" fmla="*/ 1215502 w 1378659"/>
                            <a:gd name="connsiteY73" fmla="*/ 53972 h 476250"/>
                            <a:gd name="connsiteX74" fmla="*/ 1206104 w 1378659"/>
                            <a:gd name="connsiteY74" fmla="*/ 57147 h 476250"/>
                            <a:gd name="connsiteX75" fmla="*/ 1196706 w 1378659"/>
                            <a:gd name="connsiteY75" fmla="*/ 63497 h 476250"/>
                            <a:gd name="connsiteX76" fmla="*/ 1177910 w 1378659"/>
                            <a:gd name="connsiteY76" fmla="*/ 69846 h 476250"/>
                            <a:gd name="connsiteX77" fmla="*/ 1168511 w 1378659"/>
                            <a:gd name="connsiteY77" fmla="*/ 73021 h 476250"/>
                            <a:gd name="connsiteX78" fmla="*/ 1155980 w 1378659"/>
                            <a:gd name="connsiteY78" fmla="*/ 76196 h 476250"/>
                            <a:gd name="connsiteX79" fmla="*/ 1137184 w 1378659"/>
                            <a:gd name="connsiteY79" fmla="*/ 82546 h 476250"/>
                            <a:gd name="connsiteX80" fmla="*/ 1115255 w 1378659"/>
                            <a:gd name="connsiteY80" fmla="*/ 95245 h 476250"/>
                            <a:gd name="connsiteX81" fmla="*/ 1105857 w 1378659"/>
                            <a:gd name="connsiteY81" fmla="*/ 101595 h 476250"/>
                            <a:gd name="connsiteX82" fmla="*/ 1096458 w 1378659"/>
                            <a:gd name="connsiteY82" fmla="*/ 104770 h 476250"/>
                            <a:gd name="connsiteX83" fmla="*/ 1087060 w 1378659"/>
                            <a:gd name="connsiteY83" fmla="*/ 111119 h 476250"/>
                            <a:gd name="connsiteX84" fmla="*/ 1077662 w 1378659"/>
                            <a:gd name="connsiteY84" fmla="*/ 114294 h 476250"/>
                            <a:gd name="connsiteX85" fmla="*/ 1058865 w 1378659"/>
                            <a:gd name="connsiteY85" fmla="*/ 126994 h 476250"/>
                            <a:gd name="connsiteX86" fmla="*/ 1046335 w 1378659"/>
                            <a:gd name="connsiteY86" fmla="*/ 146043 h 476250"/>
                            <a:gd name="connsiteX87" fmla="*/ 1036936 w 1378659"/>
                            <a:gd name="connsiteY87" fmla="*/ 165092 h 476250"/>
                            <a:gd name="connsiteX88" fmla="*/ 1033804 w 1378659"/>
                            <a:gd name="connsiteY88" fmla="*/ 177791 h 476250"/>
                            <a:gd name="connsiteX89" fmla="*/ 1027538 w 1378659"/>
                            <a:gd name="connsiteY89" fmla="*/ 187316 h 476250"/>
                            <a:gd name="connsiteX90" fmla="*/ 1021273 w 1378659"/>
                            <a:gd name="connsiteY90" fmla="*/ 219064 h 476250"/>
                            <a:gd name="connsiteX91" fmla="*/ 1002476 w 1378659"/>
                            <a:gd name="connsiteY91" fmla="*/ 231764 h 476250"/>
                            <a:gd name="connsiteX92" fmla="*/ 993078 w 1378659"/>
                            <a:gd name="connsiteY92" fmla="*/ 238114 h 476250"/>
                            <a:gd name="connsiteX93" fmla="*/ 974282 w 1378659"/>
                            <a:gd name="connsiteY93" fmla="*/ 244463 h 476250"/>
                            <a:gd name="connsiteX94" fmla="*/ 905361 w 1378659"/>
                            <a:gd name="connsiteY94" fmla="*/ 241288 h 476250"/>
                            <a:gd name="connsiteX95" fmla="*/ 886565 w 1378659"/>
                            <a:gd name="connsiteY95" fmla="*/ 231764 h 476250"/>
                            <a:gd name="connsiteX96" fmla="*/ 867768 w 1378659"/>
                            <a:gd name="connsiteY96" fmla="*/ 225414 h 476250"/>
                            <a:gd name="connsiteX97" fmla="*/ 858370 w 1378659"/>
                            <a:gd name="connsiteY97" fmla="*/ 222239 h 476250"/>
                            <a:gd name="connsiteX98" fmla="*/ 839574 w 1378659"/>
                            <a:gd name="connsiteY98" fmla="*/ 209540 h 476250"/>
                            <a:gd name="connsiteX99" fmla="*/ 820777 w 1378659"/>
                            <a:gd name="connsiteY99" fmla="*/ 203190 h 476250"/>
                            <a:gd name="connsiteX100" fmla="*/ 811379 w 1378659"/>
                            <a:gd name="connsiteY100" fmla="*/ 200015 h 476250"/>
                            <a:gd name="connsiteX101" fmla="*/ 786317 w 1378659"/>
                            <a:gd name="connsiteY101" fmla="*/ 190491 h 476250"/>
                            <a:gd name="connsiteX102" fmla="*/ 767521 w 1378659"/>
                            <a:gd name="connsiteY102" fmla="*/ 177791 h 476250"/>
                            <a:gd name="connsiteX103" fmla="*/ 758122 w 1378659"/>
                            <a:gd name="connsiteY103" fmla="*/ 171442 h 476250"/>
                            <a:gd name="connsiteX104" fmla="*/ 733061 w 1378659"/>
                            <a:gd name="connsiteY104" fmla="*/ 165092 h 476250"/>
                            <a:gd name="connsiteX105" fmla="*/ 698600 w 1378659"/>
                            <a:gd name="connsiteY105" fmla="*/ 158742 h 476250"/>
                            <a:gd name="connsiteX106" fmla="*/ 651609 w 1378659"/>
                            <a:gd name="connsiteY106" fmla="*/ 161917 h 476250"/>
                            <a:gd name="connsiteX107" fmla="*/ 639078 w 1378659"/>
                            <a:gd name="connsiteY107" fmla="*/ 168267 h 476250"/>
                            <a:gd name="connsiteX108" fmla="*/ 629680 w 1378659"/>
                            <a:gd name="connsiteY108" fmla="*/ 171442 h 476250"/>
                            <a:gd name="connsiteX109" fmla="*/ 620282 w 1378659"/>
                            <a:gd name="connsiteY109" fmla="*/ 180966 h 476250"/>
                            <a:gd name="connsiteX110" fmla="*/ 610884 w 1378659"/>
                            <a:gd name="connsiteY110" fmla="*/ 187316 h 476250"/>
                            <a:gd name="connsiteX111" fmla="*/ 604618 w 1378659"/>
                            <a:gd name="connsiteY111" fmla="*/ 196840 h 476250"/>
                            <a:gd name="connsiteX112" fmla="*/ 595220 w 1378659"/>
                            <a:gd name="connsiteY112" fmla="*/ 209540 h 476250"/>
                            <a:gd name="connsiteX113" fmla="*/ 585822 w 1378659"/>
                            <a:gd name="connsiteY113" fmla="*/ 215890 h 476250"/>
                            <a:gd name="connsiteX114" fmla="*/ 570158 w 1378659"/>
                            <a:gd name="connsiteY114" fmla="*/ 231764 h 476250"/>
                            <a:gd name="connsiteX115" fmla="*/ 541963 w 1378659"/>
                            <a:gd name="connsiteY115" fmla="*/ 253988 h 476250"/>
                            <a:gd name="connsiteX116" fmla="*/ 523167 w 1378659"/>
                            <a:gd name="connsiteY116" fmla="*/ 260337 h 476250"/>
                            <a:gd name="connsiteX117" fmla="*/ 466778 w 1378659"/>
                            <a:gd name="connsiteY117" fmla="*/ 266687 h 476250"/>
                            <a:gd name="connsiteX118" fmla="*/ 457379 w 1378659"/>
                            <a:gd name="connsiteY118" fmla="*/ 269862 h 476250"/>
                            <a:gd name="connsiteX119" fmla="*/ 407256 w 1378659"/>
                            <a:gd name="connsiteY119" fmla="*/ 263512 h 476250"/>
                            <a:gd name="connsiteX120" fmla="*/ 247486 w 1378659"/>
                            <a:gd name="connsiteY120" fmla="*/ 266687 h 476250"/>
                            <a:gd name="connsiteX121" fmla="*/ 216159 w 1378659"/>
                            <a:gd name="connsiteY121" fmla="*/ 273037 h 476250"/>
                            <a:gd name="connsiteX122" fmla="*/ 194229 w 1378659"/>
                            <a:gd name="connsiteY122" fmla="*/ 288911 h 476250"/>
                            <a:gd name="connsiteX123" fmla="*/ 181698 w 1378659"/>
                            <a:gd name="connsiteY123" fmla="*/ 295261 h 476250"/>
                            <a:gd name="connsiteX124" fmla="*/ 172300 w 1378659"/>
                            <a:gd name="connsiteY124" fmla="*/ 301611 h 476250"/>
                            <a:gd name="connsiteX125" fmla="*/ 150371 w 1378659"/>
                            <a:gd name="connsiteY125" fmla="*/ 311135 h 476250"/>
                            <a:gd name="connsiteX126" fmla="*/ 122176 w 1378659"/>
                            <a:gd name="connsiteY126" fmla="*/ 320660 h 476250"/>
                            <a:gd name="connsiteX127" fmla="*/ 112778 w 1378659"/>
                            <a:gd name="connsiteY127" fmla="*/ 327009 h 476250"/>
                            <a:gd name="connsiteX128" fmla="*/ 78318 w 1378659"/>
                            <a:gd name="connsiteY128" fmla="*/ 336534 h 476250"/>
                            <a:gd name="connsiteX129" fmla="*/ 65787 w 1378659"/>
                            <a:gd name="connsiteY129" fmla="*/ 342884 h 476250"/>
                            <a:gd name="connsiteX130" fmla="*/ 46991 w 1378659"/>
                            <a:gd name="connsiteY130" fmla="*/ 349233 h 476250"/>
                            <a:gd name="connsiteX131" fmla="*/ 37592 w 1378659"/>
                            <a:gd name="connsiteY131" fmla="*/ 355583 h 476250"/>
                            <a:gd name="connsiteX132" fmla="*/ 9398 w 1378659"/>
                            <a:gd name="connsiteY132" fmla="*/ 365108 h 476250"/>
                            <a:gd name="connsiteX133" fmla="*/ 0 w 1378659"/>
                            <a:gd name="connsiteY133" fmla="*/ 368282 h 476250"/>
                            <a:gd name="connsiteX134" fmla="*/ 9398 w 1378659"/>
                            <a:gd name="connsiteY134" fmla="*/ 403206 h 476250"/>
                            <a:gd name="connsiteX135" fmla="*/ 12530 w 1378659"/>
                            <a:gd name="connsiteY135" fmla="*/ 450829 h 476250"/>
                            <a:gd name="connsiteX136" fmla="*/ 28194 w 1378659"/>
                            <a:gd name="connsiteY136" fmla="*/ 476228 h 476250"/>
                            <a:gd name="connsiteX137" fmla="*/ 28194 w 1378659"/>
                            <a:gd name="connsiteY137" fmla="*/ 466703 h 476250"/>
                          </a:gdLst>
                          <a:ahLst/>
                          <a:cxnLst>
                            <a:cxn ang="0">
                              <a:pos x="connsiteX0" y="connsiteY0"/>
                            </a:cxn>
                            <a:cxn ang="0">
                              <a:pos x="connsiteX1" y="connsiteY1"/>
                            </a:cxn>
                            <a:cxn ang="0">
                              <a:pos x="connsiteX2" y="connsiteY2"/>
                            </a:cxn>
                            <a:cxn ang="0">
                              <a:pos x="connsiteX3" y="connsiteY3"/>
                            </a:cxn>
                            <a:cxn ang="0">
                              <a:pos x="connsiteX4" y="connsiteY4"/>
                            </a:cxn>
                            <a:cxn ang="0">
                              <a:pos x="connsiteX5" y="connsiteY5"/>
                            </a:cxn>
                            <a:cxn ang="0">
                              <a:pos x="connsiteX6" y="connsiteY6"/>
                            </a:cxn>
                            <a:cxn ang="0">
                              <a:pos x="connsiteX7" y="connsiteY7"/>
                            </a:cxn>
                            <a:cxn ang="0">
                              <a:pos x="connsiteX8" y="connsiteY8"/>
                            </a:cxn>
                            <a:cxn ang="0">
                              <a:pos x="connsiteX9" y="connsiteY9"/>
                            </a:cxn>
                            <a:cxn ang="0">
                              <a:pos x="connsiteX10" y="connsiteY10"/>
                            </a:cxn>
                            <a:cxn ang="0">
                              <a:pos x="connsiteX11" y="connsiteY11"/>
                            </a:cxn>
                            <a:cxn ang="0">
                              <a:pos x="connsiteX12" y="connsiteY12"/>
                            </a:cxn>
                            <a:cxn ang="0">
                              <a:pos x="connsiteX13" y="connsiteY13"/>
                            </a:cxn>
                            <a:cxn ang="0">
                              <a:pos x="connsiteX14" y="connsiteY14"/>
                            </a:cxn>
                            <a:cxn ang="0">
                              <a:pos x="connsiteX15" y="connsiteY15"/>
                            </a:cxn>
                            <a:cxn ang="0">
                              <a:pos x="connsiteX16" y="connsiteY16"/>
                            </a:cxn>
                            <a:cxn ang="0">
                              <a:pos x="connsiteX17" y="connsiteY17"/>
                            </a:cxn>
                            <a:cxn ang="0">
                              <a:pos x="connsiteX18" y="connsiteY18"/>
                            </a:cxn>
                            <a:cxn ang="0">
                              <a:pos x="connsiteX19" y="connsiteY19"/>
                            </a:cxn>
                            <a:cxn ang="0">
                              <a:pos x="connsiteX20" y="connsiteY20"/>
                            </a:cxn>
                            <a:cxn ang="0">
                              <a:pos x="connsiteX21" y="connsiteY21"/>
                            </a:cxn>
                            <a:cxn ang="0">
                              <a:pos x="connsiteX22" y="connsiteY22"/>
                            </a:cxn>
                            <a:cxn ang="0">
                              <a:pos x="connsiteX23" y="connsiteY23"/>
                            </a:cxn>
                            <a:cxn ang="0">
                              <a:pos x="connsiteX24" y="connsiteY24"/>
                            </a:cxn>
                            <a:cxn ang="0">
                              <a:pos x="connsiteX25" y="connsiteY25"/>
                            </a:cxn>
                            <a:cxn ang="0">
                              <a:pos x="connsiteX26" y="connsiteY26"/>
                            </a:cxn>
                            <a:cxn ang="0">
                              <a:pos x="connsiteX27" y="connsiteY27"/>
                            </a:cxn>
                            <a:cxn ang="0">
                              <a:pos x="connsiteX28" y="connsiteY28"/>
                            </a:cxn>
                            <a:cxn ang="0">
                              <a:pos x="connsiteX29" y="connsiteY29"/>
                            </a:cxn>
                            <a:cxn ang="0">
                              <a:pos x="connsiteX30" y="connsiteY30"/>
                            </a:cxn>
                            <a:cxn ang="0">
                              <a:pos x="connsiteX31" y="connsiteY31"/>
                            </a:cxn>
                            <a:cxn ang="0">
                              <a:pos x="connsiteX32" y="connsiteY32"/>
                            </a:cxn>
                            <a:cxn ang="0">
                              <a:pos x="connsiteX33" y="connsiteY33"/>
                            </a:cxn>
                            <a:cxn ang="0">
                              <a:pos x="connsiteX34" y="connsiteY34"/>
                            </a:cxn>
                            <a:cxn ang="0">
                              <a:pos x="connsiteX35" y="connsiteY35"/>
                            </a:cxn>
                            <a:cxn ang="0">
                              <a:pos x="connsiteX36" y="connsiteY36"/>
                            </a:cxn>
                            <a:cxn ang="0">
                              <a:pos x="connsiteX37" y="connsiteY37"/>
                            </a:cxn>
                            <a:cxn ang="0">
                              <a:pos x="connsiteX38" y="connsiteY38"/>
                            </a:cxn>
                            <a:cxn ang="0">
                              <a:pos x="connsiteX39" y="connsiteY39"/>
                            </a:cxn>
                            <a:cxn ang="0">
                              <a:pos x="connsiteX40" y="connsiteY40"/>
                            </a:cxn>
                            <a:cxn ang="0">
                              <a:pos x="connsiteX41" y="connsiteY41"/>
                            </a:cxn>
                            <a:cxn ang="0">
                              <a:pos x="connsiteX42" y="connsiteY42"/>
                            </a:cxn>
                            <a:cxn ang="0">
                              <a:pos x="connsiteX43" y="connsiteY43"/>
                            </a:cxn>
                            <a:cxn ang="0">
                              <a:pos x="connsiteX44" y="connsiteY44"/>
                            </a:cxn>
                            <a:cxn ang="0">
                              <a:pos x="connsiteX45" y="connsiteY45"/>
                            </a:cxn>
                            <a:cxn ang="0">
                              <a:pos x="connsiteX46" y="connsiteY46"/>
                            </a:cxn>
                            <a:cxn ang="0">
                              <a:pos x="connsiteX47" y="connsiteY47"/>
                            </a:cxn>
                            <a:cxn ang="0">
                              <a:pos x="connsiteX48" y="connsiteY48"/>
                            </a:cxn>
                            <a:cxn ang="0">
                              <a:pos x="connsiteX49" y="connsiteY49"/>
                            </a:cxn>
                            <a:cxn ang="0">
                              <a:pos x="connsiteX50" y="connsiteY50"/>
                            </a:cxn>
                            <a:cxn ang="0">
                              <a:pos x="connsiteX51" y="connsiteY51"/>
                            </a:cxn>
                            <a:cxn ang="0">
                              <a:pos x="connsiteX52" y="connsiteY52"/>
                            </a:cxn>
                            <a:cxn ang="0">
                              <a:pos x="connsiteX53" y="connsiteY53"/>
                            </a:cxn>
                            <a:cxn ang="0">
                              <a:pos x="connsiteX54" y="connsiteY54"/>
                            </a:cxn>
                            <a:cxn ang="0">
                              <a:pos x="connsiteX55" y="connsiteY55"/>
                            </a:cxn>
                            <a:cxn ang="0">
                              <a:pos x="connsiteX56" y="connsiteY56"/>
                            </a:cxn>
                            <a:cxn ang="0">
                              <a:pos x="connsiteX57" y="connsiteY57"/>
                            </a:cxn>
                            <a:cxn ang="0">
                              <a:pos x="connsiteX58" y="connsiteY58"/>
                            </a:cxn>
                            <a:cxn ang="0">
                              <a:pos x="connsiteX59" y="connsiteY59"/>
                            </a:cxn>
                            <a:cxn ang="0">
                              <a:pos x="connsiteX60" y="connsiteY60"/>
                            </a:cxn>
                            <a:cxn ang="0">
                              <a:pos x="connsiteX61" y="connsiteY61"/>
                            </a:cxn>
                            <a:cxn ang="0">
                              <a:pos x="connsiteX62" y="connsiteY62"/>
                            </a:cxn>
                            <a:cxn ang="0">
                              <a:pos x="connsiteX63" y="connsiteY63"/>
                            </a:cxn>
                            <a:cxn ang="0">
                              <a:pos x="connsiteX64" y="connsiteY64"/>
                            </a:cxn>
                            <a:cxn ang="0">
                              <a:pos x="connsiteX65" y="connsiteY65"/>
                            </a:cxn>
                            <a:cxn ang="0">
                              <a:pos x="connsiteX66" y="connsiteY66"/>
                            </a:cxn>
                            <a:cxn ang="0">
                              <a:pos x="connsiteX67" y="connsiteY67"/>
                            </a:cxn>
                            <a:cxn ang="0">
                              <a:pos x="connsiteX68" y="connsiteY68"/>
                            </a:cxn>
                            <a:cxn ang="0">
                              <a:pos x="connsiteX69" y="connsiteY69"/>
                            </a:cxn>
                            <a:cxn ang="0">
                              <a:pos x="connsiteX70" y="connsiteY70"/>
                            </a:cxn>
                            <a:cxn ang="0">
                              <a:pos x="connsiteX71" y="connsiteY71"/>
                            </a:cxn>
                            <a:cxn ang="0">
                              <a:pos x="connsiteX72" y="connsiteY72"/>
                            </a:cxn>
                            <a:cxn ang="0">
                              <a:pos x="connsiteX73" y="connsiteY73"/>
                            </a:cxn>
                            <a:cxn ang="0">
                              <a:pos x="connsiteX74" y="connsiteY74"/>
                            </a:cxn>
                            <a:cxn ang="0">
                              <a:pos x="connsiteX75" y="connsiteY75"/>
                            </a:cxn>
                            <a:cxn ang="0">
                              <a:pos x="connsiteX76" y="connsiteY76"/>
                            </a:cxn>
                            <a:cxn ang="0">
                              <a:pos x="connsiteX77" y="connsiteY77"/>
                            </a:cxn>
                            <a:cxn ang="0">
                              <a:pos x="connsiteX78" y="connsiteY78"/>
                            </a:cxn>
                            <a:cxn ang="0">
                              <a:pos x="connsiteX79" y="connsiteY79"/>
                            </a:cxn>
                            <a:cxn ang="0">
                              <a:pos x="connsiteX80" y="connsiteY80"/>
                            </a:cxn>
                            <a:cxn ang="0">
                              <a:pos x="connsiteX81" y="connsiteY81"/>
                            </a:cxn>
                            <a:cxn ang="0">
                              <a:pos x="connsiteX82" y="connsiteY82"/>
                            </a:cxn>
                            <a:cxn ang="0">
                              <a:pos x="connsiteX83" y="connsiteY83"/>
                            </a:cxn>
                            <a:cxn ang="0">
                              <a:pos x="connsiteX84" y="connsiteY84"/>
                            </a:cxn>
                            <a:cxn ang="0">
                              <a:pos x="connsiteX85" y="connsiteY85"/>
                            </a:cxn>
                            <a:cxn ang="0">
                              <a:pos x="connsiteX86" y="connsiteY86"/>
                            </a:cxn>
                            <a:cxn ang="0">
                              <a:pos x="connsiteX87" y="connsiteY87"/>
                            </a:cxn>
                            <a:cxn ang="0">
                              <a:pos x="connsiteX88" y="connsiteY88"/>
                            </a:cxn>
                            <a:cxn ang="0">
                              <a:pos x="connsiteX89" y="connsiteY89"/>
                            </a:cxn>
                            <a:cxn ang="0">
                              <a:pos x="connsiteX90" y="connsiteY90"/>
                            </a:cxn>
                            <a:cxn ang="0">
                              <a:pos x="connsiteX91" y="connsiteY91"/>
                            </a:cxn>
                            <a:cxn ang="0">
                              <a:pos x="connsiteX92" y="connsiteY92"/>
                            </a:cxn>
                            <a:cxn ang="0">
                              <a:pos x="connsiteX93" y="connsiteY93"/>
                            </a:cxn>
                            <a:cxn ang="0">
                              <a:pos x="connsiteX94" y="connsiteY94"/>
                            </a:cxn>
                            <a:cxn ang="0">
                              <a:pos x="connsiteX95" y="connsiteY95"/>
                            </a:cxn>
                            <a:cxn ang="0">
                              <a:pos x="connsiteX96" y="connsiteY96"/>
                            </a:cxn>
                            <a:cxn ang="0">
                              <a:pos x="connsiteX97" y="connsiteY97"/>
                            </a:cxn>
                            <a:cxn ang="0">
                              <a:pos x="connsiteX98" y="connsiteY98"/>
                            </a:cxn>
                            <a:cxn ang="0">
                              <a:pos x="connsiteX99" y="connsiteY99"/>
                            </a:cxn>
                            <a:cxn ang="0">
                              <a:pos x="connsiteX100" y="connsiteY100"/>
                            </a:cxn>
                            <a:cxn ang="0">
                              <a:pos x="connsiteX101" y="connsiteY101"/>
                            </a:cxn>
                            <a:cxn ang="0">
                              <a:pos x="connsiteX102" y="connsiteY102"/>
                            </a:cxn>
                            <a:cxn ang="0">
                              <a:pos x="connsiteX103" y="connsiteY103"/>
                            </a:cxn>
                            <a:cxn ang="0">
                              <a:pos x="connsiteX104" y="connsiteY104"/>
                            </a:cxn>
                            <a:cxn ang="0">
                              <a:pos x="connsiteX105" y="connsiteY105"/>
                            </a:cxn>
                            <a:cxn ang="0">
                              <a:pos x="connsiteX106" y="connsiteY106"/>
                            </a:cxn>
                            <a:cxn ang="0">
                              <a:pos x="connsiteX107" y="connsiteY107"/>
                            </a:cxn>
                            <a:cxn ang="0">
                              <a:pos x="connsiteX108" y="connsiteY108"/>
                            </a:cxn>
                            <a:cxn ang="0">
                              <a:pos x="connsiteX109" y="connsiteY109"/>
                            </a:cxn>
                            <a:cxn ang="0">
                              <a:pos x="connsiteX110" y="connsiteY110"/>
                            </a:cxn>
                            <a:cxn ang="0">
                              <a:pos x="connsiteX111" y="connsiteY111"/>
                            </a:cxn>
                            <a:cxn ang="0">
                              <a:pos x="connsiteX112" y="connsiteY112"/>
                            </a:cxn>
                            <a:cxn ang="0">
                              <a:pos x="connsiteX113" y="connsiteY113"/>
                            </a:cxn>
                            <a:cxn ang="0">
                              <a:pos x="connsiteX114" y="connsiteY114"/>
                            </a:cxn>
                            <a:cxn ang="0">
                              <a:pos x="connsiteX115" y="connsiteY115"/>
                            </a:cxn>
                            <a:cxn ang="0">
                              <a:pos x="connsiteX116" y="connsiteY116"/>
                            </a:cxn>
                            <a:cxn ang="0">
                              <a:pos x="connsiteX117" y="connsiteY117"/>
                            </a:cxn>
                            <a:cxn ang="0">
                              <a:pos x="connsiteX118" y="connsiteY118"/>
                            </a:cxn>
                            <a:cxn ang="0">
                              <a:pos x="connsiteX119" y="connsiteY119"/>
                            </a:cxn>
                            <a:cxn ang="0">
                              <a:pos x="connsiteX120" y="connsiteY120"/>
                            </a:cxn>
                            <a:cxn ang="0">
                              <a:pos x="connsiteX121" y="connsiteY121"/>
                            </a:cxn>
                            <a:cxn ang="0">
                              <a:pos x="connsiteX122" y="connsiteY122"/>
                            </a:cxn>
                            <a:cxn ang="0">
                              <a:pos x="connsiteX123" y="connsiteY123"/>
                            </a:cxn>
                            <a:cxn ang="0">
                              <a:pos x="connsiteX124" y="connsiteY124"/>
                            </a:cxn>
                            <a:cxn ang="0">
                              <a:pos x="connsiteX125" y="connsiteY125"/>
                            </a:cxn>
                            <a:cxn ang="0">
                              <a:pos x="connsiteX126" y="connsiteY126"/>
                            </a:cxn>
                            <a:cxn ang="0">
                              <a:pos x="connsiteX127" y="connsiteY127"/>
                            </a:cxn>
                            <a:cxn ang="0">
                              <a:pos x="connsiteX128" y="connsiteY128"/>
                            </a:cxn>
                            <a:cxn ang="0">
                              <a:pos x="connsiteX129" y="connsiteY129"/>
                            </a:cxn>
                            <a:cxn ang="0">
                              <a:pos x="connsiteX130" y="connsiteY130"/>
                            </a:cxn>
                            <a:cxn ang="0">
                              <a:pos x="connsiteX131" y="connsiteY131"/>
                            </a:cxn>
                            <a:cxn ang="0">
                              <a:pos x="connsiteX132" y="connsiteY132"/>
                            </a:cxn>
                            <a:cxn ang="0">
                              <a:pos x="connsiteX133" y="connsiteY133"/>
                            </a:cxn>
                            <a:cxn ang="0">
                              <a:pos x="connsiteX134" y="connsiteY134"/>
                            </a:cxn>
                            <a:cxn ang="0">
                              <a:pos x="connsiteX135" y="connsiteY135"/>
                            </a:cxn>
                            <a:cxn ang="0">
                              <a:pos x="connsiteX136" y="connsiteY136"/>
                            </a:cxn>
                            <a:cxn ang="0">
                              <a:pos x="connsiteX137" y="connsiteY137"/>
                            </a:cxn>
                          </a:cxnLst>
                          <a:rect l="l" t="t" r="r" b="b"/>
                          <a:pathLst>
                            <a:path w="1378659" h="476250" extrusionOk="0">
                              <a:moveTo>
                                <a:pt x="28194" y="466703"/>
                              </a:moveTo>
                              <a:cubicBezTo>
                                <a:pt x="33944" y="462888"/>
                                <a:pt x="42254" y="466219"/>
                                <a:pt x="68920" y="457178"/>
                              </a:cubicBezTo>
                              <a:cubicBezTo>
                                <a:pt x="72448" y="456203"/>
                                <a:pt x="74789" y="455884"/>
                                <a:pt x="78318" y="454004"/>
                              </a:cubicBezTo>
                              <a:cubicBezTo>
                                <a:pt x="81092" y="452238"/>
                                <a:pt x="84119" y="449281"/>
                                <a:pt x="87716" y="447654"/>
                              </a:cubicBezTo>
                              <a:cubicBezTo>
                                <a:pt x="94059" y="443715"/>
                                <a:pt x="105291" y="443220"/>
                                <a:pt x="112778" y="441304"/>
                              </a:cubicBezTo>
                              <a:cubicBezTo>
                                <a:pt x="141833" y="437252"/>
                                <a:pt x="125679" y="438231"/>
                                <a:pt x="153504" y="434954"/>
                              </a:cubicBezTo>
                              <a:cubicBezTo>
                                <a:pt x="158672" y="432670"/>
                                <a:pt x="166264" y="432828"/>
                                <a:pt x="172300" y="428605"/>
                              </a:cubicBezTo>
                              <a:cubicBezTo>
                                <a:pt x="175422" y="426385"/>
                                <a:pt x="178144" y="423964"/>
                                <a:pt x="181698" y="422255"/>
                              </a:cubicBezTo>
                              <a:cubicBezTo>
                                <a:pt x="200556" y="414524"/>
                                <a:pt x="206334" y="416448"/>
                                <a:pt x="225557" y="409556"/>
                              </a:cubicBezTo>
                              <a:cubicBezTo>
                                <a:pt x="267398" y="394009"/>
                                <a:pt x="227290" y="412529"/>
                                <a:pt x="256884" y="400031"/>
                              </a:cubicBezTo>
                              <a:cubicBezTo>
                                <a:pt x="260172" y="399280"/>
                                <a:pt x="263097" y="397855"/>
                                <a:pt x="266282" y="396856"/>
                              </a:cubicBezTo>
                              <a:cubicBezTo>
                                <a:pt x="284269" y="392480"/>
                                <a:pt x="278941" y="396061"/>
                                <a:pt x="294477" y="390506"/>
                              </a:cubicBezTo>
                              <a:cubicBezTo>
                                <a:pt x="301886" y="387636"/>
                                <a:pt x="307205" y="385345"/>
                                <a:pt x="313273" y="384157"/>
                              </a:cubicBezTo>
                              <a:cubicBezTo>
                                <a:pt x="316140" y="383050"/>
                                <a:pt x="319487" y="382049"/>
                                <a:pt x="322672" y="380982"/>
                              </a:cubicBezTo>
                              <a:cubicBezTo>
                                <a:pt x="325374" y="379282"/>
                                <a:pt x="329212" y="380076"/>
                                <a:pt x="332070" y="377807"/>
                              </a:cubicBezTo>
                              <a:cubicBezTo>
                                <a:pt x="338165" y="373062"/>
                                <a:pt x="344413" y="367381"/>
                                <a:pt x="350866" y="365108"/>
                              </a:cubicBezTo>
                              <a:cubicBezTo>
                                <a:pt x="387658" y="355284"/>
                                <a:pt x="323991" y="371107"/>
                                <a:pt x="372796" y="358758"/>
                              </a:cubicBezTo>
                              <a:cubicBezTo>
                                <a:pt x="379718" y="355759"/>
                                <a:pt x="384898" y="353435"/>
                                <a:pt x="391592" y="352408"/>
                              </a:cubicBezTo>
                              <a:cubicBezTo>
                                <a:pt x="400015" y="351114"/>
                                <a:pt x="406355" y="351584"/>
                                <a:pt x="413521" y="349233"/>
                              </a:cubicBezTo>
                              <a:cubicBezTo>
                                <a:pt x="419719" y="348028"/>
                                <a:pt x="423854" y="345975"/>
                                <a:pt x="429185" y="346059"/>
                              </a:cubicBezTo>
                              <a:cubicBezTo>
                                <a:pt x="488048" y="344422"/>
                                <a:pt x="540756" y="348050"/>
                                <a:pt x="601486" y="342884"/>
                              </a:cubicBezTo>
                              <a:cubicBezTo>
                                <a:pt x="645957" y="333210"/>
                                <a:pt x="604002" y="347858"/>
                                <a:pt x="632813" y="336534"/>
                              </a:cubicBezTo>
                              <a:cubicBezTo>
                                <a:pt x="641888" y="336549"/>
                                <a:pt x="667054" y="331440"/>
                                <a:pt x="676671" y="327009"/>
                              </a:cubicBezTo>
                              <a:cubicBezTo>
                                <a:pt x="683126" y="325521"/>
                                <a:pt x="690410" y="322422"/>
                                <a:pt x="695468" y="320660"/>
                              </a:cubicBezTo>
                              <a:cubicBezTo>
                                <a:pt x="698717" y="319232"/>
                                <a:pt x="702607" y="317992"/>
                                <a:pt x="704866" y="317485"/>
                              </a:cubicBezTo>
                              <a:cubicBezTo>
                                <a:pt x="707769" y="315704"/>
                                <a:pt x="711611" y="316094"/>
                                <a:pt x="714264" y="314310"/>
                              </a:cubicBezTo>
                              <a:cubicBezTo>
                                <a:pt x="717464" y="312077"/>
                                <a:pt x="719880" y="309379"/>
                                <a:pt x="723662" y="307960"/>
                              </a:cubicBezTo>
                              <a:cubicBezTo>
                                <a:pt x="729698" y="305242"/>
                                <a:pt x="742459" y="301611"/>
                                <a:pt x="742459" y="301611"/>
                              </a:cubicBezTo>
                              <a:cubicBezTo>
                                <a:pt x="755716" y="304637"/>
                                <a:pt x="769547" y="302712"/>
                                <a:pt x="780052" y="304785"/>
                              </a:cubicBezTo>
                              <a:cubicBezTo>
                                <a:pt x="783122" y="305985"/>
                                <a:pt x="787316" y="305996"/>
                                <a:pt x="789450" y="307960"/>
                              </a:cubicBezTo>
                              <a:cubicBezTo>
                                <a:pt x="804846" y="316589"/>
                                <a:pt x="787624" y="314426"/>
                                <a:pt x="805114" y="323835"/>
                              </a:cubicBezTo>
                              <a:cubicBezTo>
                                <a:pt x="811408" y="326820"/>
                                <a:pt x="818229" y="328626"/>
                                <a:pt x="823910" y="330184"/>
                              </a:cubicBezTo>
                              <a:cubicBezTo>
                                <a:pt x="827284" y="331830"/>
                                <a:pt x="830334" y="332774"/>
                                <a:pt x="833308" y="333359"/>
                              </a:cubicBezTo>
                              <a:cubicBezTo>
                                <a:pt x="836912" y="333826"/>
                                <a:pt x="849964" y="338205"/>
                                <a:pt x="855237" y="339709"/>
                              </a:cubicBezTo>
                              <a:cubicBezTo>
                                <a:pt x="873964" y="349079"/>
                                <a:pt x="858837" y="340523"/>
                                <a:pt x="874034" y="349233"/>
                              </a:cubicBezTo>
                              <a:cubicBezTo>
                                <a:pt x="877892" y="349928"/>
                                <a:pt x="881856" y="351473"/>
                                <a:pt x="886565" y="352408"/>
                              </a:cubicBezTo>
                              <a:cubicBezTo>
                                <a:pt x="889789" y="354062"/>
                                <a:pt x="892173" y="354423"/>
                                <a:pt x="895963" y="355583"/>
                              </a:cubicBezTo>
                              <a:cubicBezTo>
                                <a:pt x="924987" y="357547"/>
                                <a:pt x="969803" y="362027"/>
                                <a:pt x="989945" y="361933"/>
                              </a:cubicBezTo>
                              <a:cubicBezTo>
                                <a:pt x="1012601" y="361358"/>
                                <a:pt x="1029025" y="360821"/>
                                <a:pt x="1049467" y="358758"/>
                              </a:cubicBezTo>
                              <a:cubicBezTo>
                                <a:pt x="1052751" y="358284"/>
                                <a:pt x="1055669" y="356036"/>
                                <a:pt x="1058865" y="355583"/>
                              </a:cubicBezTo>
                              <a:cubicBezTo>
                                <a:pt x="1065409" y="353171"/>
                                <a:pt x="1070741" y="353861"/>
                                <a:pt x="1077662" y="352408"/>
                              </a:cubicBezTo>
                              <a:cubicBezTo>
                                <a:pt x="1081098" y="351350"/>
                                <a:pt x="1084202" y="349902"/>
                                <a:pt x="1087060" y="349233"/>
                              </a:cubicBezTo>
                              <a:cubicBezTo>
                                <a:pt x="1092097" y="347964"/>
                                <a:pt x="1095498" y="347194"/>
                                <a:pt x="1099591" y="346059"/>
                              </a:cubicBezTo>
                              <a:cubicBezTo>
                                <a:pt x="1105917" y="344136"/>
                                <a:pt x="1118388" y="339710"/>
                                <a:pt x="1118388" y="339709"/>
                              </a:cubicBezTo>
                              <a:cubicBezTo>
                                <a:pt x="1118969" y="336039"/>
                                <a:pt x="1120219" y="333383"/>
                                <a:pt x="1121520" y="330184"/>
                              </a:cubicBezTo>
                              <a:cubicBezTo>
                                <a:pt x="1123854" y="324776"/>
                                <a:pt x="1128806" y="319538"/>
                                <a:pt x="1134051" y="314310"/>
                              </a:cubicBezTo>
                              <a:cubicBezTo>
                                <a:pt x="1142009" y="302733"/>
                                <a:pt x="1151166" y="299391"/>
                                <a:pt x="1159113" y="288911"/>
                              </a:cubicBezTo>
                              <a:cubicBezTo>
                                <a:pt x="1164499" y="282194"/>
                                <a:pt x="1166232" y="278316"/>
                                <a:pt x="1171644" y="269862"/>
                              </a:cubicBezTo>
                              <a:cubicBezTo>
                                <a:pt x="1174514" y="266467"/>
                                <a:pt x="1175386" y="262490"/>
                                <a:pt x="1177910" y="260337"/>
                              </a:cubicBezTo>
                              <a:cubicBezTo>
                                <a:pt x="1181946" y="256079"/>
                                <a:pt x="1182687" y="255334"/>
                                <a:pt x="1187308" y="250813"/>
                              </a:cubicBezTo>
                              <a:cubicBezTo>
                                <a:pt x="1188967" y="245088"/>
                                <a:pt x="1189549" y="238234"/>
                                <a:pt x="1193573" y="231764"/>
                              </a:cubicBezTo>
                              <a:cubicBezTo>
                                <a:pt x="1224119" y="183888"/>
                                <a:pt x="1191558" y="234662"/>
                                <a:pt x="1215502" y="203190"/>
                              </a:cubicBezTo>
                              <a:cubicBezTo>
                                <a:pt x="1217536" y="200194"/>
                                <a:pt x="1218908" y="195505"/>
                                <a:pt x="1221768" y="193666"/>
                              </a:cubicBezTo>
                              <a:cubicBezTo>
                                <a:pt x="1228188" y="187196"/>
                                <a:pt x="1236389" y="185166"/>
                                <a:pt x="1240564" y="180966"/>
                              </a:cubicBezTo>
                              <a:cubicBezTo>
                                <a:pt x="1256796" y="165007"/>
                                <a:pt x="1248129" y="172364"/>
                                <a:pt x="1268759" y="158742"/>
                              </a:cubicBezTo>
                              <a:cubicBezTo>
                                <a:pt x="1272055" y="157548"/>
                                <a:pt x="1274911" y="153985"/>
                                <a:pt x="1278157" y="152392"/>
                              </a:cubicBezTo>
                              <a:cubicBezTo>
                                <a:pt x="1283439" y="150344"/>
                                <a:pt x="1286358" y="147440"/>
                                <a:pt x="1290688" y="146043"/>
                              </a:cubicBezTo>
                              <a:cubicBezTo>
                                <a:pt x="1293052" y="144799"/>
                                <a:pt x="1297635" y="145025"/>
                                <a:pt x="1300086" y="142868"/>
                              </a:cubicBezTo>
                              <a:cubicBezTo>
                                <a:pt x="1306022" y="140739"/>
                                <a:pt x="1313458" y="131977"/>
                                <a:pt x="1318883" y="130168"/>
                              </a:cubicBezTo>
                              <a:cubicBezTo>
                                <a:pt x="1322274" y="128493"/>
                                <a:pt x="1325569" y="128696"/>
                                <a:pt x="1328281" y="126994"/>
                              </a:cubicBezTo>
                              <a:cubicBezTo>
                                <a:pt x="1335149" y="122838"/>
                                <a:pt x="1342424" y="119466"/>
                                <a:pt x="1347078" y="114294"/>
                              </a:cubicBezTo>
                              <a:cubicBezTo>
                                <a:pt x="1351088" y="111276"/>
                                <a:pt x="1352801" y="107416"/>
                                <a:pt x="1356476" y="104770"/>
                              </a:cubicBezTo>
                              <a:cubicBezTo>
                                <a:pt x="1358981" y="102823"/>
                                <a:pt x="1363221" y="103072"/>
                                <a:pt x="1365874" y="101595"/>
                              </a:cubicBezTo>
                              <a:cubicBezTo>
                                <a:pt x="1369221" y="98975"/>
                                <a:pt x="1372644" y="96996"/>
                                <a:pt x="1375272" y="95245"/>
                              </a:cubicBezTo>
                              <a:cubicBezTo>
                                <a:pt x="1383135" y="77024"/>
                                <a:pt x="1378040" y="96654"/>
                                <a:pt x="1375272" y="76196"/>
                              </a:cubicBezTo>
                              <a:cubicBezTo>
                                <a:pt x="1374224" y="-4286"/>
                                <a:pt x="1394454" y="13143"/>
                                <a:pt x="1362741" y="0"/>
                              </a:cubicBezTo>
                              <a:cubicBezTo>
                                <a:pt x="1360352" y="970"/>
                                <a:pt x="1331193" y="-1096"/>
                                <a:pt x="1318883" y="6349"/>
                              </a:cubicBezTo>
                              <a:cubicBezTo>
                                <a:pt x="1313565" y="10500"/>
                                <a:pt x="1306612" y="13273"/>
                                <a:pt x="1300086" y="19049"/>
                              </a:cubicBezTo>
                              <a:cubicBezTo>
                                <a:pt x="1296758" y="20734"/>
                                <a:pt x="1294360" y="24944"/>
                                <a:pt x="1290688" y="25398"/>
                              </a:cubicBezTo>
                              <a:cubicBezTo>
                                <a:pt x="1282992" y="27273"/>
                                <a:pt x="1277324" y="30179"/>
                                <a:pt x="1271892" y="31748"/>
                              </a:cubicBezTo>
                              <a:cubicBezTo>
                                <a:pt x="1268327" y="32546"/>
                                <a:pt x="1265357" y="32301"/>
                                <a:pt x="1262494" y="34923"/>
                              </a:cubicBezTo>
                              <a:cubicBezTo>
                                <a:pt x="1258793" y="37175"/>
                                <a:pt x="1256842" y="40378"/>
                                <a:pt x="1253095" y="41273"/>
                              </a:cubicBezTo>
                              <a:cubicBezTo>
                                <a:pt x="1246923" y="44449"/>
                                <a:pt x="1240002" y="45545"/>
                                <a:pt x="1234299" y="47622"/>
                              </a:cubicBezTo>
                              <a:cubicBezTo>
                                <a:pt x="1229994" y="49081"/>
                                <a:pt x="1221925" y="52730"/>
                                <a:pt x="1215502" y="53972"/>
                              </a:cubicBezTo>
                              <a:cubicBezTo>
                                <a:pt x="1212267" y="54867"/>
                                <a:pt x="1208764" y="55942"/>
                                <a:pt x="1206104" y="57147"/>
                              </a:cubicBezTo>
                              <a:cubicBezTo>
                                <a:pt x="1203279" y="59519"/>
                                <a:pt x="1200272" y="61404"/>
                                <a:pt x="1196706" y="63497"/>
                              </a:cubicBezTo>
                              <a:cubicBezTo>
                                <a:pt x="1190913" y="65776"/>
                                <a:pt x="1185699" y="68080"/>
                                <a:pt x="1177910" y="69846"/>
                              </a:cubicBezTo>
                              <a:cubicBezTo>
                                <a:pt x="1174309" y="71188"/>
                                <a:pt x="1171652" y="72320"/>
                                <a:pt x="1168511" y="73021"/>
                              </a:cubicBezTo>
                              <a:cubicBezTo>
                                <a:pt x="1164776" y="74160"/>
                                <a:pt x="1160711" y="74651"/>
                                <a:pt x="1155980" y="76196"/>
                              </a:cubicBezTo>
                              <a:cubicBezTo>
                                <a:pt x="1149169" y="77410"/>
                                <a:pt x="1142327" y="79693"/>
                                <a:pt x="1137184" y="82546"/>
                              </a:cubicBezTo>
                              <a:cubicBezTo>
                                <a:pt x="1116715" y="101088"/>
                                <a:pt x="1142004" y="79274"/>
                                <a:pt x="1115255" y="95245"/>
                              </a:cubicBezTo>
                              <a:cubicBezTo>
                                <a:pt x="1112038" y="97764"/>
                                <a:pt x="1108371" y="100038"/>
                                <a:pt x="1105857" y="101595"/>
                              </a:cubicBezTo>
                              <a:cubicBezTo>
                                <a:pt x="1102817" y="103447"/>
                                <a:pt x="1098766" y="103120"/>
                                <a:pt x="1096458" y="104770"/>
                              </a:cubicBezTo>
                              <a:cubicBezTo>
                                <a:pt x="1092970" y="106545"/>
                                <a:pt x="1090686" y="108542"/>
                                <a:pt x="1087060" y="111119"/>
                              </a:cubicBezTo>
                              <a:cubicBezTo>
                                <a:pt x="1083849" y="112464"/>
                                <a:pt x="1080621" y="112984"/>
                                <a:pt x="1077662" y="114294"/>
                              </a:cubicBezTo>
                              <a:cubicBezTo>
                                <a:pt x="1071080" y="118001"/>
                                <a:pt x="1058866" y="126994"/>
                                <a:pt x="1058865" y="126994"/>
                              </a:cubicBezTo>
                              <a:cubicBezTo>
                                <a:pt x="1054533" y="135071"/>
                                <a:pt x="1049031" y="139251"/>
                                <a:pt x="1046335" y="146043"/>
                              </a:cubicBezTo>
                              <a:cubicBezTo>
                                <a:pt x="1042182" y="159019"/>
                                <a:pt x="1043869" y="153201"/>
                                <a:pt x="1036936" y="165092"/>
                              </a:cubicBezTo>
                              <a:cubicBezTo>
                                <a:pt x="1036917" y="169538"/>
                                <a:pt x="1036119" y="174217"/>
                                <a:pt x="1033804" y="177791"/>
                              </a:cubicBezTo>
                              <a:cubicBezTo>
                                <a:pt x="1032676" y="181003"/>
                                <a:pt x="1028813" y="184061"/>
                                <a:pt x="1027538" y="187316"/>
                              </a:cubicBezTo>
                              <a:cubicBezTo>
                                <a:pt x="1025769" y="197838"/>
                                <a:pt x="1032379" y="214481"/>
                                <a:pt x="1021273" y="219064"/>
                              </a:cubicBezTo>
                              <a:cubicBezTo>
                                <a:pt x="1016910" y="221977"/>
                                <a:pt x="1006113" y="228385"/>
                                <a:pt x="1002476" y="231764"/>
                              </a:cubicBezTo>
                              <a:cubicBezTo>
                                <a:pt x="998892" y="234421"/>
                                <a:pt x="996812" y="236849"/>
                                <a:pt x="993078" y="238114"/>
                              </a:cubicBezTo>
                              <a:cubicBezTo>
                                <a:pt x="985047" y="240725"/>
                                <a:pt x="978521" y="243711"/>
                                <a:pt x="974282" y="244463"/>
                              </a:cubicBezTo>
                              <a:cubicBezTo>
                                <a:pt x="950296" y="239787"/>
                                <a:pt x="926986" y="241144"/>
                                <a:pt x="905361" y="241288"/>
                              </a:cubicBezTo>
                              <a:cubicBezTo>
                                <a:pt x="895268" y="240445"/>
                                <a:pt x="895910" y="235862"/>
                                <a:pt x="886565" y="231764"/>
                              </a:cubicBezTo>
                              <a:cubicBezTo>
                                <a:pt x="880138" y="229143"/>
                                <a:pt x="872616" y="227010"/>
                                <a:pt x="867768" y="225414"/>
                              </a:cubicBezTo>
                              <a:cubicBezTo>
                                <a:pt x="864568" y="224121"/>
                                <a:pt x="861343" y="224493"/>
                                <a:pt x="858370" y="222239"/>
                              </a:cubicBezTo>
                              <a:cubicBezTo>
                                <a:pt x="851129" y="218957"/>
                                <a:pt x="846614" y="213217"/>
                                <a:pt x="839574" y="209540"/>
                              </a:cubicBezTo>
                              <a:cubicBezTo>
                                <a:pt x="835383" y="208426"/>
                                <a:pt x="828751" y="206381"/>
                                <a:pt x="820777" y="203190"/>
                              </a:cubicBezTo>
                              <a:cubicBezTo>
                                <a:pt x="817125" y="201789"/>
                                <a:pt x="814192" y="201348"/>
                                <a:pt x="811379" y="200015"/>
                              </a:cubicBezTo>
                              <a:cubicBezTo>
                                <a:pt x="796899" y="189124"/>
                                <a:pt x="804383" y="194981"/>
                                <a:pt x="786317" y="190491"/>
                              </a:cubicBezTo>
                              <a:cubicBezTo>
                                <a:pt x="777369" y="183609"/>
                                <a:pt x="775999" y="183526"/>
                                <a:pt x="767521" y="177791"/>
                              </a:cubicBezTo>
                              <a:cubicBezTo>
                                <a:pt x="764621" y="175722"/>
                                <a:pt x="761553" y="172375"/>
                                <a:pt x="758122" y="171442"/>
                              </a:cubicBezTo>
                              <a:cubicBezTo>
                                <a:pt x="748451" y="168445"/>
                                <a:pt x="742980" y="165960"/>
                                <a:pt x="733061" y="165092"/>
                              </a:cubicBezTo>
                              <a:cubicBezTo>
                                <a:pt x="708962" y="158778"/>
                                <a:pt x="722412" y="163821"/>
                                <a:pt x="698600" y="158742"/>
                              </a:cubicBezTo>
                              <a:cubicBezTo>
                                <a:pt x="684312" y="159585"/>
                                <a:pt x="666520" y="162151"/>
                                <a:pt x="651609" y="161917"/>
                              </a:cubicBezTo>
                              <a:cubicBezTo>
                                <a:pt x="646883" y="162714"/>
                                <a:pt x="643322" y="166288"/>
                                <a:pt x="639078" y="168267"/>
                              </a:cubicBezTo>
                              <a:cubicBezTo>
                                <a:pt x="636172" y="169454"/>
                                <a:pt x="632316" y="169991"/>
                                <a:pt x="629680" y="171442"/>
                              </a:cubicBezTo>
                              <a:cubicBezTo>
                                <a:pt x="627291" y="174492"/>
                                <a:pt x="624236" y="177410"/>
                                <a:pt x="620282" y="180966"/>
                              </a:cubicBezTo>
                              <a:cubicBezTo>
                                <a:pt x="617481" y="183107"/>
                                <a:pt x="614034" y="184067"/>
                                <a:pt x="610884" y="187316"/>
                              </a:cubicBezTo>
                              <a:cubicBezTo>
                                <a:pt x="607954" y="189920"/>
                                <a:pt x="606532" y="193493"/>
                                <a:pt x="604618" y="196840"/>
                              </a:cubicBezTo>
                              <a:cubicBezTo>
                                <a:pt x="601718" y="201101"/>
                                <a:pt x="599628" y="205992"/>
                                <a:pt x="595220" y="209540"/>
                              </a:cubicBezTo>
                              <a:cubicBezTo>
                                <a:pt x="592619" y="212800"/>
                                <a:pt x="589010" y="214352"/>
                                <a:pt x="585822" y="215890"/>
                              </a:cubicBezTo>
                              <a:cubicBezTo>
                                <a:pt x="577346" y="230272"/>
                                <a:pt x="584022" y="219795"/>
                                <a:pt x="570158" y="231764"/>
                              </a:cubicBezTo>
                              <a:cubicBezTo>
                                <a:pt x="558620" y="240827"/>
                                <a:pt x="559013" y="249956"/>
                                <a:pt x="541963" y="253988"/>
                              </a:cubicBezTo>
                              <a:cubicBezTo>
                                <a:pt x="536972" y="255993"/>
                                <a:pt x="529666" y="257973"/>
                                <a:pt x="523167" y="260337"/>
                              </a:cubicBezTo>
                              <a:cubicBezTo>
                                <a:pt x="484573" y="268311"/>
                                <a:pt x="510224" y="262675"/>
                                <a:pt x="466778" y="266687"/>
                              </a:cubicBezTo>
                              <a:cubicBezTo>
                                <a:pt x="463760" y="267929"/>
                                <a:pt x="460530" y="270161"/>
                                <a:pt x="457379" y="269862"/>
                              </a:cubicBezTo>
                              <a:cubicBezTo>
                                <a:pt x="440565" y="268965"/>
                                <a:pt x="407255" y="263512"/>
                                <a:pt x="407256" y="263512"/>
                              </a:cubicBezTo>
                              <a:cubicBezTo>
                                <a:pt x="333319" y="262712"/>
                                <a:pt x="281912" y="273046"/>
                                <a:pt x="247486" y="266687"/>
                              </a:cubicBezTo>
                              <a:cubicBezTo>
                                <a:pt x="241918" y="267295"/>
                                <a:pt x="225564" y="268709"/>
                                <a:pt x="216159" y="273037"/>
                              </a:cubicBezTo>
                              <a:cubicBezTo>
                                <a:pt x="210320" y="276209"/>
                                <a:pt x="200706" y="285125"/>
                                <a:pt x="194229" y="288911"/>
                              </a:cubicBezTo>
                              <a:cubicBezTo>
                                <a:pt x="189861" y="292203"/>
                                <a:pt x="185195" y="293462"/>
                                <a:pt x="181698" y="295261"/>
                              </a:cubicBezTo>
                              <a:cubicBezTo>
                                <a:pt x="178588" y="297483"/>
                                <a:pt x="175643" y="299522"/>
                                <a:pt x="172300" y="301611"/>
                              </a:cubicBezTo>
                              <a:cubicBezTo>
                                <a:pt x="157398" y="309735"/>
                                <a:pt x="163845" y="306350"/>
                                <a:pt x="150371" y="311135"/>
                              </a:cubicBezTo>
                              <a:cubicBezTo>
                                <a:pt x="127817" y="319259"/>
                                <a:pt x="142913" y="312630"/>
                                <a:pt x="122176" y="320660"/>
                              </a:cubicBezTo>
                              <a:cubicBezTo>
                                <a:pt x="118244" y="322920"/>
                                <a:pt x="116006" y="325822"/>
                                <a:pt x="112778" y="327009"/>
                              </a:cubicBezTo>
                              <a:cubicBezTo>
                                <a:pt x="103004" y="331344"/>
                                <a:pt x="90059" y="330876"/>
                                <a:pt x="78318" y="336534"/>
                              </a:cubicBezTo>
                              <a:cubicBezTo>
                                <a:pt x="74689" y="338992"/>
                                <a:pt x="70597" y="342151"/>
                                <a:pt x="65787" y="342884"/>
                              </a:cubicBezTo>
                              <a:cubicBezTo>
                                <a:pt x="58078" y="344963"/>
                                <a:pt x="51267" y="345151"/>
                                <a:pt x="46991" y="349233"/>
                              </a:cubicBezTo>
                              <a:cubicBezTo>
                                <a:pt x="43313" y="350992"/>
                                <a:pt x="41331" y="353584"/>
                                <a:pt x="37592" y="355583"/>
                              </a:cubicBezTo>
                              <a:cubicBezTo>
                                <a:pt x="26639" y="360677"/>
                                <a:pt x="18194" y="361733"/>
                                <a:pt x="9398" y="365108"/>
                              </a:cubicBezTo>
                              <a:cubicBezTo>
                                <a:pt x="6085" y="365807"/>
                                <a:pt x="3365" y="367515"/>
                                <a:pt x="0" y="368282"/>
                              </a:cubicBezTo>
                              <a:cubicBezTo>
                                <a:pt x="7745" y="392887"/>
                                <a:pt x="2438" y="382215"/>
                                <a:pt x="9398" y="403206"/>
                              </a:cubicBezTo>
                              <a:cubicBezTo>
                                <a:pt x="13107" y="419794"/>
                                <a:pt x="9833" y="435713"/>
                                <a:pt x="12530" y="450829"/>
                              </a:cubicBezTo>
                              <a:cubicBezTo>
                                <a:pt x="12718" y="462058"/>
                                <a:pt x="16221" y="473409"/>
                                <a:pt x="28194" y="476228"/>
                              </a:cubicBezTo>
                              <a:cubicBezTo>
                                <a:pt x="30835" y="475687"/>
                                <a:pt x="21746" y="468497"/>
                                <a:pt x="28194" y="466703"/>
                              </a:cubicBezTo>
                              <a:close/>
                            </a:path>
                          </a:pathLst>
                        </a:custGeom>
                        <ask:type>
                          <ask:lineSketchNone/>
                        </ask:type>
                      </ask:lineSketchStyleProps>
                    </a:ext>
                  </a:extLst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/>
                </a:p>
              </p:txBody>
            </p:sp>
          </p:grpSp>
          <p:sp>
            <p:nvSpPr>
              <p:cNvPr id="22" name="Freihandform 21">
                <a:extLst>
                  <a:ext uri="{FF2B5EF4-FFF2-40B4-BE49-F238E27FC236}">
                    <a16:creationId xmlns:a16="http://schemas.microsoft.com/office/drawing/2014/main" id="{838B53B6-226E-1F71-7C65-97E8061CBB60}"/>
                  </a:ext>
                </a:extLst>
              </p:cNvPr>
              <p:cNvSpPr/>
              <p:nvPr/>
            </p:nvSpPr>
            <p:spPr>
              <a:xfrm>
                <a:off x="2476907" y="2227943"/>
                <a:ext cx="1848439" cy="1114586"/>
              </a:xfrm>
              <a:custGeom>
                <a:avLst/>
                <a:gdLst>
                  <a:gd name="connsiteX0" fmla="*/ 0 w 1378580"/>
                  <a:gd name="connsiteY0" fmla="*/ 387399 h 844599"/>
                  <a:gd name="connsiteX1" fmla="*/ 0 w 1378580"/>
                  <a:gd name="connsiteY1" fmla="*/ 844599 h 844599"/>
                  <a:gd name="connsiteX2" fmla="*/ 1378580 w 1378580"/>
                  <a:gd name="connsiteY2" fmla="*/ 844599 h 844599"/>
                  <a:gd name="connsiteX3" fmla="*/ 1364620 w 1378580"/>
                  <a:gd name="connsiteY3" fmla="*/ 0 h 844599"/>
                  <a:gd name="connsiteX4" fmla="*/ 1315759 w 1378580"/>
                  <a:gd name="connsiteY4" fmla="*/ 41881 h 844599"/>
                  <a:gd name="connsiteX5" fmla="*/ 1256427 w 1378580"/>
                  <a:gd name="connsiteY5" fmla="*/ 76782 h 844599"/>
                  <a:gd name="connsiteX6" fmla="*/ 1183136 w 1378580"/>
                  <a:gd name="connsiteY6" fmla="*/ 153564 h 844599"/>
                  <a:gd name="connsiteX7" fmla="*/ 1148235 w 1378580"/>
                  <a:gd name="connsiteY7" fmla="*/ 219875 h 844599"/>
                  <a:gd name="connsiteX8" fmla="*/ 1078433 w 1378580"/>
                  <a:gd name="connsiteY8" fmla="*/ 272226 h 844599"/>
                  <a:gd name="connsiteX9" fmla="*/ 949301 w 1378580"/>
                  <a:gd name="connsiteY9" fmla="*/ 275716 h 844599"/>
                  <a:gd name="connsiteX10" fmla="*/ 841108 w 1378580"/>
                  <a:gd name="connsiteY10" fmla="*/ 272226 h 844599"/>
                  <a:gd name="connsiteX11" fmla="*/ 753856 w 1378580"/>
                  <a:gd name="connsiteY11" fmla="*/ 233835 h 844599"/>
                  <a:gd name="connsiteX12" fmla="*/ 704995 w 1378580"/>
                  <a:gd name="connsiteY12" fmla="*/ 233835 h 844599"/>
                  <a:gd name="connsiteX13" fmla="*/ 631704 w 1378580"/>
                  <a:gd name="connsiteY13" fmla="*/ 261756 h 844599"/>
                  <a:gd name="connsiteX14" fmla="*/ 520021 w 1378580"/>
                  <a:gd name="connsiteY14" fmla="*/ 261756 h 844599"/>
                  <a:gd name="connsiteX15" fmla="*/ 450220 w 1378580"/>
                  <a:gd name="connsiteY15" fmla="*/ 268736 h 844599"/>
                  <a:gd name="connsiteX16" fmla="*/ 369948 w 1378580"/>
                  <a:gd name="connsiteY16" fmla="*/ 275716 h 844599"/>
                  <a:gd name="connsiteX17" fmla="*/ 303637 w 1378580"/>
                  <a:gd name="connsiteY17" fmla="*/ 303637 h 844599"/>
                  <a:gd name="connsiteX18" fmla="*/ 209404 w 1378580"/>
                  <a:gd name="connsiteY18" fmla="*/ 335047 h 844599"/>
                  <a:gd name="connsiteX19" fmla="*/ 122153 w 1378580"/>
                  <a:gd name="connsiteY19" fmla="*/ 355988 h 844599"/>
                  <a:gd name="connsiteX20" fmla="*/ 52351 w 1378580"/>
                  <a:gd name="connsiteY20" fmla="*/ 376928 h 844599"/>
                  <a:gd name="connsiteX21" fmla="*/ 0 w 1378580"/>
                  <a:gd name="connsiteY21" fmla="*/ 387399 h 8445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</a:cxnLst>
                <a:rect l="l" t="t" r="r" b="b"/>
                <a:pathLst>
                  <a:path w="1378580" h="844599">
                    <a:moveTo>
                      <a:pt x="0" y="387399"/>
                    </a:moveTo>
                    <a:lnTo>
                      <a:pt x="0" y="844599"/>
                    </a:lnTo>
                    <a:lnTo>
                      <a:pt x="1378580" y="844599"/>
                    </a:lnTo>
                    <a:lnTo>
                      <a:pt x="1364620" y="0"/>
                    </a:lnTo>
                    <a:lnTo>
                      <a:pt x="1315759" y="41881"/>
                    </a:lnTo>
                    <a:lnTo>
                      <a:pt x="1256427" y="76782"/>
                    </a:lnTo>
                    <a:lnTo>
                      <a:pt x="1183136" y="153564"/>
                    </a:lnTo>
                    <a:lnTo>
                      <a:pt x="1148235" y="219875"/>
                    </a:lnTo>
                    <a:lnTo>
                      <a:pt x="1078433" y="272226"/>
                    </a:lnTo>
                    <a:lnTo>
                      <a:pt x="949301" y="275716"/>
                    </a:lnTo>
                    <a:lnTo>
                      <a:pt x="841108" y="272226"/>
                    </a:lnTo>
                    <a:lnTo>
                      <a:pt x="753856" y="233835"/>
                    </a:lnTo>
                    <a:lnTo>
                      <a:pt x="704995" y="233835"/>
                    </a:lnTo>
                    <a:lnTo>
                      <a:pt x="631704" y="261756"/>
                    </a:lnTo>
                    <a:lnTo>
                      <a:pt x="520021" y="261756"/>
                    </a:lnTo>
                    <a:lnTo>
                      <a:pt x="450220" y="268736"/>
                    </a:lnTo>
                    <a:lnTo>
                      <a:pt x="369948" y="275716"/>
                    </a:lnTo>
                    <a:lnTo>
                      <a:pt x="303637" y="303637"/>
                    </a:lnTo>
                    <a:lnTo>
                      <a:pt x="209404" y="335047"/>
                    </a:lnTo>
                    <a:lnTo>
                      <a:pt x="122153" y="355988"/>
                    </a:lnTo>
                    <a:lnTo>
                      <a:pt x="52351" y="376928"/>
                    </a:lnTo>
                    <a:lnTo>
                      <a:pt x="0" y="387399"/>
                    </a:ln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  <a:prstDash val="dash"/>
                <a:extLst>
                  <a:ext uri="{C807C97D-BFC1-408E-A445-0C87EB9F89A2}">
                    <ask:lineSketchStyleProps xmlns:ask="http://schemas.microsoft.com/office/drawing/2018/sketchyshapes" xmlns="" sd="1219033472">
                      <a:custGeom>
                        <a:avLst/>
                        <a:gdLst>
                          <a:gd name="connsiteX0" fmla="*/ 0 w 1378659"/>
                          <a:gd name="connsiteY0" fmla="*/ 363313 h 792089"/>
                          <a:gd name="connsiteX1" fmla="*/ 0 w 1378659"/>
                          <a:gd name="connsiteY1" fmla="*/ 792089 h 792089"/>
                          <a:gd name="connsiteX2" fmla="*/ 1378659 w 1378659"/>
                          <a:gd name="connsiteY2" fmla="*/ 792089 h 792089"/>
                          <a:gd name="connsiteX3" fmla="*/ 1364698 w 1378659"/>
                          <a:gd name="connsiteY3" fmla="*/ 0 h 792089"/>
                          <a:gd name="connsiteX4" fmla="*/ 1315834 w 1378659"/>
                          <a:gd name="connsiteY4" fmla="*/ 39277 h 792089"/>
                          <a:gd name="connsiteX5" fmla="*/ 1256498 w 1378659"/>
                          <a:gd name="connsiteY5" fmla="*/ 72008 h 792089"/>
                          <a:gd name="connsiteX6" fmla="*/ 1183203 w 1378659"/>
                          <a:gd name="connsiteY6" fmla="*/ 144016 h 792089"/>
                          <a:gd name="connsiteX7" fmla="*/ 1148300 w 1378659"/>
                          <a:gd name="connsiteY7" fmla="*/ 206205 h 792089"/>
                          <a:gd name="connsiteX8" fmla="*/ 1078494 w 1378659"/>
                          <a:gd name="connsiteY8" fmla="*/ 255301 h 792089"/>
                          <a:gd name="connsiteX9" fmla="*/ 949355 w 1378659"/>
                          <a:gd name="connsiteY9" fmla="*/ 258574 h 792089"/>
                          <a:gd name="connsiteX10" fmla="*/ 841156 w 1378659"/>
                          <a:gd name="connsiteY10" fmla="*/ 255301 h 792089"/>
                          <a:gd name="connsiteX11" fmla="*/ 753899 w 1378659"/>
                          <a:gd name="connsiteY11" fmla="*/ 219297 h 792089"/>
                          <a:gd name="connsiteX12" fmla="*/ 705035 w 1378659"/>
                          <a:gd name="connsiteY12" fmla="*/ 219297 h 792089"/>
                          <a:gd name="connsiteX13" fmla="*/ 631740 w 1378659"/>
                          <a:gd name="connsiteY13" fmla="*/ 245482 h 792089"/>
                          <a:gd name="connsiteX14" fmla="*/ 520050 w 1378659"/>
                          <a:gd name="connsiteY14" fmla="*/ 245482 h 792089"/>
                          <a:gd name="connsiteX15" fmla="*/ 450245 w 1378659"/>
                          <a:gd name="connsiteY15" fmla="*/ 252028 h 792089"/>
                          <a:gd name="connsiteX16" fmla="*/ 369969 w 1378659"/>
                          <a:gd name="connsiteY16" fmla="*/ 258574 h 792089"/>
                          <a:gd name="connsiteX17" fmla="*/ 303654 w 1378659"/>
                          <a:gd name="connsiteY17" fmla="*/ 284759 h 792089"/>
                          <a:gd name="connsiteX18" fmla="*/ 209415 w 1378659"/>
                          <a:gd name="connsiteY18" fmla="*/ 314216 h 792089"/>
                          <a:gd name="connsiteX19" fmla="*/ 122160 w 1378659"/>
                          <a:gd name="connsiteY19" fmla="*/ 333855 h 792089"/>
                          <a:gd name="connsiteX20" fmla="*/ 52353 w 1378659"/>
                          <a:gd name="connsiteY20" fmla="*/ 353493 h 792089"/>
                          <a:gd name="connsiteX21" fmla="*/ 0 w 1378659"/>
                          <a:gd name="connsiteY21" fmla="*/ 363313 h 792089"/>
                        </a:gdLst>
                        <a:ahLst/>
                        <a:cxnLst>
                          <a:cxn ang="0">
                            <a:pos x="connsiteX0" y="connsiteY0"/>
                          </a:cxn>
                          <a:cxn ang="0">
                            <a:pos x="connsiteX1" y="connsiteY1"/>
                          </a:cxn>
                          <a:cxn ang="0">
                            <a:pos x="connsiteX2" y="connsiteY2"/>
                          </a:cxn>
                          <a:cxn ang="0">
                            <a:pos x="connsiteX3" y="connsiteY3"/>
                          </a:cxn>
                          <a:cxn ang="0">
                            <a:pos x="connsiteX4" y="connsiteY4"/>
                          </a:cxn>
                          <a:cxn ang="0">
                            <a:pos x="connsiteX5" y="connsiteY5"/>
                          </a:cxn>
                          <a:cxn ang="0">
                            <a:pos x="connsiteX6" y="connsiteY6"/>
                          </a:cxn>
                          <a:cxn ang="0">
                            <a:pos x="connsiteX7" y="connsiteY7"/>
                          </a:cxn>
                          <a:cxn ang="0">
                            <a:pos x="connsiteX8" y="connsiteY8"/>
                          </a:cxn>
                          <a:cxn ang="0">
                            <a:pos x="connsiteX9" y="connsiteY9"/>
                          </a:cxn>
                          <a:cxn ang="0">
                            <a:pos x="connsiteX10" y="connsiteY10"/>
                          </a:cxn>
                          <a:cxn ang="0">
                            <a:pos x="connsiteX11" y="connsiteY11"/>
                          </a:cxn>
                          <a:cxn ang="0">
                            <a:pos x="connsiteX12" y="connsiteY12"/>
                          </a:cxn>
                          <a:cxn ang="0">
                            <a:pos x="connsiteX13" y="connsiteY13"/>
                          </a:cxn>
                          <a:cxn ang="0">
                            <a:pos x="connsiteX14" y="connsiteY14"/>
                          </a:cxn>
                          <a:cxn ang="0">
                            <a:pos x="connsiteX15" y="connsiteY15"/>
                          </a:cxn>
                          <a:cxn ang="0">
                            <a:pos x="connsiteX16" y="connsiteY16"/>
                          </a:cxn>
                          <a:cxn ang="0">
                            <a:pos x="connsiteX17" y="connsiteY17"/>
                          </a:cxn>
                          <a:cxn ang="0">
                            <a:pos x="connsiteX18" y="connsiteY18"/>
                          </a:cxn>
                          <a:cxn ang="0">
                            <a:pos x="connsiteX19" y="connsiteY19"/>
                          </a:cxn>
                          <a:cxn ang="0">
                            <a:pos x="connsiteX20" y="connsiteY20"/>
                          </a:cxn>
                          <a:cxn ang="0">
                            <a:pos x="connsiteX21" y="connsiteY21"/>
                          </a:cxn>
                        </a:cxnLst>
                        <a:rect l="l" t="t" r="r" b="b"/>
                        <a:pathLst>
                          <a:path w="1378659" h="792089" extrusionOk="0">
                            <a:moveTo>
                              <a:pt x="0" y="363313"/>
                            </a:moveTo>
                            <a:cubicBezTo>
                              <a:pt x="-23348" y="504724"/>
                              <a:pt x="-3892" y="675597"/>
                              <a:pt x="0" y="792089"/>
                            </a:cubicBezTo>
                            <a:cubicBezTo>
                              <a:pt x="680032" y="840451"/>
                              <a:pt x="852334" y="795618"/>
                              <a:pt x="1378659" y="792089"/>
                            </a:cubicBezTo>
                            <a:cubicBezTo>
                              <a:pt x="1369980" y="560562"/>
                              <a:pt x="1327470" y="234062"/>
                              <a:pt x="1364698" y="0"/>
                            </a:cubicBezTo>
                            <a:cubicBezTo>
                              <a:pt x="1350938" y="14172"/>
                              <a:pt x="1329349" y="34661"/>
                              <a:pt x="1315834" y="39277"/>
                            </a:cubicBezTo>
                            <a:cubicBezTo>
                              <a:pt x="1291289" y="59379"/>
                              <a:pt x="1266914" y="70370"/>
                              <a:pt x="1256498" y="72008"/>
                            </a:cubicBezTo>
                            <a:cubicBezTo>
                              <a:pt x="1240299" y="94466"/>
                              <a:pt x="1200515" y="135507"/>
                              <a:pt x="1183203" y="144016"/>
                            </a:cubicBezTo>
                            <a:cubicBezTo>
                              <a:pt x="1170581" y="177657"/>
                              <a:pt x="1155202" y="192630"/>
                              <a:pt x="1148300" y="206205"/>
                            </a:cubicBezTo>
                            <a:cubicBezTo>
                              <a:pt x="1127675" y="217352"/>
                              <a:pt x="1091875" y="244548"/>
                              <a:pt x="1078494" y="255301"/>
                            </a:cubicBezTo>
                            <a:cubicBezTo>
                              <a:pt x="1038705" y="253320"/>
                              <a:pt x="967917" y="263085"/>
                              <a:pt x="949355" y="258574"/>
                            </a:cubicBezTo>
                            <a:cubicBezTo>
                              <a:pt x="921570" y="260238"/>
                              <a:pt x="881739" y="263748"/>
                              <a:pt x="841156" y="255301"/>
                            </a:cubicBezTo>
                            <a:cubicBezTo>
                              <a:pt x="818270" y="248325"/>
                              <a:pt x="776970" y="235377"/>
                              <a:pt x="753899" y="219297"/>
                            </a:cubicBezTo>
                            <a:cubicBezTo>
                              <a:pt x="738560" y="221913"/>
                              <a:pt x="726522" y="222661"/>
                              <a:pt x="705035" y="219297"/>
                            </a:cubicBezTo>
                            <a:cubicBezTo>
                              <a:pt x="681992" y="227386"/>
                              <a:pt x="665156" y="234068"/>
                              <a:pt x="631740" y="245482"/>
                            </a:cubicBezTo>
                            <a:cubicBezTo>
                              <a:pt x="594667" y="248752"/>
                              <a:pt x="569816" y="252903"/>
                              <a:pt x="520050" y="245482"/>
                            </a:cubicBezTo>
                            <a:cubicBezTo>
                              <a:pt x="506234" y="249328"/>
                              <a:pt x="482007" y="247751"/>
                              <a:pt x="450245" y="252028"/>
                            </a:cubicBezTo>
                            <a:cubicBezTo>
                              <a:pt x="417651" y="252295"/>
                              <a:pt x="379533" y="262622"/>
                              <a:pt x="369969" y="258574"/>
                            </a:cubicBezTo>
                            <a:cubicBezTo>
                              <a:pt x="344236" y="270360"/>
                              <a:pt x="319515" y="280181"/>
                              <a:pt x="303654" y="284759"/>
                            </a:cubicBezTo>
                            <a:cubicBezTo>
                              <a:pt x="265863" y="291307"/>
                              <a:pt x="230605" y="315207"/>
                              <a:pt x="209415" y="314216"/>
                            </a:cubicBezTo>
                            <a:cubicBezTo>
                              <a:pt x="196595" y="322481"/>
                              <a:pt x="133278" y="326435"/>
                              <a:pt x="122160" y="333855"/>
                            </a:cubicBezTo>
                            <a:cubicBezTo>
                              <a:pt x="100599" y="343179"/>
                              <a:pt x="70463" y="354210"/>
                              <a:pt x="52353" y="353493"/>
                            </a:cubicBezTo>
                            <a:cubicBezTo>
                              <a:pt x="39313" y="357745"/>
                              <a:pt x="5027" y="359809"/>
                              <a:pt x="0" y="363313"/>
                            </a:cubicBezTo>
                            <a:close/>
                          </a:path>
                        </a:pathLst>
                      </a:custGeom>
                      <ask:type>
                        <ask:lineSketchNone/>
                      </ask:type>
                    </ask:lineSketchStyleProps>
                  </a:ext>
                </a:extLst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</p:grpSp>
        <p:sp>
          <p:nvSpPr>
            <p:cNvPr id="34" name="Geschweifte Klammer rechts 33">
              <a:extLst>
                <a:ext uri="{FF2B5EF4-FFF2-40B4-BE49-F238E27FC236}">
                  <a16:creationId xmlns:a16="http://schemas.microsoft.com/office/drawing/2014/main" id="{1936E730-71FD-8260-2C02-A2885A797C9E}"/>
                </a:ext>
              </a:extLst>
            </p:cNvPr>
            <p:cNvSpPr/>
            <p:nvPr/>
          </p:nvSpPr>
          <p:spPr>
            <a:xfrm>
              <a:off x="4142232" y="4414188"/>
              <a:ext cx="256032" cy="1670626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5" name="Geschweifte Klammer rechts 34">
              <a:extLst>
                <a:ext uri="{FF2B5EF4-FFF2-40B4-BE49-F238E27FC236}">
                  <a16:creationId xmlns:a16="http://schemas.microsoft.com/office/drawing/2014/main" id="{5CDEC905-C329-A319-6A37-A2F49A7CE255}"/>
                </a:ext>
              </a:extLst>
            </p:cNvPr>
            <p:cNvSpPr/>
            <p:nvPr/>
          </p:nvSpPr>
          <p:spPr>
            <a:xfrm>
              <a:off x="4142232" y="4165652"/>
              <a:ext cx="130628" cy="19279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" name="Geschweifte Klammer rechts 35">
              <a:extLst>
                <a:ext uri="{FF2B5EF4-FFF2-40B4-BE49-F238E27FC236}">
                  <a16:creationId xmlns:a16="http://schemas.microsoft.com/office/drawing/2014/main" id="{F52FF54A-9A43-438C-F447-BE5D028BD084}"/>
                </a:ext>
              </a:extLst>
            </p:cNvPr>
            <p:cNvSpPr/>
            <p:nvPr/>
          </p:nvSpPr>
          <p:spPr>
            <a:xfrm>
              <a:off x="4139620" y="1598271"/>
              <a:ext cx="130628" cy="192790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Geschweifte Klammer rechts 36">
              <a:extLst>
                <a:ext uri="{FF2B5EF4-FFF2-40B4-BE49-F238E27FC236}">
                  <a16:creationId xmlns:a16="http://schemas.microsoft.com/office/drawing/2014/main" id="{3E14709F-A4AB-4401-0524-6F70F19A0913}"/>
                </a:ext>
              </a:extLst>
            </p:cNvPr>
            <p:cNvSpPr/>
            <p:nvPr/>
          </p:nvSpPr>
          <p:spPr>
            <a:xfrm>
              <a:off x="4139620" y="1870492"/>
              <a:ext cx="256032" cy="1670626"/>
            </a:xfrm>
            <a:prstGeom prst="rightBrac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4E789742-B955-A28A-7F46-C220EC0947D6}"/>
                </a:ext>
              </a:extLst>
            </p:cNvPr>
            <p:cNvSpPr txBox="1"/>
            <p:nvPr/>
          </p:nvSpPr>
          <p:spPr>
            <a:xfrm>
              <a:off x="4272860" y="1553777"/>
              <a:ext cx="15591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Wound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area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E186BCDF-4CD8-78D2-37D4-29E27EF20C3E}"/>
                </a:ext>
              </a:extLst>
            </p:cNvPr>
            <p:cNvSpPr txBox="1"/>
            <p:nvPr/>
          </p:nvSpPr>
          <p:spPr>
            <a:xfrm>
              <a:off x="4378282" y="2566646"/>
              <a:ext cx="14270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Following</a:t>
              </a:r>
              <a:r>
                <a:rPr lang="de-DE" sz="12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3" name="Textfeld 42">
            <a:extLst>
              <a:ext uri="{FF2B5EF4-FFF2-40B4-BE49-F238E27FC236}">
                <a16:creationId xmlns:a16="http://schemas.microsoft.com/office/drawing/2014/main" id="{0FEE29AB-F208-C8B6-39A4-4F7926ADE888}"/>
              </a:ext>
            </a:extLst>
          </p:cNvPr>
          <p:cNvSpPr txBox="1"/>
          <p:nvPr/>
        </p:nvSpPr>
        <p:spPr>
          <a:xfrm>
            <a:off x="3785935" y="5233130"/>
            <a:ext cx="14270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llowing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F128B8C5-13FA-7757-D1B3-96CDCAF323A7}"/>
              </a:ext>
            </a:extLst>
          </p:cNvPr>
          <p:cNvSpPr txBox="1"/>
          <p:nvPr/>
        </p:nvSpPr>
        <p:spPr>
          <a:xfrm>
            <a:off x="3659057" y="4260161"/>
            <a:ext cx="22474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ou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rea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7BDBA532-DA05-C990-CF16-C67662D25A81}"/>
              </a:ext>
            </a:extLst>
          </p:cNvPr>
          <p:cNvSpPr txBox="1"/>
          <p:nvPr/>
        </p:nvSpPr>
        <p:spPr>
          <a:xfrm>
            <a:off x="6457289" y="896384"/>
            <a:ext cx="54107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BF0D8679-DE1B-CCD9-F819-925F5DE56296}"/>
              </a:ext>
            </a:extLst>
          </p:cNvPr>
          <p:cNvSpPr txBox="1"/>
          <p:nvPr/>
        </p:nvSpPr>
        <p:spPr>
          <a:xfrm>
            <a:off x="470982" y="1027580"/>
            <a:ext cx="54107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Grafik 7" descr="Ein Bild, das Text, Diagramm, parallel, Reihe enthält.&#10;&#10;Automatisch generierte Beschreibung">
            <a:extLst>
              <a:ext uri="{FF2B5EF4-FFF2-40B4-BE49-F238E27FC236}">
                <a16:creationId xmlns:a16="http://schemas.microsoft.com/office/drawing/2014/main" id="{C2B3BACA-3961-BEF2-3DC6-AE2AFFA2B9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29409" y="981016"/>
            <a:ext cx="4825103" cy="5431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586980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420BBD-E8D7-F53E-0F39-DB08FBA9B3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60684" y="208715"/>
            <a:ext cx="10515600" cy="645528"/>
          </a:xfrm>
        </p:spPr>
        <p:txBody>
          <a:bodyPr>
            <a:normAutofit/>
          </a:bodyPr>
          <a:lstStyle/>
          <a:p>
            <a:r>
              <a:rPr lang="de-DE" sz="2400" smtClean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de-DE" sz="2400" dirty="0">
                <a:latin typeface="Arial" panose="020B0604020202020204" pitchFamily="34" charset="0"/>
                <a:cs typeface="Arial" panose="020B0604020202020204" pitchFamily="34" charset="0"/>
              </a:rPr>
              <a:t>Figure 2:</a:t>
            </a:r>
          </a:p>
        </p:txBody>
      </p:sp>
      <p:grpSp>
        <p:nvGrpSpPr>
          <p:cNvPr id="18" name="Gruppieren 17">
            <a:extLst>
              <a:ext uri="{FF2B5EF4-FFF2-40B4-BE49-F238E27FC236}">
                <a16:creationId xmlns:a16="http://schemas.microsoft.com/office/drawing/2014/main" id="{7A41F14E-7D58-22CC-BE0B-AF57D2F58026}"/>
              </a:ext>
            </a:extLst>
          </p:cNvPr>
          <p:cNvGrpSpPr/>
          <p:nvPr/>
        </p:nvGrpSpPr>
        <p:grpSpPr>
          <a:xfrm>
            <a:off x="776464" y="2374900"/>
            <a:ext cx="3352625" cy="2554288"/>
            <a:chOff x="134827" y="1509295"/>
            <a:chExt cx="3036997" cy="2616940"/>
          </a:xfrm>
        </p:grpSpPr>
        <p:pic>
          <p:nvPicPr>
            <p:cNvPr id="7" name="Grafik 6">
              <a:extLst>
                <a:ext uri="{FF2B5EF4-FFF2-40B4-BE49-F238E27FC236}">
                  <a16:creationId xmlns:a16="http://schemas.microsoft.com/office/drawing/2014/main" id="{B6CA67E1-DCE0-4AEF-4731-49CF9991D1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69597" y="1509295"/>
              <a:ext cx="1902227" cy="104660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2229D4EB-9D7F-4341-4EBA-23A944FEFE3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269597" y="2652097"/>
              <a:ext cx="1902227" cy="6934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1" name="Grafik 10">
              <a:extLst>
                <a:ext uri="{FF2B5EF4-FFF2-40B4-BE49-F238E27FC236}">
                  <a16:creationId xmlns:a16="http://schemas.microsoft.com/office/drawing/2014/main" id="{6CF50813-CAAF-4A1E-E48E-276317536E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lum contrast="-40000"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9398" b="23602"/>
            <a:stretch/>
          </p:blipFill>
          <p:spPr>
            <a:xfrm>
              <a:off x="1269597" y="3432811"/>
              <a:ext cx="1902227" cy="69342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E8391468-882B-009C-BF9D-0DB8CB09E01A}"/>
                </a:ext>
              </a:extLst>
            </p:cNvPr>
            <p:cNvSpPr txBox="1"/>
            <p:nvPr/>
          </p:nvSpPr>
          <p:spPr>
            <a:xfrm>
              <a:off x="134827" y="1894097"/>
              <a:ext cx="1231239" cy="346858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P(Y925)FAK</a:t>
              </a:r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19B5A384-9171-E9A0-B059-BA0B351F9371}"/>
                </a:ext>
              </a:extLst>
            </p:cNvPr>
            <p:cNvSpPr txBox="1"/>
            <p:nvPr/>
          </p:nvSpPr>
          <p:spPr>
            <a:xfrm>
              <a:off x="470693" y="2801564"/>
              <a:ext cx="100891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totFAK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8AD25F32-461D-D5B4-4362-F3D85B9C0351}"/>
                </a:ext>
              </a:extLst>
            </p:cNvPr>
            <p:cNvSpPr txBox="1"/>
            <p:nvPr/>
          </p:nvSpPr>
          <p:spPr>
            <a:xfrm>
              <a:off x="422296" y="3610246"/>
              <a:ext cx="1231240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600" kern="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β</a:t>
              </a:r>
              <a:r>
                <a:rPr lang="de-DE" sz="1600" dirty="0">
                  <a:effectLst/>
                </a:rPr>
                <a:t> </a:t>
              </a:r>
              <a:r>
                <a:rPr lang="de-DE" sz="1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de-DE" sz="16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de-DE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" name="Textfeld 18">
            <a:extLst>
              <a:ext uri="{FF2B5EF4-FFF2-40B4-BE49-F238E27FC236}">
                <a16:creationId xmlns:a16="http://schemas.microsoft.com/office/drawing/2014/main" id="{902CEF0D-F163-E294-F0E9-13ECD6D56021}"/>
              </a:ext>
            </a:extLst>
          </p:cNvPr>
          <p:cNvSpPr txBox="1"/>
          <p:nvPr/>
        </p:nvSpPr>
        <p:spPr>
          <a:xfrm>
            <a:off x="4091603" y="2750489"/>
            <a:ext cx="138588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>
            <a:extLst>
              <a:ext uri="{FF2B5EF4-FFF2-40B4-BE49-F238E27FC236}">
                <a16:creationId xmlns:a16="http://schemas.microsoft.com/office/drawing/2014/main" id="{1645729F-64DD-C48D-A216-F7DA00A2DA68}"/>
              </a:ext>
            </a:extLst>
          </p:cNvPr>
          <p:cNvSpPr txBox="1"/>
          <p:nvPr/>
        </p:nvSpPr>
        <p:spPr>
          <a:xfrm>
            <a:off x="4064895" y="3659474"/>
            <a:ext cx="138588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125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7BEC6645-A322-44AA-7FC8-DC1DACC92E63}"/>
              </a:ext>
            </a:extLst>
          </p:cNvPr>
          <p:cNvSpPr txBox="1"/>
          <p:nvPr/>
        </p:nvSpPr>
        <p:spPr>
          <a:xfrm>
            <a:off x="4129089" y="4425552"/>
            <a:ext cx="1385886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2 </a:t>
            </a:r>
            <a:r>
              <a:rPr lang="de-DE" sz="14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de-DE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6134F3EA-FEEE-9D82-B144-7D9764107925}"/>
              </a:ext>
            </a:extLst>
          </p:cNvPr>
          <p:cNvSpPr txBox="1"/>
          <p:nvPr/>
        </p:nvSpPr>
        <p:spPr>
          <a:xfrm>
            <a:off x="878647" y="1554686"/>
            <a:ext cx="54107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0C3824E0-66A9-4745-7D02-72AC7601927C}"/>
              </a:ext>
            </a:extLst>
          </p:cNvPr>
          <p:cNvSpPr txBox="1"/>
          <p:nvPr/>
        </p:nvSpPr>
        <p:spPr>
          <a:xfrm>
            <a:off x="6613700" y="1554686"/>
            <a:ext cx="541079" cy="4001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277C6B39-E361-0B98-EE68-A95D3A845315}"/>
              </a:ext>
            </a:extLst>
          </p:cNvPr>
          <p:cNvSpPr txBox="1"/>
          <p:nvPr/>
        </p:nvSpPr>
        <p:spPr>
          <a:xfrm>
            <a:off x="2139058" y="1959251"/>
            <a:ext cx="111376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6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de-DE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40BFC6EB-8D4E-C771-9BE9-B0E17BA76019}"/>
              </a:ext>
            </a:extLst>
          </p:cNvPr>
          <p:cNvSpPr txBox="1"/>
          <p:nvPr/>
        </p:nvSpPr>
        <p:spPr>
          <a:xfrm>
            <a:off x="3252825" y="1968599"/>
            <a:ext cx="1113767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1600" dirty="0">
                <a:latin typeface="Arial" panose="020B0604020202020204" pitchFamily="34" charset="0"/>
                <a:cs typeface="Arial" panose="020B0604020202020204" pitchFamily="34" charset="0"/>
              </a:rPr>
              <a:t>GDNF</a:t>
            </a:r>
          </a:p>
        </p:txBody>
      </p:sp>
      <p:pic>
        <p:nvPicPr>
          <p:cNvPr id="17" name="Grafik 16" descr="Ein Bild, das Diagramm, Reihe, technische Zeichnung, Plan enthält.&#10;&#10;Automatisch generierte Beschreibung">
            <a:extLst>
              <a:ext uri="{FF2B5EF4-FFF2-40B4-BE49-F238E27FC236}">
                <a16:creationId xmlns:a16="http://schemas.microsoft.com/office/drawing/2014/main" id="{5F0076AC-1ECF-FED4-E174-7D1A507B9F2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29637" y="1954796"/>
            <a:ext cx="4273298" cy="35365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2331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3</Words>
  <Application>Microsoft Office PowerPoint</Application>
  <PresentationFormat>Breitbild</PresentationFormat>
  <Paragraphs>18</Paragraphs>
  <Slides>2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Office</vt:lpstr>
      <vt:lpstr>Supplemental Figure 1:</vt:lpstr>
      <vt:lpstr>Supplemental Figure 2: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:</dc:title>
  <dc:creator>Marius Hoerner</dc:creator>
  <cp:lastModifiedBy>Burkard, Natalie</cp:lastModifiedBy>
  <cp:revision>7</cp:revision>
  <dcterms:created xsi:type="dcterms:W3CDTF">2024-08-07T07:31:28Z</dcterms:created>
  <dcterms:modified xsi:type="dcterms:W3CDTF">2024-08-13T05:17:30Z</dcterms:modified>
</cp:coreProperties>
</file>